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9" r:id="rId3"/>
    <p:sldId id="257" r:id="rId4"/>
    <p:sldId id="258" r:id="rId5"/>
    <p:sldId id="260" r:id="rId6"/>
  </p:sldIdLst>
  <p:sldSz cx="475488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5EB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7" autoAdjust="0"/>
    <p:restoredTop sz="94660"/>
  </p:normalViewPr>
  <p:slideViewPr>
    <p:cSldViewPr snapToGrid="0">
      <p:cViewPr varScale="1">
        <p:scale>
          <a:sx n="31" d="100"/>
          <a:sy n="31" d="100"/>
        </p:scale>
        <p:origin x="228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25T21:32:53.269"/>
    </inkml:context>
    <inkml:brush xml:id="br0">
      <inkml:brushProperty name="width" value="0.14111" units="cm"/>
      <inkml:brushProperty name="height" value="0.14111" units="cm"/>
      <inkml:brushProperty name="color" value="#70AD47"/>
    </inkml:brush>
  </inkml:definitions>
  <inkml:trace contextRef="#ctx0" brushRef="#br0">0 8777 24575,'242'-8'0,"322"-68"0,-524 66 0,0-3 0,0-2 0,-1-3 0,-1-2 0,0-2 0,-1-3 0,38-35 0,-36 25 0,-2-3 0,0-3 0,-2-1 0,-1-3 0,-2-2 0,31-57 0,180-398 0,-80 46 0,-107 286 0,35-110 0,112-311 0,174-354-1094,-201 457 1094,-92 247 0,31-100 4,94-243-259,3 128 205,-79 198-164,220-389-683,-60 207 897,27 45 0,120-17 0,-375 359 0,179-137 0,9 31 0,-151 112-80,2 7 0,1 6-1,0 7 1,135-9 0,435 25-1256,-577 14 1388,1287 9-167,-1278-13 145,126-26-1,-218 23 49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8-28T19:14:42.525"/>
    </inkml:context>
    <inkml:brush xml:id="br0">
      <inkml:brushProperty name="width" value="0.14111" units="cm"/>
      <inkml:brushProperty name="height" value="0.14111" units="cm"/>
      <inkml:brushProperty name="color" value="#70AD47"/>
    </inkml:brush>
  </inkml:definitions>
  <inkml:trace contextRef="#ctx0" brushRef="#br0">0 8777 24575,'242'-8'0,"322"-68"0,-524 66 0,0-3 0,0-2 0,-1-3 0,-1-2 0,0-2 0,-1-3 0,38-35 0,-36 25 0,-2-3 0,0-3 0,-2-1 0,-1-3 0,-2-2 0,31-57 0,180-398 0,-80 46 0,-107 286 0,35-110 0,112-311 0,174-354-1094,-201 457 1094,-92 247 0,31-100 4,94-243-259,3 128 205,-79 198-164,220-389-683,-60 207 897,27 45 0,120-17 0,-375 359 0,179-137 0,9 31 0,-151 112-80,2 7 0,1 6-1,0 7 1,135-9 0,435 25-1256,-577 14 1388,1287 9-167,-1278-13 145,126-26-1,-218 23 49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8-28T19:14:56.084"/>
    </inkml:context>
    <inkml:brush xml:id="br0">
      <inkml:brushProperty name="width" value="0.3175" units="cm"/>
      <inkml:brushProperty name="height" value="0.3175" units="cm"/>
      <inkml:brushProperty name="color" value="#70AD47"/>
    </inkml:brush>
  </inkml:definitions>
  <inkml:trace contextRef="#ctx0" brushRef="#br0">0 20233 24575,'498'-18'0,"661"-162"0,-1077 157 0,0-8 0,1-4 0,-3-8 0,-2-4 0,0-5 0,-2-7 0,78-82 0,-73 59 0,-5-8 0,0-7 0,-4-2 0,-2-7 0,-5-5 0,65-134 0,369-938 0,-164 108 0,-219 674 0,71-259 0,230-734 0,358-833-1094,-413 1076 1094,-189 583 0,63-236 4,194-573-259,5 302 205,-161 467-164,452-918-683,-124 489 897,56 106 0,246-40 0,-770 846 0,368-323 0,18 73 0,-311 264-80,5 17 0,2 14-1,0 16 1,277-21 0,895 59-1256,-1187 33 1388,2647 22-167,-2628-32 145,259-61-1,-448 55 49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8-28T19:14:56.084"/>
    </inkml:context>
    <inkml:brush xml:id="br0">
      <inkml:brushProperty name="width" value="0.3175" units="cm"/>
      <inkml:brushProperty name="height" value="0.3175" units="cm"/>
      <inkml:brushProperty name="color" value="#70AD47"/>
    </inkml:brush>
  </inkml:definitions>
  <inkml:trace contextRef="#ctx0" brushRef="#br0">0 20233 24575,'498'-18'0,"661"-162"0,-1077 157 0,0-8 0,1-4 0,-3-8 0,-2-4 0,0-5 0,-2-7 0,78-82 0,-73 59 0,-5-8 0,0-7 0,-4-2 0,-2-7 0,-5-5 0,65-134 0,369-938 0,-164 108 0,-219 674 0,71-259 0,230-734 0,358-833-1094,-413 1076 1094,-189 583 0,63-236 4,194-573-259,5 302 205,-161 467-164,452-918-683,-124 489 897,56 106 0,246-40 0,-770 846 0,368-323 0,18 73 0,-311 264-80,5 17 0,2 14-1,0 16 1,277-21 0,895 59-1256,-1187 33 1388,2647 22-167,-2628-32 145,259-61-1,-448 55 49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3600" y="3591562"/>
            <a:ext cx="35661600" cy="7640320"/>
          </a:xfrm>
        </p:spPr>
        <p:txBody>
          <a:bodyPr anchor="b"/>
          <a:lstStyle>
            <a:lvl1pPr algn="ctr">
              <a:defRPr sz="19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943600" y="11526522"/>
            <a:ext cx="35661600" cy="5298438"/>
          </a:xfrm>
        </p:spPr>
        <p:txBody>
          <a:bodyPr/>
          <a:lstStyle>
            <a:lvl1pPr marL="0" indent="0" algn="ctr">
              <a:buNone/>
              <a:defRPr sz="7680"/>
            </a:lvl1pPr>
            <a:lvl2pPr marL="1463040" indent="0" algn="ctr">
              <a:buNone/>
              <a:defRPr sz="6400"/>
            </a:lvl2pPr>
            <a:lvl3pPr marL="2926080" indent="0" algn="ctr">
              <a:buNone/>
              <a:defRPr sz="5760"/>
            </a:lvl3pPr>
            <a:lvl4pPr marL="4389120" indent="0" algn="ctr">
              <a:buNone/>
              <a:defRPr sz="5120"/>
            </a:lvl4pPr>
            <a:lvl5pPr marL="5852160" indent="0" algn="ctr">
              <a:buNone/>
              <a:defRPr sz="5120"/>
            </a:lvl5pPr>
            <a:lvl6pPr marL="7315200" indent="0" algn="ctr">
              <a:buNone/>
              <a:defRPr sz="5120"/>
            </a:lvl6pPr>
            <a:lvl7pPr marL="8778240" indent="0" algn="ctr">
              <a:buNone/>
              <a:defRPr sz="5120"/>
            </a:lvl7pPr>
            <a:lvl8pPr marL="10241280" indent="0" algn="ctr">
              <a:buNone/>
              <a:defRPr sz="5120"/>
            </a:lvl8pPr>
            <a:lvl9pPr marL="11704320" indent="0" algn="ctr">
              <a:buNone/>
              <a:defRPr sz="5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15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10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27110" y="1168400"/>
            <a:ext cx="10252710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68980" y="1168400"/>
            <a:ext cx="30163770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520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70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4215" y="5471163"/>
            <a:ext cx="41010840" cy="9128758"/>
          </a:xfrm>
        </p:spPr>
        <p:txBody>
          <a:bodyPr anchor="b"/>
          <a:lstStyle>
            <a:lvl1pPr>
              <a:defRPr sz="19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4215" y="14686283"/>
            <a:ext cx="41010840" cy="4800598"/>
          </a:xfrm>
        </p:spPr>
        <p:txBody>
          <a:bodyPr/>
          <a:lstStyle>
            <a:lvl1pPr marL="0" indent="0">
              <a:buNone/>
              <a:defRPr sz="7680">
                <a:solidFill>
                  <a:schemeClr val="tx1">
                    <a:tint val="75000"/>
                  </a:schemeClr>
                </a:solidFill>
              </a:defRPr>
            </a:lvl1pPr>
            <a:lvl2pPr marL="146304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2pPr>
            <a:lvl3pPr marL="292608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3pPr>
            <a:lvl4pPr marL="438912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4pPr>
            <a:lvl5pPr marL="585216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5pPr>
            <a:lvl6pPr marL="731520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6pPr>
            <a:lvl7pPr marL="877824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7pPr>
            <a:lvl8pPr marL="1024128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8pPr>
            <a:lvl9pPr marL="11704320" indent="0">
              <a:buNone/>
              <a:defRPr sz="5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32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68980" y="5842000"/>
            <a:ext cx="2020824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71580" y="5842000"/>
            <a:ext cx="2020824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04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5173" y="1168401"/>
            <a:ext cx="41010840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75175" y="5379722"/>
            <a:ext cx="20115369" cy="2636518"/>
          </a:xfrm>
        </p:spPr>
        <p:txBody>
          <a:bodyPr anchor="b"/>
          <a:lstStyle>
            <a:lvl1pPr marL="0" indent="0">
              <a:buNone/>
              <a:defRPr sz="7680" b="1"/>
            </a:lvl1pPr>
            <a:lvl2pPr marL="1463040" indent="0">
              <a:buNone/>
              <a:defRPr sz="6400" b="1"/>
            </a:lvl2pPr>
            <a:lvl3pPr marL="2926080" indent="0">
              <a:buNone/>
              <a:defRPr sz="5760" b="1"/>
            </a:lvl3pPr>
            <a:lvl4pPr marL="4389120" indent="0">
              <a:buNone/>
              <a:defRPr sz="5120" b="1"/>
            </a:lvl4pPr>
            <a:lvl5pPr marL="5852160" indent="0">
              <a:buNone/>
              <a:defRPr sz="5120" b="1"/>
            </a:lvl5pPr>
            <a:lvl6pPr marL="7315200" indent="0">
              <a:buNone/>
              <a:defRPr sz="5120" b="1"/>
            </a:lvl6pPr>
            <a:lvl7pPr marL="8778240" indent="0">
              <a:buNone/>
              <a:defRPr sz="5120" b="1"/>
            </a:lvl7pPr>
            <a:lvl8pPr marL="10241280" indent="0">
              <a:buNone/>
              <a:defRPr sz="5120" b="1"/>
            </a:lvl8pPr>
            <a:lvl9pPr marL="11704320" indent="0">
              <a:buNone/>
              <a:defRPr sz="5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5175" y="8016240"/>
            <a:ext cx="2011536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4071580" y="5379722"/>
            <a:ext cx="20214433" cy="2636518"/>
          </a:xfrm>
        </p:spPr>
        <p:txBody>
          <a:bodyPr anchor="b"/>
          <a:lstStyle>
            <a:lvl1pPr marL="0" indent="0">
              <a:buNone/>
              <a:defRPr sz="7680" b="1"/>
            </a:lvl1pPr>
            <a:lvl2pPr marL="1463040" indent="0">
              <a:buNone/>
              <a:defRPr sz="6400" b="1"/>
            </a:lvl2pPr>
            <a:lvl3pPr marL="2926080" indent="0">
              <a:buNone/>
              <a:defRPr sz="5760" b="1"/>
            </a:lvl3pPr>
            <a:lvl4pPr marL="4389120" indent="0">
              <a:buNone/>
              <a:defRPr sz="5120" b="1"/>
            </a:lvl4pPr>
            <a:lvl5pPr marL="5852160" indent="0">
              <a:buNone/>
              <a:defRPr sz="5120" b="1"/>
            </a:lvl5pPr>
            <a:lvl6pPr marL="7315200" indent="0">
              <a:buNone/>
              <a:defRPr sz="5120" b="1"/>
            </a:lvl6pPr>
            <a:lvl7pPr marL="8778240" indent="0">
              <a:buNone/>
              <a:defRPr sz="5120" b="1"/>
            </a:lvl7pPr>
            <a:lvl8pPr marL="10241280" indent="0">
              <a:buNone/>
              <a:defRPr sz="5120" b="1"/>
            </a:lvl8pPr>
            <a:lvl9pPr marL="11704320" indent="0">
              <a:buNone/>
              <a:defRPr sz="5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071580" y="8016240"/>
            <a:ext cx="2021443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717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8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429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5175" y="1463040"/>
            <a:ext cx="15335724" cy="5120640"/>
          </a:xfrm>
        </p:spPr>
        <p:txBody>
          <a:bodyPr anchor="b"/>
          <a:lstStyle>
            <a:lvl1pPr>
              <a:defRPr sz="10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214433" y="3159762"/>
            <a:ext cx="24071580" cy="15595600"/>
          </a:xfrm>
        </p:spPr>
        <p:txBody>
          <a:bodyPr/>
          <a:lstStyle>
            <a:lvl1pPr>
              <a:defRPr sz="10240"/>
            </a:lvl1pPr>
            <a:lvl2pPr>
              <a:defRPr sz="8960"/>
            </a:lvl2pPr>
            <a:lvl3pPr>
              <a:defRPr sz="768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75175" y="6583680"/>
            <a:ext cx="15335724" cy="12197082"/>
          </a:xfrm>
        </p:spPr>
        <p:txBody>
          <a:bodyPr/>
          <a:lstStyle>
            <a:lvl1pPr marL="0" indent="0">
              <a:buNone/>
              <a:defRPr sz="5120"/>
            </a:lvl1pPr>
            <a:lvl2pPr marL="1463040" indent="0">
              <a:buNone/>
              <a:defRPr sz="4480"/>
            </a:lvl2pPr>
            <a:lvl3pPr marL="2926080" indent="0">
              <a:buNone/>
              <a:defRPr sz="3840"/>
            </a:lvl3pPr>
            <a:lvl4pPr marL="4389120" indent="0">
              <a:buNone/>
              <a:defRPr sz="3200"/>
            </a:lvl4pPr>
            <a:lvl5pPr marL="5852160" indent="0">
              <a:buNone/>
              <a:defRPr sz="3200"/>
            </a:lvl5pPr>
            <a:lvl6pPr marL="7315200" indent="0">
              <a:buNone/>
              <a:defRPr sz="3200"/>
            </a:lvl6pPr>
            <a:lvl7pPr marL="8778240" indent="0">
              <a:buNone/>
              <a:defRPr sz="3200"/>
            </a:lvl7pPr>
            <a:lvl8pPr marL="10241280" indent="0">
              <a:buNone/>
              <a:defRPr sz="3200"/>
            </a:lvl8pPr>
            <a:lvl9pPr marL="11704320" indent="0">
              <a:buNone/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259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5175" y="1463040"/>
            <a:ext cx="15335724" cy="5120640"/>
          </a:xfrm>
        </p:spPr>
        <p:txBody>
          <a:bodyPr anchor="b"/>
          <a:lstStyle>
            <a:lvl1pPr>
              <a:defRPr sz="10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0214433" y="3159762"/>
            <a:ext cx="24071580" cy="15595600"/>
          </a:xfrm>
        </p:spPr>
        <p:txBody>
          <a:bodyPr anchor="t"/>
          <a:lstStyle>
            <a:lvl1pPr marL="0" indent="0">
              <a:buNone/>
              <a:defRPr sz="10240"/>
            </a:lvl1pPr>
            <a:lvl2pPr marL="1463040" indent="0">
              <a:buNone/>
              <a:defRPr sz="8960"/>
            </a:lvl2pPr>
            <a:lvl3pPr marL="2926080" indent="0">
              <a:buNone/>
              <a:defRPr sz="7680"/>
            </a:lvl3pPr>
            <a:lvl4pPr marL="4389120" indent="0">
              <a:buNone/>
              <a:defRPr sz="6400"/>
            </a:lvl4pPr>
            <a:lvl5pPr marL="5852160" indent="0">
              <a:buNone/>
              <a:defRPr sz="6400"/>
            </a:lvl5pPr>
            <a:lvl6pPr marL="7315200" indent="0">
              <a:buNone/>
              <a:defRPr sz="6400"/>
            </a:lvl6pPr>
            <a:lvl7pPr marL="8778240" indent="0">
              <a:buNone/>
              <a:defRPr sz="6400"/>
            </a:lvl7pPr>
            <a:lvl8pPr marL="10241280" indent="0">
              <a:buNone/>
              <a:defRPr sz="6400"/>
            </a:lvl8pPr>
            <a:lvl9pPr marL="11704320" indent="0">
              <a:buNone/>
              <a:defRPr sz="6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75175" y="6583680"/>
            <a:ext cx="15335724" cy="12197082"/>
          </a:xfrm>
        </p:spPr>
        <p:txBody>
          <a:bodyPr/>
          <a:lstStyle>
            <a:lvl1pPr marL="0" indent="0">
              <a:buNone/>
              <a:defRPr sz="5120"/>
            </a:lvl1pPr>
            <a:lvl2pPr marL="1463040" indent="0">
              <a:buNone/>
              <a:defRPr sz="4480"/>
            </a:lvl2pPr>
            <a:lvl3pPr marL="2926080" indent="0">
              <a:buNone/>
              <a:defRPr sz="3840"/>
            </a:lvl3pPr>
            <a:lvl4pPr marL="4389120" indent="0">
              <a:buNone/>
              <a:defRPr sz="3200"/>
            </a:lvl4pPr>
            <a:lvl5pPr marL="5852160" indent="0">
              <a:buNone/>
              <a:defRPr sz="3200"/>
            </a:lvl5pPr>
            <a:lvl6pPr marL="7315200" indent="0">
              <a:buNone/>
              <a:defRPr sz="3200"/>
            </a:lvl6pPr>
            <a:lvl7pPr marL="8778240" indent="0">
              <a:buNone/>
              <a:defRPr sz="3200"/>
            </a:lvl7pPr>
            <a:lvl8pPr marL="10241280" indent="0">
              <a:buNone/>
              <a:defRPr sz="3200"/>
            </a:lvl8pPr>
            <a:lvl9pPr marL="11704320" indent="0">
              <a:buNone/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659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68980" y="1168401"/>
            <a:ext cx="41010840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68980" y="5842000"/>
            <a:ext cx="41010840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68980" y="20340322"/>
            <a:ext cx="1069848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2BFE0-8549-4C1F-84C9-7EF9AF1AAFCF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750540" y="20340322"/>
            <a:ext cx="1604772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581340" y="20340322"/>
            <a:ext cx="1069848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91067-4F41-4D39-A7C1-6D626FFAE5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82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926080" rtl="0" eaLnBrk="1" latinLnBrk="0" hangingPunct="1">
        <a:lnSpc>
          <a:spcPct val="90000"/>
        </a:lnSpc>
        <a:spcBef>
          <a:spcPct val="0"/>
        </a:spcBef>
        <a:buNone/>
        <a:defRPr sz="14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1520" indent="-731520" algn="l" defTabSz="2926080" rtl="0" eaLnBrk="1" latinLnBrk="0" hangingPunct="1">
        <a:lnSpc>
          <a:spcPct val="90000"/>
        </a:lnSpc>
        <a:spcBef>
          <a:spcPts val="3200"/>
        </a:spcBef>
        <a:buFont typeface="Arial" panose="020B0604020202020204" pitchFamily="34" charset="0"/>
        <a:buChar char="•"/>
        <a:defRPr sz="8960" kern="1200">
          <a:solidFill>
            <a:schemeClr val="tx1"/>
          </a:solidFill>
          <a:latin typeface="+mn-lt"/>
          <a:ea typeface="+mn-ea"/>
          <a:cs typeface="+mn-cs"/>
        </a:defRPr>
      </a:lvl1pPr>
      <a:lvl2pPr marL="219456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768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3pPr>
      <a:lvl4pPr marL="512064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4pPr>
      <a:lvl5pPr marL="658368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5pPr>
      <a:lvl6pPr marL="804672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6pPr>
      <a:lvl7pPr marL="950976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7pPr>
      <a:lvl8pPr marL="1097280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8pPr>
      <a:lvl9pPr marL="12435840" indent="-731520" algn="l" defTabSz="292608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5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1pPr>
      <a:lvl2pPr marL="146304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2pPr>
      <a:lvl3pPr marL="292608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3pPr>
      <a:lvl4pPr marL="438912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4pPr>
      <a:lvl5pPr marL="585216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5pPr>
      <a:lvl6pPr marL="731520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6pPr>
      <a:lvl7pPr marL="877824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7pPr>
      <a:lvl8pPr marL="1024128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8pPr>
      <a:lvl9pPr marL="11704320" algn="l" defTabSz="2926080" rtl="0" eaLnBrk="1" latinLnBrk="0" hangingPunct="1">
        <a:defRPr sz="5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customXml" Target="../ink/ink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customXml" Target="../ink/ink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customXml" Target="../ink/ink3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customXml" Target="../ink/ink4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>
            <a:extLst>
              <a:ext uri="{FF2B5EF4-FFF2-40B4-BE49-F238E27FC236}">
                <a16:creationId xmlns:a16="http://schemas.microsoft.com/office/drawing/2014/main" id="{9B22C7B2-5231-D2C1-92A7-8950CDB0E80F}"/>
              </a:ext>
            </a:extLst>
          </p:cNvPr>
          <p:cNvSpPr txBox="1"/>
          <p:nvPr/>
        </p:nvSpPr>
        <p:spPr>
          <a:xfrm>
            <a:off x="412618" y="8628655"/>
            <a:ext cx="2514600" cy="1298377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4F1D1B6-D2DB-3D5A-95EC-6F27A33490F4}"/>
              </a:ext>
            </a:extLst>
          </p:cNvPr>
          <p:cNvSpPr txBox="1"/>
          <p:nvPr/>
        </p:nvSpPr>
        <p:spPr>
          <a:xfrm>
            <a:off x="218374" y="8494993"/>
            <a:ext cx="290105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solidFill>
                  <a:schemeClr val="bg1"/>
                </a:solidFill>
              </a:rPr>
              <a:t>Mg</a:t>
            </a:r>
            <a:r>
              <a:rPr lang="en-US" sz="8800" baseline="30000" dirty="0">
                <a:solidFill>
                  <a:schemeClr val="bg1"/>
                </a:solidFill>
              </a:rPr>
              <a:t>2+</a:t>
            </a:r>
            <a:endParaRPr lang="en-US" sz="8800" dirty="0">
              <a:solidFill>
                <a:schemeClr val="bg1"/>
              </a:solidFill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6733EC9-2AD6-6F10-9F6C-764739DAF718}"/>
              </a:ext>
            </a:extLst>
          </p:cNvPr>
          <p:cNvGrpSpPr/>
          <p:nvPr/>
        </p:nvGrpSpPr>
        <p:grpSpPr>
          <a:xfrm>
            <a:off x="11896926" y="13125445"/>
            <a:ext cx="7599228" cy="8737517"/>
            <a:chOff x="-1120990" y="8729375"/>
            <a:chExt cx="9217654" cy="10748245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E4B38068-AAE5-84BB-0CE6-99241E309CF6}"/>
                </a:ext>
              </a:extLst>
            </p:cNvPr>
            <p:cNvGrpSpPr/>
            <p:nvPr/>
          </p:nvGrpSpPr>
          <p:grpSpPr>
            <a:xfrm>
              <a:off x="1757272" y="8729375"/>
              <a:ext cx="3036903" cy="7634415"/>
              <a:chOff x="9341364" y="2891367"/>
              <a:chExt cx="3036903" cy="7634415"/>
            </a:xfrm>
          </p:grpSpPr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F59D4E93-ED76-4D70-84EE-AEC044AA2924}"/>
                  </a:ext>
                </a:extLst>
              </p:cNvPr>
              <p:cNvSpPr/>
              <p:nvPr/>
            </p:nvSpPr>
            <p:spPr>
              <a:xfrm>
                <a:off x="10876112" y="9655176"/>
                <a:ext cx="373655" cy="764859"/>
              </a:xfrm>
              <a:prstGeom prst="ellipse">
                <a:avLst/>
              </a:prstGeom>
              <a:solidFill>
                <a:srgbClr val="F9EFD0"/>
              </a:solidFill>
              <a:ln w="57150">
                <a:solidFill>
                  <a:srgbClr val="F9EFD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CE4F41A-D124-DB47-4C51-33C610BEE6B1}"/>
                  </a:ext>
                </a:extLst>
              </p:cNvPr>
              <p:cNvGrpSpPr/>
              <p:nvPr/>
            </p:nvGrpSpPr>
            <p:grpSpPr>
              <a:xfrm>
                <a:off x="9341364" y="2891367"/>
                <a:ext cx="3036903" cy="7634415"/>
                <a:chOff x="10204964" y="2637367"/>
                <a:chExt cx="3036903" cy="7634415"/>
              </a:xfrm>
            </p:grpSpPr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350C650C-A008-81C1-28A4-2C5C84C4B978}"/>
                    </a:ext>
                  </a:extLst>
                </p:cNvPr>
                <p:cNvSpPr/>
                <p:nvPr/>
              </p:nvSpPr>
              <p:spPr>
                <a:xfrm>
                  <a:off x="11612886" y="9401176"/>
                  <a:ext cx="634677" cy="870606"/>
                </a:xfrm>
                <a:prstGeom prst="ellipse">
                  <a:avLst/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5BE919F5-2FBC-2A6A-E137-47450FDAC2A9}"/>
                    </a:ext>
                  </a:extLst>
                </p:cNvPr>
                <p:cNvSpPr/>
                <p:nvPr/>
              </p:nvSpPr>
              <p:spPr>
                <a:xfrm>
                  <a:off x="10898271" y="4668519"/>
                  <a:ext cx="2050649" cy="235163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7" name="Block Arc 36">
                  <a:extLst>
                    <a:ext uri="{FF2B5EF4-FFF2-40B4-BE49-F238E27FC236}">
                      <a16:creationId xmlns:a16="http://schemas.microsoft.com/office/drawing/2014/main" id="{C637C429-C6DC-E762-9F55-879984955B4E}"/>
                    </a:ext>
                  </a:extLst>
                </p:cNvPr>
                <p:cNvSpPr/>
                <p:nvPr/>
              </p:nvSpPr>
              <p:spPr>
                <a:xfrm rot="14698403">
                  <a:off x="10270097" y="2676360"/>
                  <a:ext cx="427356" cy="514795"/>
                </a:xfrm>
                <a:prstGeom prst="blockArc">
                  <a:avLst>
                    <a:gd name="adj1" fmla="val 13560443"/>
                    <a:gd name="adj2" fmla="val 2935971"/>
                    <a:gd name="adj3" fmla="val 24413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48E51EC0-852B-26C9-BCB7-443B0A94DA55}"/>
                    </a:ext>
                  </a:extLst>
                </p:cNvPr>
                <p:cNvSpPr/>
                <p:nvPr/>
              </p:nvSpPr>
              <p:spPr>
                <a:xfrm>
                  <a:off x="10445751" y="3054350"/>
                  <a:ext cx="464594" cy="10027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" name="Block Arc 38">
                  <a:extLst>
                    <a:ext uri="{FF2B5EF4-FFF2-40B4-BE49-F238E27FC236}">
                      <a16:creationId xmlns:a16="http://schemas.microsoft.com/office/drawing/2014/main" id="{15F547DC-15A5-96F0-1096-5801337FE7F1}"/>
                    </a:ext>
                  </a:extLst>
                </p:cNvPr>
                <p:cNvSpPr/>
                <p:nvPr/>
              </p:nvSpPr>
              <p:spPr>
                <a:xfrm rot="11312380">
                  <a:off x="10247864" y="2641239"/>
                  <a:ext cx="427356" cy="514795"/>
                </a:xfrm>
                <a:prstGeom prst="blockArc">
                  <a:avLst>
                    <a:gd name="adj1" fmla="val 15619198"/>
                    <a:gd name="adj2" fmla="val 16406583"/>
                    <a:gd name="adj3" fmla="val 22545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0" name="Block Arc 39">
                  <a:extLst>
                    <a:ext uri="{FF2B5EF4-FFF2-40B4-BE49-F238E27FC236}">
                      <a16:creationId xmlns:a16="http://schemas.microsoft.com/office/drawing/2014/main" id="{15E42C1F-440E-3AA9-5638-9C0AC7880000}"/>
                    </a:ext>
                  </a:extLst>
                </p:cNvPr>
                <p:cNvSpPr/>
                <p:nvPr/>
              </p:nvSpPr>
              <p:spPr>
                <a:xfrm rot="11312380">
                  <a:off x="10204964" y="2933117"/>
                  <a:ext cx="427356" cy="192024"/>
                </a:xfrm>
                <a:prstGeom prst="blockArc">
                  <a:avLst>
                    <a:gd name="adj1" fmla="val 15879138"/>
                    <a:gd name="adj2" fmla="val 17412361"/>
                    <a:gd name="adj3" fmla="val 26734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Block Arc 40">
                  <a:extLst>
                    <a:ext uri="{FF2B5EF4-FFF2-40B4-BE49-F238E27FC236}">
                      <a16:creationId xmlns:a16="http://schemas.microsoft.com/office/drawing/2014/main" id="{D611C4A3-3723-5564-EEC8-1506DE73C2FA}"/>
                    </a:ext>
                  </a:extLst>
                </p:cNvPr>
                <p:cNvSpPr/>
                <p:nvPr/>
              </p:nvSpPr>
              <p:spPr>
                <a:xfrm rot="11312380">
                  <a:off x="10214444" y="2933116"/>
                  <a:ext cx="427356" cy="192024"/>
                </a:xfrm>
                <a:prstGeom prst="blockArc">
                  <a:avLst>
                    <a:gd name="adj1" fmla="val 13519529"/>
                    <a:gd name="adj2" fmla="val 16615939"/>
                    <a:gd name="adj3" fmla="val 25588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Block Arc 41">
                  <a:extLst>
                    <a:ext uri="{FF2B5EF4-FFF2-40B4-BE49-F238E27FC236}">
                      <a16:creationId xmlns:a16="http://schemas.microsoft.com/office/drawing/2014/main" id="{668D6336-2D66-6DC9-37C1-E6D240C64A20}"/>
                    </a:ext>
                  </a:extLst>
                </p:cNvPr>
                <p:cNvSpPr/>
                <p:nvPr/>
              </p:nvSpPr>
              <p:spPr>
                <a:xfrm rot="11032256">
                  <a:off x="10238792" y="2931528"/>
                  <a:ext cx="427356" cy="192024"/>
                </a:xfrm>
                <a:prstGeom prst="blockArc">
                  <a:avLst>
                    <a:gd name="adj1" fmla="val 13519529"/>
                    <a:gd name="adj2" fmla="val 15470025"/>
                    <a:gd name="adj3" fmla="val 23131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" name="Rectangle: Rounded Corners 42">
                  <a:extLst>
                    <a:ext uri="{FF2B5EF4-FFF2-40B4-BE49-F238E27FC236}">
                      <a16:creationId xmlns:a16="http://schemas.microsoft.com/office/drawing/2014/main" id="{38CE6DF7-90DF-50BA-7573-4165DE47ABF2}"/>
                    </a:ext>
                  </a:extLst>
                </p:cNvPr>
                <p:cNvSpPr/>
                <p:nvPr/>
              </p:nvSpPr>
              <p:spPr>
                <a:xfrm>
                  <a:off x="10795109" y="2870200"/>
                  <a:ext cx="2235084" cy="358703"/>
                </a:xfrm>
                <a:prstGeom prst="roundRect">
                  <a:avLst>
                    <a:gd name="adj" fmla="val 30607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Rectangle: Rounded Corners 43">
                  <a:extLst>
                    <a:ext uri="{FF2B5EF4-FFF2-40B4-BE49-F238E27FC236}">
                      <a16:creationId xmlns:a16="http://schemas.microsoft.com/office/drawing/2014/main" id="{C54968FA-8D15-04B4-DC92-CFFB6E83598C}"/>
                    </a:ext>
                  </a:extLst>
                </p:cNvPr>
                <p:cNvSpPr/>
                <p:nvPr/>
              </p:nvSpPr>
              <p:spPr>
                <a:xfrm>
                  <a:off x="10565822" y="2637367"/>
                  <a:ext cx="2676045" cy="326453"/>
                </a:xfrm>
                <a:prstGeom prst="roundRect">
                  <a:avLst>
                    <a:gd name="adj" fmla="val 41305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rapezoid 44">
                  <a:extLst>
                    <a:ext uri="{FF2B5EF4-FFF2-40B4-BE49-F238E27FC236}">
                      <a16:creationId xmlns:a16="http://schemas.microsoft.com/office/drawing/2014/main" id="{E9B94114-BF27-F719-47A2-E94F87A7803C}"/>
                    </a:ext>
                  </a:extLst>
                </p:cNvPr>
                <p:cNvSpPr/>
                <p:nvPr/>
              </p:nvSpPr>
              <p:spPr>
                <a:xfrm rot="10800000">
                  <a:off x="10894226" y="7020147"/>
                  <a:ext cx="2071313" cy="2957101"/>
                </a:xfrm>
                <a:prstGeom prst="trapezoid">
                  <a:avLst>
                    <a:gd name="adj" fmla="val 36875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14E62CF8-689B-6D4D-EBF0-E46082F2BD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20487" y="7029540"/>
                  <a:ext cx="728432" cy="298318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B5617FD0-0423-F691-A854-EB88DD00CC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7020153"/>
                  <a:ext cx="744971" cy="2996972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81911518-8058-5100-72E5-FDA494F19807}"/>
                    </a:ext>
                  </a:extLst>
                </p:cNvPr>
                <p:cNvSpPr/>
                <p:nvPr/>
              </p:nvSpPr>
              <p:spPr>
                <a:xfrm>
                  <a:off x="10898271" y="3262086"/>
                  <a:ext cx="2050649" cy="1538229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63809F2C-6B8F-119A-08A1-BAFF398D48D4}"/>
                    </a:ext>
                  </a:extLst>
                </p:cNvPr>
                <p:cNvSpPr/>
                <p:nvPr/>
              </p:nvSpPr>
              <p:spPr>
                <a:xfrm>
                  <a:off x="11012077" y="4677907"/>
                  <a:ext cx="1827973" cy="2351633"/>
                </a:xfrm>
                <a:prstGeom prst="rect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3D2188EE-582B-AE22-2E8D-E5509D2E9F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530352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7D64AC25-FEBE-C021-4654-1F828F1B11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75046" y="685800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2" name="Oval 51">
                  <a:extLst>
                    <a:ext uri="{FF2B5EF4-FFF2-40B4-BE49-F238E27FC236}">
                      <a16:creationId xmlns:a16="http://schemas.microsoft.com/office/drawing/2014/main" id="{4CF43FF6-D773-04AC-4136-584D4152B913}"/>
                    </a:ext>
                  </a:extLst>
                </p:cNvPr>
                <p:cNvSpPr/>
                <p:nvPr/>
              </p:nvSpPr>
              <p:spPr>
                <a:xfrm>
                  <a:off x="11739712" y="9419272"/>
                  <a:ext cx="373655" cy="764859"/>
                </a:xfrm>
                <a:prstGeom prst="ellipse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C1067FCC-9AC3-25E9-F382-1666BC2A9C8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374396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2698B47E-2D03-2145-B483-1D0447BD49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48920" y="3236263"/>
                  <a:ext cx="0" cy="3808748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EABCF6E5-DC7C-6B69-B4E9-3BFE91FBDA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3236263"/>
                  <a:ext cx="0" cy="3801125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6" name="Trapezoid 55">
                  <a:extLst>
                    <a:ext uri="{FF2B5EF4-FFF2-40B4-BE49-F238E27FC236}">
                      <a16:creationId xmlns:a16="http://schemas.microsoft.com/office/drawing/2014/main" id="{B67D6BE6-DB81-CE1C-9015-48DAF539C1CD}"/>
                    </a:ext>
                  </a:extLst>
                </p:cNvPr>
                <p:cNvSpPr/>
                <p:nvPr/>
              </p:nvSpPr>
              <p:spPr>
                <a:xfrm rot="10800000">
                  <a:off x="11020539" y="7078403"/>
                  <a:ext cx="1810512" cy="2957103"/>
                </a:xfrm>
                <a:prstGeom prst="trapezoid">
                  <a:avLst>
                    <a:gd name="adj" fmla="val 41887"/>
                  </a:avLst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Trapezoid 56">
                  <a:extLst>
                    <a:ext uri="{FF2B5EF4-FFF2-40B4-BE49-F238E27FC236}">
                      <a16:creationId xmlns:a16="http://schemas.microsoft.com/office/drawing/2014/main" id="{3B945275-2ABE-8487-D0FF-9147ABE1B08D}"/>
                    </a:ext>
                  </a:extLst>
                </p:cNvPr>
                <p:cNvSpPr/>
                <p:nvPr/>
              </p:nvSpPr>
              <p:spPr>
                <a:xfrm rot="10800000">
                  <a:off x="11923760" y="9993713"/>
                  <a:ext cx="123106" cy="85889"/>
                </a:xfrm>
                <a:prstGeom prst="trapezoid">
                  <a:avLst>
                    <a:gd name="adj" fmla="val 3698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8" name="Rectangle: Rounded Corners 57">
                  <a:extLst>
                    <a:ext uri="{FF2B5EF4-FFF2-40B4-BE49-F238E27FC236}">
                      <a16:creationId xmlns:a16="http://schemas.microsoft.com/office/drawing/2014/main" id="{4E6EEC3F-4D8E-50FA-270D-01AB652AD804}"/>
                    </a:ext>
                  </a:extLst>
                </p:cNvPr>
                <p:cNvSpPr/>
                <p:nvPr/>
              </p:nvSpPr>
              <p:spPr>
                <a:xfrm>
                  <a:off x="11042409" y="6947349"/>
                  <a:ext cx="1765478" cy="195322"/>
                </a:xfrm>
                <a:prstGeom prst="roundRect">
                  <a:avLst>
                    <a:gd name="adj" fmla="val 1961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24B754EE-8B63-E9C8-EC86-28A69C69CF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12077" y="7050469"/>
                  <a:ext cx="49623" cy="182344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0769D5E0-E5B1-D0BE-78C7-2485530BE1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786299" y="7042931"/>
                  <a:ext cx="46451" cy="186953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rapezoid 32">
                <a:extLst>
                  <a:ext uri="{FF2B5EF4-FFF2-40B4-BE49-F238E27FC236}">
                    <a16:creationId xmlns:a16="http://schemas.microsoft.com/office/drawing/2014/main" id="{788B04E3-1722-2760-AED9-6FE0FFD75AC9}"/>
                  </a:ext>
                </a:extLst>
              </p:cNvPr>
              <p:cNvSpPr/>
              <p:nvPr/>
            </p:nvSpPr>
            <p:spPr>
              <a:xfrm rot="10800000">
                <a:off x="10939945" y="10247711"/>
                <a:ext cx="131984" cy="98613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4" name="Trapezoid 33">
                <a:extLst>
                  <a:ext uri="{FF2B5EF4-FFF2-40B4-BE49-F238E27FC236}">
                    <a16:creationId xmlns:a16="http://schemas.microsoft.com/office/drawing/2014/main" id="{6C244FBF-20D9-9C0B-22B9-8B6635270C9A}"/>
                  </a:ext>
                </a:extLst>
              </p:cNvPr>
              <p:cNvSpPr/>
              <p:nvPr/>
            </p:nvSpPr>
            <p:spPr>
              <a:xfrm rot="10800000">
                <a:off x="10996688" y="10255028"/>
                <a:ext cx="126948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184B965-9999-74C7-812E-97AEA99177C1}"/>
                </a:ext>
              </a:extLst>
            </p:cNvPr>
            <p:cNvSpPr txBox="1"/>
            <p:nvPr/>
          </p:nvSpPr>
          <p:spPr>
            <a:xfrm>
              <a:off x="-1120990" y="16335208"/>
              <a:ext cx="9217654" cy="3142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0" dirty="0"/>
                <a:t>TX-TL reaction mixture</a:t>
              </a:r>
            </a:p>
          </p:txBody>
        </p:sp>
        <p:sp>
          <p:nvSpPr>
            <p:cNvPr id="19" name="Hexagon 18">
              <a:extLst>
                <a:ext uri="{FF2B5EF4-FFF2-40B4-BE49-F238E27FC236}">
                  <a16:creationId xmlns:a16="http://schemas.microsoft.com/office/drawing/2014/main" id="{0E57C74F-B3DF-1881-8660-FBD6173B47F7}"/>
                </a:ext>
              </a:extLst>
            </p:cNvPr>
            <p:cNvSpPr/>
            <p:nvPr/>
          </p:nvSpPr>
          <p:spPr>
            <a:xfrm>
              <a:off x="2646064" y="11393153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Hexagon 19">
              <a:extLst>
                <a:ext uri="{FF2B5EF4-FFF2-40B4-BE49-F238E27FC236}">
                  <a16:creationId xmlns:a16="http://schemas.microsoft.com/office/drawing/2014/main" id="{9D4818E2-455F-3282-8441-90E48C94F53E}"/>
                </a:ext>
              </a:extLst>
            </p:cNvPr>
            <p:cNvSpPr/>
            <p:nvPr/>
          </p:nvSpPr>
          <p:spPr>
            <a:xfrm>
              <a:off x="3726148" y="1178582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Hexagon 20">
              <a:extLst>
                <a:ext uri="{FF2B5EF4-FFF2-40B4-BE49-F238E27FC236}">
                  <a16:creationId xmlns:a16="http://schemas.microsoft.com/office/drawing/2014/main" id="{85E35CAB-95B6-11C0-C28F-D828983769A2}"/>
                </a:ext>
              </a:extLst>
            </p:cNvPr>
            <p:cNvSpPr/>
            <p:nvPr/>
          </p:nvSpPr>
          <p:spPr>
            <a:xfrm>
              <a:off x="2965781" y="12688178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Hexagon 21">
              <a:extLst>
                <a:ext uri="{FF2B5EF4-FFF2-40B4-BE49-F238E27FC236}">
                  <a16:creationId xmlns:a16="http://schemas.microsoft.com/office/drawing/2014/main" id="{036985BD-17B8-486A-2AEC-9763180AE7B7}"/>
                </a:ext>
              </a:extLst>
            </p:cNvPr>
            <p:cNvSpPr/>
            <p:nvPr/>
          </p:nvSpPr>
          <p:spPr>
            <a:xfrm>
              <a:off x="3586448" y="10994577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Hexagon 22">
              <a:extLst>
                <a:ext uri="{FF2B5EF4-FFF2-40B4-BE49-F238E27FC236}">
                  <a16:creationId xmlns:a16="http://schemas.microsoft.com/office/drawing/2014/main" id="{70E8751E-E408-FB4D-8B91-733CBF55843C}"/>
                </a:ext>
              </a:extLst>
            </p:cNvPr>
            <p:cNvSpPr/>
            <p:nvPr/>
          </p:nvSpPr>
          <p:spPr>
            <a:xfrm>
              <a:off x="3654145" y="1385148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16D50E1F-6C3B-6C12-B7B3-8409782834B3}"/>
                </a:ext>
              </a:extLst>
            </p:cNvPr>
            <p:cNvSpPr/>
            <p:nvPr/>
          </p:nvSpPr>
          <p:spPr>
            <a:xfrm>
              <a:off x="3081655" y="1195580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79EF2BB8-E2C0-27DA-B26C-BA6A92B88EDC}"/>
                </a:ext>
              </a:extLst>
            </p:cNvPr>
            <p:cNvSpPr/>
            <p:nvPr/>
          </p:nvSpPr>
          <p:spPr>
            <a:xfrm>
              <a:off x="3364944" y="1235695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E80CF54C-B032-3D19-4667-CDF9501D09BC}"/>
                </a:ext>
              </a:extLst>
            </p:cNvPr>
            <p:cNvSpPr/>
            <p:nvPr/>
          </p:nvSpPr>
          <p:spPr>
            <a:xfrm>
              <a:off x="3010530" y="14107849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" name="Connector: Curved 26">
              <a:extLst>
                <a:ext uri="{FF2B5EF4-FFF2-40B4-BE49-F238E27FC236}">
                  <a16:creationId xmlns:a16="http://schemas.microsoft.com/office/drawing/2014/main" id="{0D03A762-611E-27C5-B3D1-EA2BF6FF139B}"/>
                </a:ext>
              </a:extLst>
            </p:cNvPr>
            <p:cNvCxnSpPr/>
            <p:nvPr/>
          </p:nvCxnSpPr>
          <p:spPr>
            <a:xfrm rot="10800000" flipV="1">
              <a:off x="3207177" y="13301673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or: Curved 27">
              <a:extLst>
                <a:ext uri="{FF2B5EF4-FFF2-40B4-BE49-F238E27FC236}">
                  <a16:creationId xmlns:a16="http://schemas.microsoft.com/office/drawing/2014/main" id="{5D666390-1B99-3C6B-4453-F784746C934E}"/>
                </a:ext>
              </a:extLst>
            </p:cNvPr>
            <p:cNvCxnSpPr/>
            <p:nvPr/>
          </p:nvCxnSpPr>
          <p:spPr>
            <a:xfrm rot="10800000" flipV="1">
              <a:off x="2882340" y="116039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or: Curved 28">
              <a:extLst>
                <a:ext uri="{FF2B5EF4-FFF2-40B4-BE49-F238E27FC236}">
                  <a16:creationId xmlns:a16="http://schemas.microsoft.com/office/drawing/2014/main" id="{723A38D4-F324-0A2E-7034-2069AA1F9132}"/>
                </a:ext>
              </a:extLst>
            </p:cNvPr>
            <p:cNvCxnSpPr/>
            <p:nvPr/>
          </p:nvCxnSpPr>
          <p:spPr>
            <a:xfrm rot="10800000" flipV="1">
              <a:off x="3263340" y="128866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or: Curved 29">
              <a:extLst>
                <a:ext uri="{FF2B5EF4-FFF2-40B4-BE49-F238E27FC236}">
                  <a16:creationId xmlns:a16="http://schemas.microsoft.com/office/drawing/2014/main" id="{8C425428-1BD5-15A6-21E5-2D2B8EE06AAD}"/>
                </a:ext>
              </a:extLst>
            </p:cNvPr>
            <p:cNvCxnSpPr/>
            <p:nvPr/>
          </p:nvCxnSpPr>
          <p:spPr>
            <a:xfrm rot="10800000" flipV="1">
              <a:off x="3359577" y="145032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1" name="Picture 60">
            <a:extLst>
              <a:ext uri="{FF2B5EF4-FFF2-40B4-BE49-F238E27FC236}">
                <a16:creationId xmlns:a16="http://schemas.microsoft.com/office/drawing/2014/main" id="{E8882BC8-766F-7A68-5841-94AFBDB73D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15201" y="150445"/>
            <a:ext cx="5057081" cy="8591688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FA6CA5DD-A0E4-2D77-E4F9-B91098ACA50D}"/>
              </a:ext>
            </a:extLst>
          </p:cNvPr>
          <p:cNvSpPr txBox="1"/>
          <p:nvPr/>
        </p:nvSpPr>
        <p:spPr>
          <a:xfrm>
            <a:off x="11896927" y="8993759"/>
            <a:ext cx="7599229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Echo 525 Liquid Handler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9C25978F-13C4-4E13-F2DA-17AEA88C82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17188" y="8160659"/>
            <a:ext cx="7599230" cy="5624289"/>
          </a:xfrm>
          <a:prstGeom prst="rect">
            <a:avLst/>
          </a:prstGeom>
        </p:spPr>
      </p:pic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98520662-67F2-86D0-B3AB-EE604755629D}"/>
              </a:ext>
            </a:extLst>
          </p:cNvPr>
          <p:cNvCxnSpPr>
            <a:cxnSpLocks/>
          </p:cNvCxnSpPr>
          <p:nvPr/>
        </p:nvCxnSpPr>
        <p:spPr>
          <a:xfrm>
            <a:off x="10050960" y="6226185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5CDA4EFA-0B3D-09E3-8105-4A3814A667E2}"/>
              </a:ext>
            </a:extLst>
          </p:cNvPr>
          <p:cNvSpPr txBox="1"/>
          <p:nvPr/>
        </p:nvSpPr>
        <p:spPr>
          <a:xfrm>
            <a:off x="21086422" y="13825824"/>
            <a:ext cx="746076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10µL reactions in 384-well plate</a:t>
            </a:r>
          </a:p>
        </p:txBody>
      </p:sp>
      <p:sp>
        <p:nvSpPr>
          <p:cNvPr id="73" name="Hexagon 72">
            <a:extLst>
              <a:ext uri="{FF2B5EF4-FFF2-40B4-BE49-F238E27FC236}">
                <a16:creationId xmlns:a16="http://schemas.microsoft.com/office/drawing/2014/main" id="{F63E90C7-D21D-6C2E-EC1F-AB6EF5883BE7}"/>
              </a:ext>
            </a:extLst>
          </p:cNvPr>
          <p:cNvSpPr/>
          <p:nvPr/>
        </p:nvSpPr>
        <p:spPr>
          <a:xfrm rot="1800000">
            <a:off x="4486482" y="6314286"/>
            <a:ext cx="2743200" cy="2377440"/>
          </a:xfrm>
          <a:prstGeom prst="hexagon">
            <a:avLst>
              <a:gd name="adj" fmla="val 28695"/>
              <a:gd name="vf" fmla="val 115470"/>
            </a:avLst>
          </a:prstGeom>
          <a:solidFill>
            <a:srgbClr val="E5EBFB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622627A-A879-540B-0D40-2C6ECACD27B3}"/>
              </a:ext>
            </a:extLst>
          </p:cNvPr>
          <p:cNvSpPr txBox="1"/>
          <p:nvPr/>
        </p:nvSpPr>
        <p:spPr>
          <a:xfrm>
            <a:off x="4654165" y="6732252"/>
            <a:ext cx="240783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/>
              <a:t>Fuel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BD7F2BBC-1C79-BA36-D024-6CC7329B4BF7}"/>
              </a:ext>
            </a:extLst>
          </p:cNvPr>
          <p:cNvGrpSpPr/>
          <p:nvPr/>
        </p:nvGrpSpPr>
        <p:grpSpPr>
          <a:xfrm>
            <a:off x="-946432" y="987599"/>
            <a:ext cx="10293631" cy="4419469"/>
            <a:chOff x="489316" y="12831878"/>
            <a:chExt cx="10293631" cy="441946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DE71032-0CE4-3FE4-553B-EFBDB3851C2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95969" y="14032207"/>
              <a:ext cx="1640904" cy="1647403"/>
            </a:xfrm>
            <a:prstGeom prst="rect">
              <a:avLst/>
            </a:prstGeom>
          </p:spPr>
        </p:pic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C7AFCE27-B887-BFB8-7E69-FD36E0DDAE75}"/>
                </a:ext>
              </a:extLst>
            </p:cNvPr>
            <p:cNvSpPr/>
            <p:nvPr/>
          </p:nvSpPr>
          <p:spPr>
            <a:xfrm>
              <a:off x="489316" y="15707157"/>
              <a:ext cx="10293631" cy="1544190"/>
            </a:xfrm>
            <a:prstGeom prst="roundRect">
              <a:avLst/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1019A6BA-02E5-084C-2485-D6A97B076E58}"/>
                </a:ext>
              </a:extLst>
            </p:cNvPr>
            <p:cNvCxnSpPr/>
            <p:nvPr/>
          </p:nvCxnSpPr>
          <p:spPr>
            <a:xfrm>
              <a:off x="1154301" y="14294282"/>
              <a:ext cx="0" cy="14630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AF52A3FA-D712-A46E-9D6D-C5DBD456E9D4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15" y="14347622"/>
              <a:ext cx="1043360" cy="0"/>
            </a:xfrm>
            <a:prstGeom prst="line">
              <a:avLst/>
            </a:prstGeom>
            <a:ln w="1143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Partial Circle 14">
              <a:extLst>
                <a:ext uri="{FF2B5EF4-FFF2-40B4-BE49-F238E27FC236}">
                  <a16:creationId xmlns:a16="http://schemas.microsoft.com/office/drawing/2014/main" id="{8E8E0BFD-8976-3C57-D7ED-89125F74EFB6}"/>
                </a:ext>
              </a:extLst>
            </p:cNvPr>
            <p:cNvSpPr/>
            <p:nvPr/>
          </p:nvSpPr>
          <p:spPr>
            <a:xfrm rot="5400000">
              <a:off x="4085125" y="15265521"/>
              <a:ext cx="1035047" cy="883279"/>
            </a:xfrm>
            <a:prstGeom prst="pie">
              <a:avLst>
                <a:gd name="adj1" fmla="val 5418294"/>
                <a:gd name="adj2" fmla="val 16200000"/>
              </a:avLst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3873E46-EBFD-494B-0C31-52EAB1E3F81E}"/>
                </a:ext>
              </a:extLst>
            </p:cNvPr>
            <p:cNvSpPr txBox="1"/>
            <p:nvPr/>
          </p:nvSpPr>
          <p:spPr>
            <a:xfrm>
              <a:off x="5643928" y="15106995"/>
              <a:ext cx="3698875" cy="1200329"/>
            </a:xfrm>
            <a:prstGeom prst="homePlate">
              <a:avLst/>
            </a:prstGeom>
            <a:solidFill>
              <a:srgbClr val="70AD47"/>
            </a:solidFill>
            <a:ln w="762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200" b="1" i="1" dirty="0"/>
                <a:t>deGFP</a:t>
              </a:r>
              <a:endParaRPr lang="en-US" sz="7401" b="1" i="1" dirty="0"/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116E1721-8F45-915E-8797-40069DABA2B0}"/>
                </a:ext>
              </a:extLst>
            </p:cNvPr>
            <p:cNvCxnSpPr/>
            <p:nvPr/>
          </p:nvCxnSpPr>
          <p:spPr>
            <a:xfrm>
              <a:off x="9885096" y="14666863"/>
              <a:ext cx="0" cy="10058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2B7BF86A-78D9-8D99-317E-9C776424E355}"/>
                </a:ext>
              </a:extLst>
            </p:cNvPr>
            <p:cNvCxnSpPr>
              <a:cxnSpLocks/>
            </p:cNvCxnSpPr>
            <p:nvPr/>
          </p:nvCxnSpPr>
          <p:spPr>
            <a:xfrm>
              <a:off x="9342803" y="14677464"/>
              <a:ext cx="1028701" cy="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FBBCC03-EA72-2A31-6965-7F3A3832AAC8}"/>
                </a:ext>
              </a:extLst>
            </p:cNvPr>
            <p:cNvSpPr txBox="1"/>
            <p:nvPr/>
          </p:nvSpPr>
          <p:spPr>
            <a:xfrm>
              <a:off x="2395971" y="12831878"/>
              <a:ext cx="1802897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200" b="1" dirty="0"/>
                <a:t>MG</a:t>
              </a:r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24B87E41-770E-2AFE-87B9-273D9013475A}"/>
                </a:ext>
              </a:extLst>
            </p:cNvPr>
            <p:cNvSpPr/>
            <p:nvPr/>
          </p:nvSpPr>
          <p:spPr>
            <a:xfrm>
              <a:off x="3965742" y="13157719"/>
              <a:ext cx="548640" cy="548640"/>
            </a:xfrm>
            <a:prstGeom prst="ellipse">
              <a:avLst/>
            </a:prstGeom>
            <a:solidFill>
              <a:schemeClr val="accent2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Arc 87">
            <a:extLst>
              <a:ext uri="{FF2B5EF4-FFF2-40B4-BE49-F238E27FC236}">
                <a16:creationId xmlns:a16="http://schemas.microsoft.com/office/drawing/2014/main" id="{0D632810-2253-E3EA-4CF4-C4FB6CB6D68B}"/>
              </a:ext>
            </a:extLst>
          </p:cNvPr>
          <p:cNvSpPr/>
          <p:nvPr/>
        </p:nvSpPr>
        <p:spPr>
          <a:xfrm>
            <a:off x="16898462" y="4423353"/>
            <a:ext cx="5355276" cy="5624289"/>
          </a:xfrm>
          <a:prstGeom prst="arc">
            <a:avLst/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Arc 88">
            <a:extLst>
              <a:ext uri="{FF2B5EF4-FFF2-40B4-BE49-F238E27FC236}">
                <a16:creationId xmlns:a16="http://schemas.microsoft.com/office/drawing/2014/main" id="{0E0BA8D1-C99A-9920-1E18-DFA69A3FDAAD}"/>
              </a:ext>
            </a:extLst>
          </p:cNvPr>
          <p:cNvSpPr/>
          <p:nvPr/>
        </p:nvSpPr>
        <p:spPr>
          <a:xfrm flipV="1">
            <a:off x="16891975" y="14079353"/>
            <a:ext cx="5355276" cy="5624289"/>
          </a:xfrm>
          <a:prstGeom prst="arc">
            <a:avLst/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35BB5BA5-4DEF-9A71-AD0D-0002769F92A6}"/>
              </a:ext>
            </a:extLst>
          </p:cNvPr>
          <p:cNvCxnSpPr>
            <a:cxnSpLocks/>
          </p:cNvCxnSpPr>
          <p:nvPr/>
        </p:nvCxnSpPr>
        <p:spPr>
          <a:xfrm>
            <a:off x="29127465" y="11022466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A5749A71-7D1C-92F5-2FCC-A6E9F0892D89}"/>
              </a:ext>
            </a:extLst>
          </p:cNvPr>
          <p:cNvCxnSpPr>
            <a:cxnSpLocks/>
          </p:cNvCxnSpPr>
          <p:nvPr/>
        </p:nvCxnSpPr>
        <p:spPr>
          <a:xfrm>
            <a:off x="36165586" y="8238466"/>
            <a:ext cx="228809" cy="17841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2D7033D7-BE29-A11F-955C-B2D90450BB98}"/>
              </a:ext>
            </a:extLst>
          </p:cNvPr>
          <p:cNvCxnSpPr>
            <a:cxnSpLocks/>
          </p:cNvCxnSpPr>
          <p:nvPr/>
        </p:nvCxnSpPr>
        <p:spPr>
          <a:xfrm>
            <a:off x="36572378" y="8276022"/>
            <a:ext cx="181741" cy="152504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DC5D246D-72FC-CD2F-22CE-0556F7E3BFAA}"/>
              </a:ext>
            </a:extLst>
          </p:cNvPr>
          <p:cNvCxnSpPr>
            <a:cxnSpLocks/>
          </p:cNvCxnSpPr>
          <p:nvPr/>
        </p:nvCxnSpPr>
        <p:spPr>
          <a:xfrm>
            <a:off x="36906460" y="8303176"/>
            <a:ext cx="98328" cy="11370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C3CA2A48-D756-CA2B-3CC6-C68EFE72F73C}"/>
              </a:ext>
            </a:extLst>
          </p:cNvPr>
          <p:cNvCxnSpPr>
            <a:cxnSpLocks/>
          </p:cNvCxnSpPr>
          <p:nvPr/>
        </p:nvCxnSpPr>
        <p:spPr>
          <a:xfrm>
            <a:off x="34646857" y="6629541"/>
            <a:ext cx="425332" cy="35822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D1F5D2C2-1717-8A69-F524-9B0E0D40F08A}"/>
              </a:ext>
            </a:extLst>
          </p:cNvPr>
          <p:cNvCxnSpPr>
            <a:cxnSpLocks/>
          </p:cNvCxnSpPr>
          <p:nvPr/>
        </p:nvCxnSpPr>
        <p:spPr>
          <a:xfrm>
            <a:off x="34678726" y="6369404"/>
            <a:ext cx="349219" cy="290398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3EE31A63-2FCF-DF35-15B9-1BBEE753A62C}"/>
              </a:ext>
            </a:extLst>
          </p:cNvPr>
          <p:cNvCxnSpPr>
            <a:cxnSpLocks/>
          </p:cNvCxnSpPr>
          <p:nvPr/>
        </p:nvCxnSpPr>
        <p:spPr>
          <a:xfrm>
            <a:off x="34710594" y="6076030"/>
            <a:ext cx="272237" cy="24433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D77F9450-AEC8-6827-073C-A9B1F9CF538E}"/>
              </a:ext>
            </a:extLst>
          </p:cNvPr>
          <p:cNvCxnSpPr>
            <a:cxnSpLocks/>
          </p:cNvCxnSpPr>
          <p:nvPr/>
        </p:nvCxnSpPr>
        <p:spPr>
          <a:xfrm>
            <a:off x="34614989" y="6869541"/>
            <a:ext cx="533580" cy="479879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FE254BBC-C8AF-36F0-3FBA-54F6B2E3660F}"/>
              </a:ext>
            </a:extLst>
          </p:cNvPr>
          <p:cNvCxnSpPr>
            <a:cxnSpLocks/>
          </p:cNvCxnSpPr>
          <p:nvPr/>
        </p:nvCxnSpPr>
        <p:spPr>
          <a:xfrm>
            <a:off x="34592348" y="7116436"/>
            <a:ext cx="1449242" cy="131209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4BD0E5D1-954C-8DB2-3D92-BE9813698625}"/>
              </a:ext>
            </a:extLst>
          </p:cNvPr>
          <p:cNvCxnSpPr>
            <a:cxnSpLocks/>
          </p:cNvCxnSpPr>
          <p:nvPr/>
        </p:nvCxnSpPr>
        <p:spPr>
          <a:xfrm>
            <a:off x="34432555" y="8221333"/>
            <a:ext cx="260815" cy="197094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4940969-82C4-AC07-F67C-C14DEC7ED908}"/>
              </a:ext>
            </a:extLst>
          </p:cNvPr>
          <p:cNvCxnSpPr>
            <a:cxnSpLocks/>
          </p:cNvCxnSpPr>
          <p:nvPr/>
        </p:nvCxnSpPr>
        <p:spPr>
          <a:xfrm>
            <a:off x="34495524" y="7914311"/>
            <a:ext cx="532420" cy="49233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D966CE83-F097-C58E-5A06-8C1619A04674}"/>
              </a:ext>
            </a:extLst>
          </p:cNvPr>
          <p:cNvCxnSpPr>
            <a:cxnSpLocks/>
          </p:cNvCxnSpPr>
          <p:nvPr/>
        </p:nvCxnSpPr>
        <p:spPr>
          <a:xfrm>
            <a:off x="34562961" y="7410670"/>
            <a:ext cx="1171216" cy="100621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E0697D64-A876-2864-BE0E-2A2843FA696D}"/>
              </a:ext>
            </a:extLst>
          </p:cNvPr>
          <p:cNvCxnSpPr>
            <a:cxnSpLocks/>
            <a:stCxn id="116" idx="1"/>
          </p:cNvCxnSpPr>
          <p:nvPr/>
        </p:nvCxnSpPr>
        <p:spPr>
          <a:xfrm>
            <a:off x="34519739" y="7664042"/>
            <a:ext cx="872104" cy="76448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105" name="Ink 104">
                <a:extLst>
                  <a:ext uri="{FF2B5EF4-FFF2-40B4-BE49-F238E27FC236}">
                    <a16:creationId xmlns:a16="http://schemas.microsoft.com/office/drawing/2014/main" id="{432EC8B9-14B9-8C34-74CC-25AE2D696AB4}"/>
                  </a:ext>
                </a:extLst>
              </p14:cNvPr>
              <p14:cNvContentPartPr/>
              <p14:nvPr/>
            </p14:nvContentPartPr>
            <p14:xfrm>
              <a:off x="34409797" y="9540731"/>
              <a:ext cx="3106518" cy="3038352"/>
            </p14:xfrm>
          </p:contentPart>
        </mc:Choice>
        <mc:Fallback xmlns="">
          <p:pic>
            <p:nvPicPr>
              <p:cNvPr id="105" name="Ink 104">
                <a:extLst>
                  <a:ext uri="{FF2B5EF4-FFF2-40B4-BE49-F238E27FC236}">
                    <a16:creationId xmlns:a16="http://schemas.microsoft.com/office/drawing/2014/main" id="{432EC8B9-14B9-8C34-74CC-25AE2D696AB4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384239" y="9515171"/>
                <a:ext cx="3156913" cy="3088751"/>
              </a:xfrm>
              <a:prstGeom prst="rect">
                <a:avLst/>
              </a:prstGeom>
            </p:spPr>
          </p:pic>
        </mc:Fallback>
      </mc:AlternateContent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C3093B16-34A8-7115-6D1F-9AB444BFD86D}"/>
              </a:ext>
            </a:extLst>
          </p:cNvPr>
          <p:cNvCxnSpPr/>
          <p:nvPr/>
        </p:nvCxnSpPr>
        <p:spPr>
          <a:xfrm flipV="1">
            <a:off x="34409798" y="9378683"/>
            <a:ext cx="0" cy="32004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ACC98C72-9764-B314-711B-A348BB6BE137}"/>
              </a:ext>
            </a:extLst>
          </p:cNvPr>
          <p:cNvCxnSpPr>
            <a:cxnSpLocks/>
          </p:cNvCxnSpPr>
          <p:nvPr/>
        </p:nvCxnSpPr>
        <p:spPr>
          <a:xfrm>
            <a:off x="34409798" y="12579083"/>
            <a:ext cx="32004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D96E6461-1AEB-8344-9B33-6658C8DCF5E3}"/>
              </a:ext>
            </a:extLst>
          </p:cNvPr>
          <p:cNvSpPr txBox="1"/>
          <p:nvPr/>
        </p:nvSpPr>
        <p:spPr>
          <a:xfrm>
            <a:off x="36150918" y="12582177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0FD29B7-B55B-3F04-4619-D805044ED9F4}"/>
              </a:ext>
            </a:extLst>
          </p:cNvPr>
          <p:cNvSpPr txBox="1"/>
          <p:nvPr/>
        </p:nvSpPr>
        <p:spPr>
          <a:xfrm>
            <a:off x="32796854" y="9248633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deGFP</a:t>
            </a:r>
            <a:endParaRPr lang="en-US" b="1" dirty="0"/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FB108647-36EA-45BF-F6B9-4753A2CF857D}"/>
              </a:ext>
            </a:extLst>
          </p:cNvPr>
          <p:cNvCxnSpPr/>
          <p:nvPr/>
        </p:nvCxnSpPr>
        <p:spPr>
          <a:xfrm flipV="1">
            <a:off x="34409798" y="5219573"/>
            <a:ext cx="0" cy="32004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A9988CA2-DCB5-1B19-184D-3E6832141100}"/>
              </a:ext>
            </a:extLst>
          </p:cNvPr>
          <p:cNvCxnSpPr>
            <a:cxnSpLocks/>
          </p:cNvCxnSpPr>
          <p:nvPr/>
        </p:nvCxnSpPr>
        <p:spPr>
          <a:xfrm>
            <a:off x="34409798" y="8419973"/>
            <a:ext cx="3200400" cy="0"/>
          </a:xfrm>
          <a:prstGeom prst="straightConnector1">
            <a:avLst/>
          </a:prstGeom>
          <a:ln w="381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9B667D2D-3BA5-E143-BC16-C11B822BB9B4}"/>
              </a:ext>
            </a:extLst>
          </p:cNvPr>
          <p:cNvSpPr txBox="1"/>
          <p:nvPr/>
        </p:nvSpPr>
        <p:spPr>
          <a:xfrm>
            <a:off x="36150918" y="8423067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CB20F3C-8FB0-AFEE-846F-77EA1E0E3D42}"/>
              </a:ext>
            </a:extLst>
          </p:cNvPr>
          <p:cNvSpPr txBox="1"/>
          <p:nvPr/>
        </p:nvSpPr>
        <p:spPr>
          <a:xfrm>
            <a:off x="32796854" y="5089523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Gapt</a:t>
            </a:r>
            <a:endParaRPr lang="en-US" b="1" dirty="0"/>
          </a:p>
        </p:txBody>
      </p:sp>
      <p:sp>
        <p:nvSpPr>
          <p:cNvPr id="115" name="Rectangle: Rounded Corners 114">
            <a:extLst>
              <a:ext uri="{FF2B5EF4-FFF2-40B4-BE49-F238E27FC236}">
                <a16:creationId xmlns:a16="http://schemas.microsoft.com/office/drawing/2014/main" id="{78770554-794D-E4CC-57DC-28CAF9C7F1A2}"/>
              </a:ext>
            </a:extLst>
          </p:cNvPr>
          <p:cNvSpPr/>
          <p:nvPr/>
        </p:nvSpPr>
        <p:spPr>
          <a:xfrm>
            <a:off x="33047523" y="4699001"/>
            <a:ext cx="4952330" cy="8615719"/>
          </a:xfrm>
          <a:prstGeom prst="roundRect">
            <a:avLst>
              <a:gd name="adj" fmla="val 11426"/>
            </a:avLst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Freeform: Shape 115">
            <a:extLst>
              <a:ext uri="{FF2B5EF4-FFF2-40B4-BE49-F238E27FC236}">
                <a16:creationId xmlns:a16="http://schemas.microsoft.com/office/drawing/2014/main" id="{8CD56F5E-A8EC-38B5-1754-CBB4A734746C}"/>
              </a:ext>
            </a:extLst>
          </p:cNvPr>
          <p:cNvSpPr/>
          <p:nvPr/>
        </p:nvSpPr>
        <p:spPr>
          <a:xfrm>
            <a:off x="34434015" y="5732448"/>
            <a:ext cx="3057525" cy="2665018"/>
          </a:xfrm>
          <a:custGeom>
            <a:avLst/>
            <a:gdLst>
              <a:gd name="connsiteX0" fmla="*/ 0 w 3057525"/>
              <a:gd name="connsiteY0" fmla="*/ 2665018 h 2665018"/>
              <a:gd name="connsiteX1" fmla="*/ 85725 w 3057525"/>
              <a:gd name="connsiteY1" fmla="*/ 1931593 h 2665018"/>
              <a:gd name="connsiteX2" fmla="*/ 209550 w 3057525"/>
              <a:gd name="connsiteY2" fmla="*/ 883843 h 2665018"/>
              <a:gd name="connsiteX3" fmla="*/ 304800 w 3057525"/>
              <a:gd name="connsiteY3" fmla="*/ 159943 h 2665018"/>
              <a:gd name="connsiteX4" fmla="*/ 352425 w 3057525"/>
              <a:gd name="connsiteY4" fmla="*/ 36118 h 2665018"/>
              <a:gd name="connsiteX5" fmla="*/ 428625 w 3057525"/>
              <a:gd name="connsiteY5" fmla="*/ 26593 h 2665018"/>
              <a:gd name="connsiteX6" fmla="*/ 495300 w 3057525"/>
              <a:gd name="connsiteY6" fmla="*/ 359968 h 2665018"/>
              <a:gd name="connsiteX7" fmla="*/ 561975 w 3057525"/>
              <a:gd name="connsiteY7" fmla="*/ 750493 h 2665018"/>
              <a:gd name="connsiteX8" fmla="*/ 638175 w 3057525"/>
              <a:gd name="connsiteY8" fmla="*/ 1264843 h 2665018"/>
              <a:gd name="connsiteX9" fmla="*/ 771525 w 3057525"/>
              <a:gd name="connsiteY9" fmla="*/ 1769668 h 2665018"/>
              <a:gd name="connsiteX10" fmla="*/ 923925 w 3057525"/>
              <a:gd name="connsiteY10" fmla="*/ 2064943 h 2665018"/>
              <a:gd name="connsiteX11" fmla="*/ 1162050 w 3057525"/>
              <a:gd name="connsiteY11" fmla="*/ 2303068 h 2665018"/>
              <a:gd name="connsiteX12" fmla="*/ 1352550 w 3057525"/>
              <a:gd name="connsiteY12" fmla="*/ 2398318 h 2665018"/>
              <a:gd name="connsiteX13" fmla="*/ 1609725 w 3057525"/>
              <a:gd name="connsiteY13" fmla="*/ 2484043 h 2665018"/>
              <a:gd name="connsiteX14" fmla="*/ 1924050 w 3057525"/>
              <a:gd name="connsiteY14" fmla="*/ 2531668 h 2665018"/>
              <a:gd name="connsiteX15" fmla="*/ 2305050 w 3057525"/>
              <a:gd name="connsiteY15" fmla="*/ 2560243 h 2665018"/>
              <a:gd name="connsiteX16" fmla="*/ 2771775 w 3057525"/>
              <a:gd name="connsiteY16" fmla="*/ 2588818 h 2665018"/>
              <a:gd name="connsiteX17" fmla="*/ 3057525 w 3057525"/>
              <a:gd name="connsiteY17" fmla="*/ 2607868 h 2665018"/>
              <a:gd name="connsiteX18" fmla="*/ 3057525 w 3057525"/>
              <a:gd name="connsiteY18" fmla="*/ 2607868 h 26650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3057525" h="2665018">
                <a:moveTo>
                  <a:pt x="0" y="2665018"/>
                </a:moveTo>
                <a:cubicBezTo>
                  <a:pt x="25400" y="2446737"/>
                  <a:pt x="50800" y="2228456"/>
                  <a:pt x="85725" y="1931593"/>
                </a:cubicBezTo>
                <a:cubicBezTo>
                  <a:pt x="120650" y="1634730"/>
                  <a:pt x="173038" y="1179118"/>
                  <a:pt x="209550" y="883843"/>
                </a:cubicBezTo>
                <a:cubicBezTo>
                  <a:pt x="246062" y="588568"/>
                  <a:pt x="280988" y="301230"/>
                  <a:pt x="304800" y="159943"/>
                </a:cubicBezTo>
                <a:cubicBezTo>
                  <a:pt x="328612" y="18656"/>
                  <a:pt x="331788" y="58343"/>
                  <a:pt x="352425" y="36118"/>
                </a:cubicBezTo>
                <a:cubicBezTo>
                  <a:pt x="373062" y="13893"/>
                  <a:pt x="404813" y="-27382"/>
                  <a:pt x="428625" y="26593"/>
                </a:cubicBezTo>
                <a:cubicBezTo>
                  <a:pt x="452437" y="80568"/>
                  <a:pt x="473075" y="239318"/>
                  <a:pt x="495300" y="359968"/>
                </a:cubicBezTo>
                <a:cubicBezTo>
                  <a:pt x="517525" y="480618"/>
                  <a:pt x="538162" y="599680"/>
                  <a:pt x="561975" y="750493"/>
                </a:cubicBezTo>
                <a:cubicBezTo>
                  <a:pt x="585788" y="901306"/>
                  <a:pt x="603250" y="1094980"/>
                  <a:pt x="638175" y="1264843"/>
                </a:cubicBezTo>
                <a:cubicBezTo>
                  <a:pt x="673100" y="1434705"/>
                  <a:pt x="723900" y="1636318"/>
                  <a:pt x="771525" y="1769668"/>
                </a:cubicBezTo>
                <a:cubicBezTo>
                  <a:pt x="819150" y="1903018"/>
                  <a:pt x="858838" y="1976043"/>
                  <a:pt x="923925" y="2064943"/>
                </a:cubicBezTo>
                <a:cubicBezTo>
                  <a:pt x="989012" y="2153843"/>
                  <a:pt x="1090613" y="2247506"/>
                  <a:pt x="1162050" y="2303068"/>
                </a:cubicBezTo>
                <a:cubicBezTo>
                  <a:pt x="1233487" y="2358630"/>
                  <a:pt x="1277938" y="2368155"/>
                  <a:pt x="1352550" y="2398318"/>
                </a:cubicBezTo>
                <a:cubicBezTo>
                  <a:pt x="1427163" y="2428480"/>
                  <a:pt x="1514475" y="2461818"/>
                  <a:pt x="1609725" y="2484043"/>
                </a:cubicBezTo>
                <a:cubicBezTo>
                  <a:pt x="1704975" y="2506268"/>
                  <a:pt x="1808163" y="2518968"/>
                  <a:pt x="1924050" y="2531668"/>
                </a:cubicBezTo>
                <a:cubicBezTo>
                  <a:pt x="2039937" y="2544368"/>
                  <a:pt x="2305050" y="2560243"/>
                  <a:pt x="2305050" y="2560243"/>
                </a:cubicBezTo>
                <a:lnTo>
                  <a:pt x="2771775" y="2588818"/>
                </a:lnTo>
                <a:lnTo>
                  <a:pt x="3057525" y="2607868"/>
                </a:lnTo>
                <a:lnTo>
                  <a:pt x="3057525" y="2607868"/>
                </a:lnTo>
              </a:path>
            </a:pathLst>
          </a:custGeom>
          <a:noFill/>
          <a:ln w="50800">
            <a:solidFill>
              <a:srgbClr val="ED7D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74DD16D2-1340-F7B2-3BA1-5FAC1C088960}"/>
              </a:ext>
            </a:extLst>
          </p:cNvPr>
          <p:cNvCxnSpPr>
            <a:cxnSpLocks/>
          </p:cNvCxnSpPr>
          <p:nvPr/>
        </p:nvCxnSpPr>
        <p:spPr>
          <a:xfrm flipH="1">
            <a:off x="35061159" y="7019508"/>
            <a:ext cx="923689" cy="1023471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F808C957-F24A-BAC4-A7C9-37697BF2F5D4}"/>
              </a:ext>
            </a:extLst>
          </p:cNvPr>
          <p:cNvSpPr txBox="1"/>
          <p:nvPr/>
        </p:nvSpPr>
        <p:spPr>
          <a:xfrm>
            <a:off x="35617380" y="5998995"/>
            <a:ext cx="230498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Integrated MG aptamer</a:t>
            </a:r>
            <a:endParaRPr lang="en-US" b="1" dirty="0"/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18721F7F-8FF7-2E66-3D55-2EC7F7AA5E35}"/>
              </a:ext>
            </a:extLst>
          </p:cNvPr>
          <p:cNvCxnSpPr>
            <a:cxnSpLocks/>
            <a:stCxn id="120" idx="0"/>
          </p:cNvCxnSpPr>
          <p:nvPr/>
        </p:nvCxnSpPr>
        <p:spPr>
          <a:xfrm flipV="1">
            <a:off x="37110103" y="9881417"/>
            <a:ext cx="278571" cy="70143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762778E6-815C-E5FB-83E5-31A24571DB72}"/>
              </a:ext>
            </a:extLst>
          </p:cNvPr>
          <p:cNvSpPr txBox="1"/>
          <p:nvPr/>
        </p:nvSpPr>
        <p:spPr>
          <a:xfrm>
            <a:off x="36094196" y="10582854"/>
            <a:ext cx="20318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aximum deGFP</a:t>
            </a:r>
            <a:endParaRPr lang="en-US" b="1" dirty="0"/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id="{F9759AD5-D403-B875-9404-0D3FC58254B6}"/>
              </a:ext>
            </a:extLst>
          </p:cNvPr>
          <p:cNvSpPr/>
          <p:nvPr/>
        </p:nvSpPr>
        <p:spPr>
          <a:xfrm>
            <a:off x="37337679" y="9353608"/>
            <a:ext cx="365760" cy="365760"/>
          </a:xfrm>
          <a:prstGeom prst="ellipse">
            <a:avLst/>
          </a:prstGeom>
          <a:noFill/>
          <a:ln w="762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932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AF944E2E-3318-032B-4115-729BED29A8FB}"/>
              </a:ext>
            </a:extLst>
          </p:cNvPr>
          <p:cNvCxnSpPr>
            <a:cxnSpLocks/>
          </p:cNvCxnSpPr>
          <p:nvPr/>
        </p:nvCxnSpPr>
        <p:spPr>
          <a:xfrm>
            <a:off x="36165586" y="8238466"/>
            <a:ext cx="228809" cy="17841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C03664C-4DE0-B219-20B8-3A6BC3F07703}"/>
              </a:ext>
            </a:extLst>
          </p:cNvPr>
          <p:cNvCxnSpPr>
            <a:cxnSpLocks/>
          </p:cNvCxnSpPr>
          <p:nvPr/>
        </p:nvCxnSpPr>
        <p:spPr>
          <a:xfrm>
            <a:off x="36572378" y="8276022"/>
            <a:ext cx="181741" cy="152504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632A23E3-45B7-3C20-8EAA-B9C1E55DF943}"/>
              </a:ext>
            </a:extLst>
          </p:cNvPr>
          <p:cNvCxnSpPr>
            <a:cxnSpLocks/>
          </p:cNvCxnSpPr>
          <p:nvPr/>
        </p:nvCxnSpPr>
        <p:spPr>
          <a:xfrm>
            <a:off x="36906460" y="8303176"/>
            <a:ext cx="98328" cy="11370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B5F9F7D-0AE1-0155-E0EF-9CE6670106CE}"/>
              </a:ext>
            </a:extLst>
          </p:cNvPr>
          <p:cNvCxnSpPr>
            <a:cxnSpLocks/>
          </p:cNvCxnSpPr>
          <p:nvPr/>
        </p:nvCxnSpPr>
        <p:spPr>
          <a:xfrm>
            <a:off x="34646857" y="6629541"/>
            <a:ext cx="425332" cy="35822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ECC0D8C1-8CD1-5857-CC1B-6C366B103F4E}"/>
              </a:ext>
            </a:extLst>
          </p:cNvPr>
          <p:cNvCxnSpPr>
            <a:cxnSpLocks/>
          </p:cNvCxnSpPr>
          <p:nvPr/>
        </p:nvCxnSpPr>
        <p:spPr>
          <a:xfrm>
            <a:off x="34678726" y="6369404"/>
            <a:ext cx="349219" cy="290398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45C6EBFE-CADA-8254-B64A-4EA3653BFDDC}"/>
              </a:ext>
            </a:extLst>
          </p:cNvPr>
          <p:cNvCxnSpPr>
            <a:cxnSpLocks/>
          </p:cNvCxnSpPr>
          <p:nvPr/>
        </p:nvCxnSpPr>
        <p:spPr>
          <a:xfrm>
            <a:off x="34710594" y="6076030"/>
            <a:ext cx="272237" cy="24433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72B955AA-F487-2697-DB58-E5FC44764323}"/>
              </a:ext>
            </a:extLst>
          </p:cNvPr>
          <p:cNvCxnSpPr>
            <a:cxnSpLocks/>
          </p:cNvCxnSpPr>
          <p:nvPr/>
        </p:nvCxnSpPr>
        <p:spPr>
          <a:xfrm>
            <a:off x="34614989" y="6869541"/>
            <a:ext cx="533580" cy="479879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C4ECF48-E115-1A9C-5E69-695F21EA54B7}"/>
              </a:ext>
            </a:extLst>
          </p:cNvPr>
          <p:cNvCxnSpPr>
            <a:cxnSpLocks/>
          </p:cNvCxnSpPr>
          <p:nvPr/>
        </p:nvCxnSpPr>
        <p:spPr>
          <a:xfrm>
            <a:off x="34592348" y="7116436"/>
            <a:ext cx="1449242" cy="131209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E29D6AB-5DD9-820E-61D1-A25EC04BE9B3}"/>
              </a:ext>
            </a:extLst>
          </p:cNvPr>
          <p:cNvCxnSpPr>
            <a:cxnSpLocks/>
          </p:cNvCxnSpPr>
          <p:nvPr/>
        </p:nvCxnSpPr>
        <p:spPr>
          <a:xfrm>
            <a:off x="34432555" y="8221333"/>
            <a:ext cx="260815" cy="197094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65D7ABA-E17F-CC70-9DA1-33C41540235C}"/>
              </a:ext>
            </a:extLst>
          </p:cNvPr>
          <p:cNvCxnSpPr>
            <a:cxnSpLocks/>
          </p:cNvCxnSpPr>
          <p:nvPr/>
        </p:nvCxnSpPr>
        <p:spPr>
          <a:xfrm>
            <a:off x="34495524" y="7914311"/>
            <a:ext cx="532420" cy="49233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6CC67D9-0C08-CC17-0018-48D7D8456364}"/>
              </a:ext>
            </a:extLst>
          </p:cNvPr>
          <p:cNvCxnSpPr>
            <a:cxnSpLocks/>
          </p:cNvCxnSpPr>
          <p:nvPr/>
        </p:nvCxnSpPr>
        <p:spPr>
          <a:xfrm>
            <a:off x="34562961" y="7410670"/>
            <a:ext cx="1171216" cy="1006211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2370D87-9432-1DEA-9716-237A80D2D19D}"/>
              </a:ext>
            </a:extLst>
          </p:cNvPr>
          <p:cNvCxnSpPr>
            <a:cxnSpLocks/>
            <a:stCxn id="26" idx="1"/>
          </p:cNvCxnSpPr>
          <p:nvPr/>
        </p:nvCxnSpPr>
        <p:spPr>
          <a:xfrm>
            <a:off x="34519739" y="7664042"/>
            <a:ext cx="872104" cy="764485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16" name="Ink 15">
                <a:extLst>
                  <a:ext uri="{FF2B5EF4-FFF2-40B4-BE49-F238E27FC236}">
                    <a16:creationId xmlns:a16="http://schemas.microsoft.com/office/drawing/2014/main" id="{893EF042-4EED-5309-B0B5-6605479A7C8F}"/>
                  </a:ext>
                </a:extLst>
              </p14:cNvPr>
              <p14:cNvContentPartPr/>
              <p14:nvPr/>
            </p14:nvContentPartPr>
            <p14:xfrm>
              <a:off x="34409797" y="9540731"/>
              <a:ext cx="3106518" cy="3038352"/>
            </p14:xfrm>
          </p:contentPart>
        </mc:Choice>
        <mc:Fallback xmlns="">
          <p:pic>
            <p:nvPicPr>
              <p:cNvPr id="16" name="Ink 15">
                <a:extLst>
                  <a:ext uri="{FF2B5EF4-FFF2-40B4-BE49-F238E27FC236}">
                    <a16:creationId xmlns:a16="http://schemas.microsoft.com/office/drawing/2014/main" id="{893EF042-4EED-5309-B0B5-6605479A7C8F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384239" y="9515171"/>
                <a:ext cx="3156913" cy="3088751"/>
              </a:xfrm>
              <a:prstGeom prst="rect">
                <a:avLst/>
              </a:prstGeom>
            </p:spPr>
          </p:pic>
        </mc:Fallback>
      </mc:AlternateContent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9C9F237-7229-B3B7-0C74-53DE0B4F4477}"/>
              </a:ext>
            </a:extLst>
          </p:cNvPr>
          <p:cNvCxnSpPr/>
          <p:nvPr/>
        </p:nvCxnSpPr>
        <p:spPr>
          <a:xfrm flipV="1">
            <a:off x="34409798" y="9378683"/>
            <a:ext cx="0" cy="32004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5447B92-BCF5-0746-C053-DB6A88000E74}"/>
              </a:ext>
            </a:extLst>
          </p:cNvPr>
          <p:cNvCxnSpPr>
            <a:cxnSpLocks/>
          </p:cNvCxnSpPr>
          <p:nvPr/>
        </p:nvCxnSpPr>
        <p:spPr>
          <a:xfrm>
            <a:off x="34409798" y="12579083"/>
            <a:ext cx="32004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E96C24C-EE34-EF6C-0B1D-BD5E94B97108}"/>
              </a:ext>
            </a:extLst>
          </p:cNvPr>
          <p:cNvSpPr txBox="1"/>
          <p:nvPr/>
        </p:nvSpPr>
        <p:spPr>
          <a:xfrm>
            <a:off x="36150918" y="12582177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5A8AA1-6D4F-07DA-1FB8-8D3F50D3279D}"/>
              </a:ext>
            </a:extLst>
          </p:cNvPr>
          <p:cNvSpPr txBox="1"/>
          <p:nvPr/>
        </p:nvSpPr>
        <p:spPr>
          <a:xfrm>
            <a:off x="32796854" y="9248633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deGFP</a:t>
            </a:r>
            <a:endParaRPr lang="en-US" b="1" dirty="0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B778688-C8ED-783C-959B-BDBC1BA22A18}"/>
              </a:ext>
            </a:extLst>
          </p:cNvPr>
          <p:cNvCxnSpPr/>
          <p:nvPr/>
        </p:nvCxnSpPr>
        <p:spPr>
          <a:xfrm flipV="1">
            <a:off x="34409798" y="5219573"/>
            <a:ext cx="0" cy="32004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ECACB77C-77D7-9480-644E-A268A0CBB6C3}"/>
              </a:ext>
            </a:extLst>
          </p:cNvPr>
          <p:cNvCxnSpPr>
            <a:cxnSpLocks/>
          </p:cNvCxnSpPr>
          <p:nvPr/>
        </p:nvCxnSpPr>
        <p:spPr>
          <a:xfrm>
            <a:off x="34409798" y="8419973"/>
            <a:ext cx="3200400" cy="0"/>
          </a:xfrm>
          <a:prstGeom prst="straightConnector1">
            <a:avLst/>
          </a:prstGeom>
          <a:ln w="381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9F4BCEB3-88EE-B0DD-26E4-BACF3E55067C}"/>
              </a:ext>
            </a:extLst>
          </p:cNvPr>
          <p:cNvSpPr txBox="1"/>
          <p:nvPr/>
        </p:nvSpPr>
        <p:spPr>
          <a:xfrm>
            <a:off x="36150918" y="8423067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7E3675B-1D4E-849E-ACCB-09F60110A1A2}"/>
              </a:ext>
            </a:extLst>
          </p:cNvPr>
          <p:cNvSpPr txBox="1"/>
          <p:nvPr/>
        </p:nvSpPr>
        <p:spPr>
          <a:xfrm>
            <a:off x="32796854" y="5089523"/>
            <a:ext cx="20318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Gapt</a:t>
            </a:r>
            <a:endParaRPr lang="en-US" b="1" dirty="0"/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822ADD11-6D95-0DDB-0732-F61EBB96FB28}"/>
              </a:ext>
            </a:extLst>
          </p:cNvPr>
          <p:cNvSpPr/>
          <p:nvPr/>
        </p:nvSpPr>
        <p:spPr>
          <a:xfrm>
            <a:off x="33047523" y="4699001"/>
            <a:ext cx="4952330" cy="8615719"/>
          </a:xfrm>
          <a:prstGeom prst="roundRect">
            <a:avLst>
              <a:gd name="adj" fmla="val 11426"/>
            </a:avLst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Freeform: Shape 25">
            <a:extLst>
              <a:ext uri="{FF2B5EF4-FFF2-40B4-BE49-F238E27FC236}">
                <a16:creationId xmlns:a16="http://schemas.microsoft.com/office/drawing/2014/main" id="{D5DC4853-EBD5-4FF3-4066-8E768E8C86DE}"/>
              </a:ext>
            </a:extLst>
          </p:cNvPr>
          <p:cNvSpPr/>
          <p:nvPr/>
        </p:nvSpPr>
        <p:spPr>
          <a:xfrm>
            <a:off x="34434015" y="5732448"/>
            <a:ext cx="3057525" cy="2665018"/>
          </a:xfrm>
          <a:custGeom>
            <a:avLst/>
            <a:gdLst>
              <a:gd name="connsiteX0" fmla="*/ 0 w 3057525"/>
              <a:gd name="connsiteY0" fmla="*/ 2665018 h 2665018"/>
              <a:gd name="connsiteX1" fmla="*/ 85725 w 3057525"/>
              <a:gd name="connsiteY1" fmla="*/ 1931593 h 2665018"/>
              <a:gd name="connsiteX2" fmla="*/ 209550 w 3057525"/>
              <a:gd name="connsiteY2" fmla="*/ 883843 h 2665018"/>
              <a:gd name="connsiteX3" fmla="*/ 304800 w 3057525"/>
              <a:gd name="connsiteY3" fmla="*/ 159943 h 2665018"/>
              <a:gd name="connsiteX4" fmla="*/ 352425 w 3057525"/>
              <a:gd name="connsiteY4" fmla="*/ 36118 h 2665018"/>
              <a:gd name="connsiteX5" fmla="*/ 428625 w 3057525"/>
              <a:gd name="connsiteY5" fmla="*/ 26593 h 2665018"/>
              <a:gd name="connsiteX6" fmla="*/ 495300 w 3057525"/>
              <a:gd name="connsiteY6" fmla="*/ 359968 h 2665018"/>
              <a:gd name="connsiteX7" fmla="*/ 561975 w 3057525"/>
              <a:gd name="connsiteY7" fmla="*/ 750493 h 2665018"/>
              <a:gd name="connsiteX8" fmla="*/ 638175 w 3057525"/>
              <a:gd name="connsiteY8" fmla="*/ 1264843 h 2665018"/>
              <a:gd name="connsiteX9" fmla="*/ 771525 w 3057525"/>
              <a:gd name="connsiteY9" fmla="*/ 1769668 h 2665018"/>
              <a:gd name="connsiteX10" fmla="*/ 923925 w 3057525"/>
              <a:gd name="connsiteY10" fmla="*/ 2064943 h 2665018"/>
              <a:gd name="connsiteX11" fmla="*/ 1162050 w 3057525"/>
              <a:gd name="connsiteY11" fmla="*/ 2303068 h 2665018"/>
              <a:gd name="connsiteX12" fmla="*/ 1352550 w 3057525"/>
              <a:gd name="connsiteY12" fmla="*/ 2398318 h 2665018"/>
              <a:gd name="connsiteX13" fmla="*/ 1609725 w 3057525"/>
              <a:gd name="connsiteY13" fmla="*/ 2484043 h 2665018"/>
              <a:gd name="connsiteX14" fmla="*/ 1924050 w 3057525"/>
              <a:gd name="connsiteY14" fmla="*/ 2531668 h 2665018"/>
              <a:gd name="connsiteX15" fmla="*/ 2305050 w 3057525"/>
              <a:gd name="connsiteY15" fmla="*/ 2560243 h 2665018"/>
              <a:gd name="connsiteX16" fmla="*/ 2771775 w 3057525"/>
              <a:gd name="connsiteY16" fmla="*/ 2588818 h 2665018"/>
              <a:gd name="connsiteX17" fmla="*/ 3057525 w 3057525"/>
              <a:gd name="connsiteY17" fmla="*/ 2607868 h 2665018"/>
              <a:gd name="connsiteX18" fmla="*/ 3057525 w 3057525"/>
              <a:gd name="connsiteY18" fmla="*/ 2607868 h 26650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3057525" h="2665018">
                <a:moveTo>
                  <a:pt x="0" y="2665018"/>
                </a:moveTo>
                <a:cubicBezTo>
                  <a:pt x="25400" y="2446737"/>
                  <a:pt x="50800" y="2228456"/>
                  <a:pt x="85725" y="1931593"/>
                </a:cubicBezTo>
                <a:cubicBezTo>
                  <a:pt x="120650" y="1634730"/>
                  <a:pt x="173038" y="1179118"/>
                  <a:pt x="209550" y="883843"/>
                </a:cubicBezTo>
                <a:cubicBezTo>
                  <a:pt x="246062" y="588568"/>
                  <a:pt x="280988" y="301230"/>
                  <a:pt x="304800" y="159943"/>
                </a:cubicBezTo>
                <a:cubicBezTo>
                  <a:pt x="328612" y="18656"/>
                  <a:pt x="331788" y="58343"/>
                  <a:pt x="352425" y="36118"/>
                </a:cubicBezTo>
                <a:cubicBezTo>
                  <a:pt x="373062" y="13893"/>
                  <a:pt x="404813" y="-27382"/>
                  <a:pt x="428625" y="26593"/>
                </a:cubicBezTo>
                <a:cubicBezTo>
                  <a:pt x="452437" y="80568"/>
                  <a:pt x="473075" y="239318"/>
                  <a:pt x="495300" y="359968"/>
                </a:cubicBezTo>
                <a:cubicBezTo>
                  <a:pt x="517525" y="480618"/>
                  <a:pt x="538162" y="599680"/>
                  <a:pt x="561975" y="750493"/>
                </a:cubicBezTo>
                <a:cubicBezTo>
                  <a:pt x="585788" y="901306"/>
                  <a:pt x="603250" y="1094980"/>
                  <a:pt x="638175" y="1264843"/>
                </a:cubicBezTo>
                <a:cubicBezTo>
                  <a:pt x="673100" y="1434705"/>
                  <a:pt x="723900" y="1636318"/>
                  <a:pt x="771525" y="1769668"/>
                </a:cubicBezTo>
                <a:cubicBezTo>
                  <a:pt x="819150" y="1903018"/>
                  <a:pt x="858838" y="1976043"/>
                  <a:pt x="923925" y="2064943"/>
                </a:cubicBezTo>
                <a:cubicBezTo>
                  <a:pt x="989012" y="2153843"/>
                  <a:pt x="1090613" y="2247506"/>
                  <a:pt x="1162050" y="2303068"/>
                </a:cubicBezTo>
                <a:cubicBezTo>
                  <a:pt x="1233487" y="2358630"/>
                  <a:pt x="1277938" y="2368155"/>
                  <a:pt x="1352550" y="2398318"/>
                </a:cubicBezTo>
                <a:cubicBezTo>
                  <a:pt x="1427163" y="2428480"/>
                  <a:pt x="1514475" y="2461818"/>
                  <a:pt x="1609725" y="2484043"/>
                </a:cubicBezTo>
                <a:cubicBezTo>
                  <a:pt x="1704975" y="2506268"/>
                  <a:pt x="1808163" y="2518968"/>
                  <a:pt x="1924050" y="2531668"/>
                </a:cubicBezTo>
                <a:cubicBezTo>
                  <a:pt x="2039937" y="2544368"/>
                  <a:pt x="2305050" y="2560243"/>
                  <a:pt x="2305050" y="2560243"/>
                </a:cubicBezTo>
                <a:lnTo>
                  <a:pt x="2771775" y="2588818"/>
                </a:lnTo>
                <a:lnTo>
                  <a:pt x="3057525" y="2607868"/>
                </a:lnTo>
                <a:lnTo>
                  <a:pt x="3057525" y="2607868"/>
                </a:lnTo>
              </a:path>
            </a:pathLst>
          </a:custGeom>
          <a:noFill/>
          <a:ln w="50800">
            <a:solidFill>
              <a:srgbClr val="ED7D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5AE57D0-CA06-7EC1-3EC8-E765A21C035B}"/>
              </a:ext>
            </a:extLst>
          </p:cNvPr>
          <p:cNvCxnSpPr>
            <a:cxnSpLocks/>
          </p:cNvCxnSpPr>
          <p:nvPr/>
        </p:nvCxnSpPr>
        <p:spPr>
          <a:xfrm flipH="1">
            <a:off x="35061159" y="7019508"/>
            <a:ext cx="923689" cy="1023471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CB292F8C-70D7-A392-3DC3-C3849715391B}"/>
              </a:ext>
            </a:extLst>
          </p:cNvPr>
          <p:cNvSpPr txBox="1"/>
          <p:nvPr/>
        </p:nvSpPr>
        <p:spPr>
          <a:xfrm>
            <a:off x="35617380" y="5998995"/>
            <a:ext cx="230498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Integrated MG aptamer</a:t>
            </a:r>
            <a:endParaRPr lang="en-US" b="1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2C8E729-0AE9-EDF1-6A6E-2B046E1357B7}"/>
              </a:ext>
            </a:extLst>
          </p:cNvPr>
          <p:cNvCxnSpPr>
            <a:cxnSpLocks/>
            <a:stCxn id="30" idx="0"/>
          </p:cNvCxnSpPr>
          <p:nvPr/>
        </p:nvCxnSpPr>
        <p:spPr>
          <a:xfrm flipV="1">
            <a:off x="37110103" y="9881417"/>
            <a:ext cx="278571" cy="70143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B42B816B-4B11-C27D-AE46-03CA64B189D2}"/>
              </a:ext>
            </a:extLst>
          </p:cNvPr>
          <p:cNvSpPr txBox="1"/>
          <p:nvPr/>
        </p:nvSpPr>
        <p:spPr>
          <a:xfrm>
            <a:off x="36094196" y="10582854"/>
            <a:ext cx="20318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aximum deGFP</a:t>
            </a:r>
            <a:endParaRPr lang="en-US" b="1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83C96E97-18AB-030C-66B8-D0A1063CC1DD}"/>
              </a:ext>
            </a:extLst>
          </p:cNvPr>
          <p:cNvSpPr/>
          <p:nvPr/>
        </p:nvSpPr>
        <p:spPr>
          <a:xfrm>
            <a:off x="37337679" y="9353608"/>
            <a:ext cx="365760" cy="365760"/>
          </a:xfrm>
          <a:prstGeom prst="ellipse">
            <a:avLst/>
          </a:prstGeom>
          <a:noFill/>
          <a:ln w="762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493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ED9D7A-DD2D-20FA-1BF7-4848FCB891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98">
            <a:extLst>
              <a:ext uri="{FF2B5EF4-FFF2-40B4-BE49-F238E27FC236}">
                <a16:creationId xmlns:a16="http://schemas.microsoft.com/office/drawing/2014/main" id="{8410AF6F-6515-A686-C51F-F1D968C6C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28869" y="1894258"/>
            <a:ext cx="11841612" cy="1900820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BD3F94F5-5859-4271-FEB0-733B59CE13C7}"/>
              </a:ext>
            </a:extLst>
          </p:cNvPr>
          <p:cNvSpPr txBox="1"/>
          <p:nvPr/>
        </p:nvSpPr>
        <p:spPr>
          <a:xfrm>
            <a:off x="1975449" y="7960968"/>
            <a:ext cx="2514600" cy="2514600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87E5C3D-1F27-EC93-F4E3-8BD830EFA463}"/>
              </a:ext>
            </a:extLst>
          </p:cNvPr>
          <p:cNvSpPr txBox="1"/>
          <p:nvPr/>
        </p:nvSpPr>
        <p:spPr>
          <a:xfrm>
            <a:off x="1785918" y="8494993"/>
            <a:ext cx="290105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solidFill>
                  <a:schemeClr val="bg1"/>
                </a:solidFill>
              </a:rPr>
              <a:t>Mg</a:t>
            </a:r>
            <a:r>
              <a:rPr lang="en-US" sz="8800" baseline="30000" dirty="0">
                <a:solidFill>
                  <a:schemeClr val="bg1"/>
                </a:solidFill>
              </a:rPr>
              <a:t>2+</a:t>
            </a:r>
            <a:endParaRPr lang="en-US" sz="8800" dirty="0">
              <a:solidFill>
                <a:schemeClr val="bg1"/>
              </a:solidFill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BE285CC-CE02-FF94-2501-424C23D3C66B}"/>
              </a:ext>
            </a:extLst>
          </p:cNvPr>
          <p:cNvGrpSpPr/>
          <p:nvPr/>
        </p:nvGrpSpPr>
        <p:grpSpPr>
          <a:xfrm>
            <a:off x="13464471" y="13125445"/>
            <a:ext cx="7599228" cy="8737517"/>
            <a:chOff x="-1120990" y="8729375"/>
            <a:chExt cx="9217654" cy="10748245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2844F66-D313-18E1-4B7D-CADCC5D83707}"/>
                </a:ext>
              </a:extLst>
            </p:cNvPr>
            <p:cNvGrpSpPr/>
            <p:nvPr/>
          </p:nvGrpSpPr>
          <p:grpSpPr>
            <a:xfrm>
              <a:off x="1757272" y="8729375"/>
              <a:ext cx="3036903" cy="7634415"/>
              <a:chOff x="9341364" y="2891367"/>
              <a:chExt cx="3036903" cy="7634415"/>
            </a:xfrm>
          </p:grpSpPr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AF8FDBA1-3BD1-43A3-E98A-F7AB537BDD96}"/>
                  </a:ext>
                </a:extLst>
              </p:cNvPr>
              <p:cNvSpPr/>
              <p:nvPr/>
            </p:nvSpPr>
            <p:spPr>
              <a:xfrm>
                <a:off x="10876112" y="9655176"/>
                <a:ext cx="373655" cy="764859"/>
              </a:xfrm>
              <a:prstGeom prst="ellipse">
                <a:avLst/>
              </a:prstGeom>
              <a:solidFill>
                <a:srgbClr val="F9EFD0"/>
              </a:solidFill>
              <a:ln w="57150">
                <a:solidFill>
                  <a:srgbClr val="F9EFD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1D288E5-09F3-26BD-36A6-2210902535DB}"/>
                  </a:ext>
                </a:extLst>
              </p:cNvPr>
              <p:cNvGrpSpPr/>
              <p:nvPr/>
            </p:nvGrpSpPr>
            <p:grpSpPr>
              <a:xfrm>
                <a:off x="9341364" y="2891367"/>
                <a:ext cx="3036903" cy="7634415"/>
                <a:chOff x="10204964" y="2637367"/>
                <a:chExt cx="3036903" cy="7634415"/>
              </a:xfrm>
            </p:grpSpPr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63AE1F7D-53E2-A934-1B83-487A9CA2C0BE}"/>
                    </a:ext>
                  </a:extLst>
                </p:cNvPr>
                <p:cNvSpPr/>
                <p:nvPr/>
              </p:nvSpPr>
              <p:spPr>
                <a:xfrm>
                  <a:off x="11612886" y="9401176"/>
                  <a:ext cx="634677" cy="870606"/>
                </a:xfrm>
                <a:prstGeom prst="ellipse">
                  <a:avLst/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26A7B278-0233-0AAF-DBF3-C8B9D4037018}"/>
                    </a:ext>
                  </a:extLst>
                </p:cNvPr>
                <p:cNvSpPr/>
                <p:nvPr/>
              </p:nvSpPr>
              <p:spPr>
                <a:xfrm>
                  <a:off x="10898271" y="4668519"/>
                  <a:ext cx="2050649" cy="235163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7" name="Block Arc 36">
                  <a:extLst>
                    <a:ext uri="{FF2B5EF4-FFF2-40B4-BE49-F238E27FC236}">
                      <a16:creationId xmlns:a16="http://schemas.microsoft.com/office/drawing/2014/main" id="{C8C60393-082F-1E59-C137-F5820F8BA823}"/>
                    </a:ext>
                  </a:extLst>
                </p:cNvPr>
                <p:cNvSpPr/>
                <p:nvPr/>
              </p:nvSpPr>
              <p:spPr>
                <a:xfrm rot="14698403">
                  <a:off x="10270097" y="2676360"/>
                  <a:ext cx="427356" cy="514795"/>
                </a:xfrm>
                <a:prstGeom prst="blockArc">
                  <a:avLst>
                    <a:gd name="adj1" fmla="val 13560443"/>
                    <a:gd name="adj2" fmla="val 2935971"/>
                    <a:gd name="adj3" fmla="val 24413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7BEE5F32-A63B-51BB-FCB5-387034AB8875}"/>
                    </a:ext>
                  </a:extLst>
                </p:cNvPr>
                <p:cNvSpPr/>
                <p:nvPr/>
              </p:nvSpPr>
              <p:spPr>
                <a:xfrm>
                  <a:off x="10445751" y="3054350"/>
                  <a:ext cx="464594" cy="10027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" name="Block Arc 38">
                  <a:extLst>
                    <a:ext uri="{FF2B5EF4-FFF2-40B4-BE49-F238E27FC236}">
                      <a16:creationId xmlns:a16="http://schemas.microsoft.com/office/drawing/2014/main" id="{24D8F084-0E01-7C1E-3DC7-570D1861E27B}"/>
                    </a:ext>
                  </a:extLst>
                </p:cNvPr>
                <p:cNvSpPr/>
                <p:nvPr/>
              </p:nvSpPr>
              <p:spPr>
                <a:xfrm rot="11312380">
                  <a:off x="10247864" y="2641239"/>
                  <a:ext cx="427356" cy="514795"/>
                </a:xfrm>
                <a:prstGeom prst="blockArc">
                  <a:avLst>
                    <a:gd name="adj1" fmla="val 15619198"/>
                    <a:gd name="adj2" fmla="val 16406583"/>
                    <a:gd name="adj3" fmla="val 22545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0" name="Block Arc 39">
                  <a:extLst>
                    <a:ext uri="{FF2B5EF4-FFF2-40B4-BE49-F238E27FC236}">
                      <a16:creationId xmlns:a16="http://schemas.microsoft.com/office/drawing/2014/main" id="{85ED6C6B-7AF0-5121-497B-0DFBAD7DA86F}"/>
                    </a:ext>
                  </a:extLst>
                </p:cNvPr>
                <p:cNvSpPr/>
                <p:nvPr/>
              </p:nvSpPr>
              <p:spPr>
                <a:xfrm rot="11312380">
                  <a:off x="10204964" y="2933117"/>
                  <a:ext cx="427356" cy="192024"/>
                </a:xfrm>
                <a:prstGeom prst="blockArc">
                  <a:avLst>
                    <a:gd name="adj1" fmla="val 15879138"/>
                    <a:gd name="adj2" fmla="val 17412361"/>
                    <a:gd name="adj3" fmla="val 26734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Block Arc 40">
                  <a:extLst>
                    <a:ext uri="{FF2B5EF4-FFF2-40B4-BE49-F238E27FC236}">
                      <a16:creationId xmlns:a16="http://schemas.microsoft.com/office/drawing/2014/main" id="{F2D33CF2-527F-0ACC-1798-1B95925415E1}"/>
                    </a:ext>
                  </a:extLst>
                </p:cNvPr>
                <p:cNvSpPr/>
                <p:nvPr/>
              </p:nvSpPr>
              <p:spPr>
                <a:xfrm rot="11312380">
                  <a:off x="10214444" y="2933116"/>
                  <a:ext cx="427356" cy="192024"/>
                </a:xfrm>
                <a:prstGeom prst="blockArc">
                  <a:avLst>
                    <a:gd name="adj1" fmla="val 13519529"/>
                    <a:gd name="adj2" fmla="val 16615939"/>
                    <a:gd name="adj3" fmla="val 25588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Block Arc 41">
                  <a:extLst>
                    <a:ext uri="{FF2B5EF4-FFF2-40B4-BE49-F238E27FC236}">
                      <a16:creationId xmlns:a16="http://schemas.microsoft.com/office/drawing/2014/main" id="{ED167386-25F3-BAD5-EB91-16553110729D}"/>
                    </a:ext>
                  </a:extLst>
                </p:cNvPr>
                <p:cNvSpPr/>
                <p:nvPr/>
              </p:nvSpPr>
              <p:spPr>
                <a:xfrm rot="11032256">
                  <a:off x="10238792" y="2931528"/>
                  <a:ext cx="427356" cy="192024"/>
                </a:xfrm>
                <a:prstGeom prst="blockArc">
                  <a:avLst>
                    <a:gd name="adj1" fmla="val 13519529"/>
                    <a:gd name="adj2" fmla="val 15470025"/>
                    <a:gd name="adj3" fmla="val 23131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" name="Rectangle: Rounded Corners 42">
                  <a:extLst>
                    <a:ext uri="{FF2B5EF4-FFF2-40B4-BE49-F238E27FC236}">
                      <a16:creationId xmlns:a16="http://schemas.microsoft.com/office/drawing/2014/main" id="{AEF1B87C-61D5-DFA7-F7E9-FE3B85E57CFF}"/>
                    </a:ext>
                  </a:extLst>
                </p:cNvPr>
                <p:cNvSpPr/>
                <p:nvPr/>
              </p:nvSpPr>
              <p:spPr>
                <a:xfrm>
                  <a:off x="10795109" y="2870200"/>
                  <a:ext cx="2235084" cy="358703"/>
                </a:xfrm>
                <a:prstGeom prst="roundRect">
                  <a:avLst>
                    <a:gd name="adj" fmla="val 30607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Rectangle: Rounded Corners 43">
                  <a:extLst>
                    <a:ext uri="{FF2B5EF4-FFF2-40B4-BE49-F238E27FC236}">
                      <a16:creationId xmlns:a16="http://schemas.microsoft.com/office/drawing/2014/main" id="{30710238-A871-4C93-EF70-A43D68EB1D6A}"/>
                    </a:ext>
                  </a:extLst>
                </p:cNvPr>
                <p:cNvSpPr/>
                <p:nvPr/>
              </p:nvSpPr>
              <p:spPr>
                <a:xfrm>
                  <a:off x="10565822" y="2637367"/>
                  <a:ext cx="2676045" cy="326453"/>
                </a:xfrm>
                <a:prstGeom prst="roundRect">
                  <a:avLst>
                    <a:gd name="adj" fmla="val 41305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rapezoid 44">
                  <a:extLst>
                    <a:ext uri="{FF2B5EF4-FFF2-40B4-BE49-F238E27FC236}">
                      <a16:creationId xmlns:a16="http://schemas.microsoft.com/office/drawing/2014/main" id="{8AF4A04C-323D-95A2-BE0A-B81E298237A7}"/>
                    </a:ext>
                  </a:extLst>
                </p:cNvPr>
                <p:cNvSpPr/>
                <p:nvPr/>
              </p:nvSpPr>
              <p:spPr>
                <a:xfrm rot="10800000">
                  <a:off x="10894226" y="7020147"/>
                  <a:ext cx="2071313" cy="2957101"/>
                </a:xfrm>
                <a:prstGeom prst="trapezoid">
                  <a:avLst>
                    <a:gd name="adj" fmla="val 36875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D16153B9-ACBB-1732-6136-58BAF69AA0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20487" y="7029540"/>
                  <a:ext cx="728432" cy="298318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85BBF9D1-3327-D7DB-6DA1-6D20318371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7020153"/>
                  <a:ext cx="744971" cy="2996972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46022B2E-2F0E-86E6-F001-BC67CBFF63B5}"/>
                    </a:ext>
                  </a:extLst>
                </p:cNvPr>
                <p:cNvSpPr/>
                <p:nvPr/>
              </p:nvSpPr>
              <p:spPr>
                <a:xfrm>
                  <a:off x="10898271" y="3262086"/>
                  <a:ext cx="2050649" cy="1538229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E001463E-606B-9567-3D18-97B30E1E4F47}"/>
                    </a:ext>
                  </a:extLst>
                </p:cNvPr>
                <p:cNvSpPr/>
                <p:nvPr/>
              </p:nvSpPr>
              <p:spPr>
                <a:xfrm>
                  <a:off x="11012077" y="4677907"/>
                  <a:ext cx="1827973" cy="2351633"/>
                </a:xfrm>
                <a:prstGeom prst="rect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AEB7CA1A-0A36-DD0C-1CE4-C211E1823C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530352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F28DA8B5-3B91-315B-4BFF-BAC5A28A79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75046" y="685800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2" name="Oval 51">
                  <a:extLst>
                    <a:ext uri="{FF2B5EF4-FFF2-40B4-BE49-F238E27FC236}">
                      <a16:creationId xmlns:a16="http://schemas.microsoft.com/office/drawing/2014/main" id="{77668779-8C5B-BBFE-3C39-BABAB49410D4}"/>
                    </a:ext>
                  </a:extLst>
                </p:cNvPr>
                <p:cNvSpPr/>
                <p:nvPr/>
              </p:nvSpPr>
              <p:spPr>
                <a:xfrm>
                  <a:off x="11739712" y="9419272"/>
                  <a:ext cx="373655" cy="764859"/>
                </a:xfrm>
                <a:prstGeom prst="ellipse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9AB2DA49-9AF6-2E45-4FA3-7A6FBA43E7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374396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8B2D432C-DFB8-4629-093A-265998929F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48920" y="3236263"/>
                  <a:ext cx="0" cy="3808748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F2755E92-EAB4-B6AF-BA57-23A4A99728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3236263"/>
                  <a:ext cx="0" cy="3801125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6" name="Trapezoid 55">
                  <a:extLst>
                    <a:ext uri="{FF2B5EF4-FFF2-40B4-BE49-F238E27FC236}">
                      <a16:creationId xmlns:a16="http://schemas.microsoft.com/office/drawing/2014/main" id="{AB9155AD-F588-8E42-FC9D-D92AC662BA87}"/>
                    </a:ext>
                  </a:extLst>
                </p:cNvPr>
                <p:cNvSpPr/>
                <p:nvPr/>
              </p:nvSpPr>
              <p:spPr>
                <a:xfrm rot="10800000">
                  <a:off x="11020539" y="7078403"/>
                  <a:ext cx="1810512" cy="2957103"/>
                </a:xfrm>
                <a:prstGeom prst="trapezoid">
                  <a:avLst>
                    <a:gd name="adj" fmla="val 41887"/>
                  </a:avLst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Trapezoid 56">
                  <a:extLst>
                    <a:ext uri="{FF2B5EF4-FFF2-40B4-BE49-F238E27FC236}">
                      <a16:creationId xmlns:a16="http://schemas.microsoft.com/office/drawing/2014/main" id="{5F623A1A-B6DF-D77A-913F-22143E32DDFF}"/>
                    </a:ext>
                  </a:extLst>
                </p:cNvPr>
                <p:cNvSpPr/>
                <p:nvPr/>
              </p:nvSpPr>
              <p:spPr>
                <a:xfrm rot="10800000">
                  <a:off x="11923760" y="9993713"/>
                  <a:ext cx="123106" cy="85889"/>
                </a:xfrm>
                <a:prstGeom prst="trapezoid">
                  <a:avLst>
                    <a:gd name="adj" fmla="val 3698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8" name="Rectangle: Rounded Corners 57">
                  <a:extLst>
                    <a:ext uri="{FF2B5EF4-FFF2-40B4-BE49-F238E27FC236}">
                      <a16:creationId xmlns:a16="http://schemas.microsoft.com/office/drawing/2014/main" id="{9655F4CC-44D5-60C2-E7A7-929EA81B2A97}"/>
                    </a:ext>
                  </a:extLst>
                </p:cNvPr>
                <p:cNvSpPr/>
                <p:nvPr/>
              </p:nvSpPr>
              <p:spPr>
                <a:xfrm>
                  <a:off x="11042409" y="6947349"/>
                  <a:ext cx="1765478" cy="195322"/>
                </a:xfrm>
                <a:prstGeom prst="roundRect">
                  <a:avLst>
                    <a:gd name="adj" fmla="val 1961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B05111FA-74C1-6F6C-9299-D18BD62395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12077" y="7050469"/>
                  <a:ext cx="49623" cy="182344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9316CC74-E5FB-1385-0044-8B870DAA53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786299" y="7042931"/>
                  <a:ext cx="46451" cy="186953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rapezoid 32">
                <a:extLst>
                  <a:ext uri="{FF2B5EF4-FFF2-40B4-BE49-F238E27FC236}">
                    <a16:creationId xmlns:a16="http://schemas.microsoft.com/office/drawing/2014/main" id="{10E7B228-40CC-4F6B-51B6-646EBC8BC799}"/>
                  </a:ext>
                </a:extLst>
              </p:cNvPr>
              <p:cNvSpPr/>
              <p:nvPr/>
            </p:nvSpPr>
            <p:spPr>
              <a:xfrm rot="10800000">
                <a:off x="10939945" y="10247711"/>
                <a:ext cx="131984" cy="98613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4" name="Trapezoid 33">
                <a:extLst>
                  <a:ext uri="{FF2B5EF4-FFF2-40B4-BE49-F238E27FC236}">
                    <a16:creationId xmlns:a16="http://schemas.microsoft.com/office/drawing/2014/main" id="{E7382145-1CDD-BB2B-215E-254AA3AC6DDD}"/>
                  </a:ext>
                </a:extLst>
              </p:cNvPr>
              <p:cNvSpPr/>
              <p:nvPr/>
            </p:nvSpPr>
            <p:spPr>
              <a:xfrm rot="10800000">
                <a:off x="10996688" y="10255028"/>
                <a:ext cx="126948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C2727C-3D6C-80DA-4D4D-D78DA4D5036E}"/>
                </a:ext>
              </a:extLst>
            </p:cNvPr>
            <p:cNvSpPr txBox="1"/>
            <p:nvPr/>
          </p:nvSpPr>
          <p:spPr>
            <a:xfrm>
              <a:off x="-1120990" y="16335208"/>
              <a:ext cx="9217654" cy="3142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0" dirty="0"/>
                <a:t>TX-TL reaction mixture</a:t>
              </a:r>
            </a:p>
          </p:txBody>
        </p:sp>
        <p:sp>
          <p:nvSpPr>
            <p:cNvPr id="19" name="Hexagon 18">
              <a:extLst>
                <a:ext uri="{FF2B5EF4-FFF2-40B4-BE49-F238E27FC236}">
                  <a16:creationId xmlns:a16="http://schemas.microsoft.com/office/drawing/2014/main" id="{ABE479DC-BEC7-B1A7-2679-31D9FFF2100F}"/>
                </a:ext>
              </a:extLst>
            </p:cNvPr>
            <p:cNvSpPr/>
            <p:nvPr/>
          </p:nvSpPr>
          <p:spPr>
            <a:xfrm>
              <a:off x="2646064" y="11393153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Hexagon 19">
              <a:extLst>
                <a:ext uri="{FF2B5EF4-FFF2-40B4-BE49-F238E27FC236}">
                  <a16:creationId xmlns:a16="http://schemas.microsoft.com/office/drawing/2014/main" id="{9A6BC27E-F9A6-B7A6-73DE-26970D149EA2}"/>
                </a:ext>
              </a:extLst>
            </p:cNvPr>
            <p:cNvSpPr/>
            <p:nvPr/>
          </p:nvSpPr>
          <p:spPr>
            <a:xfrm>
              <a:off x="3726148" y="1178582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Hexagon 20">
              <a:extLst>
                <a:ext uri="{FF2B5EF4-FFF2-40B4-BE49-F238E27FC236}">
                  <a16:creationId xmlns:a16="http://schemas.microsoft.com/office/drawing/2014/main" id="{67234DC2-879C-6662-C209-22CA602FBA90}"/>
                </a:ext>
              </a:extLst>
            </p:cNvPr>
            <p:cNvSpPr/>
            <p:nvPr/>
          </p:nvSpPr>
          <p:spPr>
            <a:xfrm>
              <a:off x="2965781" y="12688178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Hexagon 21">
              <a:extLst>
                <a:ext uri="{FF2B5EF4-FFF2-40B4-BE49-F238E27FC236}">
                  <a16:creationId xmlns:a16="http://schemas.microsoft.com/office/drawing/2014/main" id="{EEEF71C3-6BC4-45C8-C6BE-F22C3145F25C}"/>
                </a:ext>
              </a:extLst>
            </p:cNvPr>
            <p:cNvSpPr/>
            <p:nvPr/>
          </p:nvSpPr>
          <p:spPr>
            <a:xfrm>
              <a:off x="3586448" y="10994577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Hexagon 22">
              <a:extLst>
                <a:ext uri="{FF2B5EF4-FFF2-40B4-BE49-F238E27FC236}">
                  <a16:creationId xmlns:a16="http://schemas.microsoft.com/office/drawing/2014/main" id="{3A39DB67-ECBD-EBAD-0469-A5C20FDF5ADC}"/>
                </a:ext>
              </a:extLst>
            </p:cNvPr>
            <p:cNvSpPr/>
            <p:nvPr/>
          </p:nvSpPr>
          <p:spPr>
            <a:xfrm>
              <a:off x="3654145" y="1385148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E9C1DFBD-E95F-CC31-8273-D38CC91F03AD}"/>
                </a:ext>
              </a:extLst>
            </p:cNvPr>
            <p:cNvSpPr/>
            <p:nvPr/>
          </p:nvSpPr>
          <p:spPr>
            <a:xfrm>
              <a:off x="3081655" y="1195580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AB4AB4EC-BB63-CFDB-2A46-61374B69A351}"/>
                </a:ext>
              </a:extLst>
            </p:cNvPr>
            <p:cNvSpPr/>
            <p:nvPr/>
          </p:nvSpPr>
          <p:spPr>
            <a:xfrm>
              <a:off x="3364944" y="1235695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39C0E9B6-2468-2EC3-E4C1-00E3B3CDFC40}"/>
                </a:ext>
              </a:extLst>
            </p:cNvPr>
            <p:cNvSpPr/>
            <p:nvPr/>
          </p:nvSpPr>
          <p:spPr>
            <a:xfrm>
              <a:off x="3010530" y="14107849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" name="Connector: Curved 26">
              <a:extLst>
                <a:ext uri="{FF2B5EF4-FFF2-40B4-BE49-F238E27FC236}">
                  <a16:creationId xmlns:a16="http://schemas.microsoft.com/office/drawing/2014/main" id="{69DDB432-D338-9664-AEB8-03CC4A395E7F}"/>
                </a:ext>
              </a:extLst>
            </p:cNvPr>
            <p:cNvCxnSpPr/>
            <p:nvPr/>
          </p:nvCxnSpPr>
          <p:spPr>
            <a:xfrm rot="10800000" flipV="1">
              <a:off x="3207177" y="13301673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or: Curved 27">
              <a:extLst>
                <a:ext uri="{FF2B5EF4-FFF2-40B4-BE49-F238E27FC236}">
                  <a16:creationId xmlns:a16="http://schemas.microsoft.com/office/drawing/2014/main" id="{57D9F8F6-3820-1850-26E0-96FD45996E0A}"/>
                </a:ext>
              </a:extLst>
            </p:cNvPr>
            <p:cNvCxnSpPr/>
            <p:nvPr/>
          </p:nvCxnSpPr>
          <p:spPr>
            <a:xfrm rot="10800000" flipV="1">
              <a:off x="2882340" y="116039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or: Curved 28">
              <a:extLst>
                <a:ext uri="{FF2B5EF4-FFF2-40B4-BE49-F238E27FC236}">
                  <a16:creationId xmlns:a16="http://schemas.microsoft.com/office/drawing/2014/main" id="{73B3297E-836B-B0A6-3508-B6D86BA58C0F}"/>
                </a:ext>
              </a:extLst>
            </p:cNvPr>
            <p:cNvCxnSpPr/>
            <p:nvPr/>
          </p:nvCxnSpPr>
          <p:spPr>
            <a:xfrm rot="10800000" flipV="1">
              <a:off x="3263340" y="128866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or: Curved 29">
              <a:extLst>
                <a:ext uri="{FF2B5EF4-FFF2-40B4-BE49-F238E27FC236}">
                  <a16:creationId xmlns:a16="http://schemas.microsoft.com/office/drawing/2014/main" id="{9FCA8996-97C2-064B-8844-C0648AEBA977}"/>
                </a:ext>
              </a:extLst>
            </p:cNvPr>
            <p:cNvCxnSpPr/>
            <p:nvPr/>
          </p:nvCxnSpPr>
          <p:spPr>
            <a:xfrm rot="10800000" flipV="1">
              <a:off x="3359577" y="145032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1" name="Picture 60">
            <a:extLst>
              <a:ext uri="{FF2B5EF4-FFF2-40B4-BE49-F238E27FC236}">
                <a16:creationId xmlns:a16="http://schemas.microsoft.com/office/drawing/2014/main" id="{A17F252A-2338-4A7A-CACE-7AC0F31F7B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82746" y="150445"/>
            <a:ext cx="5057081" cy="8591688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B6232D01-E972-F884-8A05-0A5C1D164CF2}"/>
              </a:ext>
            </a:extLst>
          </p:cNvPr>
          <p:cNvSpPr txBox="1"/>
          <p:nvPr/>
        </p:nvSpPr>
        <p:spPr>
          <a:xfrm>
            <a:off x="13464472" y="8993759"/>
            <a:ext cx="7599229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Echo 525 Liquid Handler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64797A8F-6E79-7778-1FBA-21A6E04955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584733" y="7834089"/>
            <a:ext cx="7599230" cy="5624289"/>
          </a:xfrm>
          <a:prstGeom prst="rect">
            <a:avLst/>
          </a:prstGeom>
        </p:spPr>
      </p:pic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EE1A5A69-DDEB-30DC-3ABD-43FD14DBD20C}"/>
              </a:ext>
            </a:extLst>
          </p:cNvPr>
          <p:cNvCxnSpPr>
            <a:cxnSpLocks/>
          </p:cNvCxnSpPr>
          <p:nvPr/>
        </p:nvCxnSpPr>
        <p:spPr>
          <a:xfrm>
            <a:off x="11618505" y="6226185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54C61565-9D69-2189-291F-3BFA30A064A2}"/>
              </a:ext>
            </a:extLst>
          </p:cNvPr>
          <p:cNvSpPr txBox="1"/>
          <p:nvPr/>
        </p:nvSpPr>
        <p:spPr>
          <a:xfrm>
            <a:off x="22653967" y="13499254"/>
            <a:ext cx="7460762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/>
              <a:t>10µL reactions in 384-well plate</a:t>
            </a:r>
          </a:p>
        </p:txBody>
      </p:sp>
      <p:sp>
        <p:nvSpPr>
          <p:cNvPr id="73" name="Hexagon 72">
            <a:extLst>
              <a:ext uri="{FF2B5EF4-FFF2-40B4-BE49-F238E27FC236}">
                <a16:creationId xmlns:a16="http://schemas.microsoft.com/office/drawing/2014/main" id="{E2F7BD3A-E116-C9CB-60F4-251B081AE92D}"/>
              </a:ext>
            </a:extLst>
          </p:cNvPr>
          <p:cNvSpPr/>
          <p:nvPr/>
        </p:nvSpPr>
        <p:spPr>
          <a:xfrm rot="1800000">
            <a:off x="6054027" y="6314286"/>
            <a:ext cx="2743200" cy="2377440"/>
          </a:xfrm>
          <a:prstGeom prst="hexagon">
            <a:avLst>
              <a:gd name="adj" fmla="val 28695"/>
              <a:gd name="vf" fmla="val 115470"/>
            </a:avLst>
          </a:prstGeom>
          <a:solidFill>
            <a:srgbClr val="E5EBFB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18F06F5-50CD-D9E9-BA32-71CC4879B9E4}"/>
              </a:ext>
            </a:extLst>
          </p:cNvPr>
          <p:cNvSpPr txBox="1"/>
          <p:nvPr/>
        </p:nvSpPr>
        <p:spPr>
          <a:xfrm>
            <a:off x="6221710" y="6732252"/>
            <a:ext cx="240783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/>
              <a:t>Fuel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A30D0689-8002-476D-465D-60642A7BCEE4}"/>
              </a:ext>
            </a:extLst>
          </p:cNvPr>
          <p:cNvGrpSpPr/>
          <p:nvPr/>
        </p:nvGrpSpPr>
        <p:grpSpPr>
          <a:xfrm>
            <a:off x="621113" y="932607"/>
            <a:ext cx="10293631" cy="4474460"/>
            <a:chOff x="489316" y="12776887"/>
            <a:chExt cx="10293631" cy="447446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3534AE9-BABE-5AD1-EEA1-599AA8D94B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95969" y="14032207"/>
              <a:ext cx="1640904" cy="1647403"/>
            </a:xfrm>
            <a:prstGeom prst="rect">
              <a:avLst/>
            </a:prstGeom>
          </p:spPr>
        </p:pic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782BEEF1-C311-BB2E-1F8F-7FCA6BD1F835}"/>
                </a:ext>
              </a:extLst>
            </p:cNvPr>
            <p:cNvSpPr/>
            <p:nvPr/>
          </p:nvSpPr>
          <p:spPr>
            <a:xfrm>
              <a:off x="489316" y="15707157"/>
              <a:ext cx="10293631" cy="1544190"/>
            </a:xfrm>
            <a:prstGeom prst="roundRect">
              <a:avLst/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C38AC8C-3922-5212-DB25-1670B8BE56BD}"/>
                </a:ext>
              </a:extLst>
            </p:cNvPr>
            <p:cNvCxnSpPr/>
            <p:nvPr/>
          </p:nvCxnSpPr>
          <p:spPr>
            <a:xfrm>
              <a:off x="1154301" y="14294282"/>
              <a:ext cx="0" cy="14630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E3B0425C-65A4-1D6D-7909-DBA40E082C44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15" y="14347622"/>
              <a:ext cx="1043360" cy="0"/>
            </a:xfrm>
            <a:prstGeom prst="line">
              <a:avLst/>
            </a:prstGeom>
            <a:ln w="1143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Partial Circle 14">
              <a:extLst>
                <a:ext uri="{FF2B5EF4-FFF2-40B4-BE49-F238E27FC236}">
                  <a16:creationId xmlns:a16="http://schemas.microsoft.com/office/drawing/2014/main" id="{3CC7893C-0DEA-EC9C-9948-CE30C408A3A3}"/>
                </a:ext>
              </a:extLst>
            </p:cNvPr>
            <p:cNvSpPr/>
            <p:nvPr/>
          </p:nvSpPr>
          <p:spPr>
            <a:xfrm rot="5400000">
              <a:off x="4085125" y="15265521"/>
              <a:ext cx="1035047" cy="883279"/>
            </a:xfrm>
            <a:prstGeom prst="pie">
              <a:avLst>
                <a:gd name="adj1" fmla="val 5418294"/>
                <a:gd name="adj2" fmla="val 16200000"/>
              </a:avLst>
            </a:prstGeom>
            <a:noFill/>
            <a:ln w="1143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A80067D-9407-733B-2B6A-6734258DBCD8}"/>
                </a:ext>
              </a:extLst>
            </p:cNvPr>
            <p:cNvSpPr txBox="1"/>
            <p:nvPr/>
          </p:nvSpPr>
          <p:spPr>
            <a:xfrm>
              <a:off x="5643928" y="15106995"/>
              <a:ext cx="3698875" cy="1323439"/>
            </a:xfrm>
            <a:prstGeom prst="homePlate">
              <a:avLst/>
            </a:prstGeom>
            <a:solidFill>
              <a:srgbClr val="70AD47"/>
            </a:solidFill>
            <a:ln w="762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0" b="1" i="1" dirty="0"/>
                <a:t>deGFP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71BC54A1-EE54-A5B0-67E2-670CA8EFB5AC}"/>
                </a:ext>
              </a:extLst>
            </p:cNvPr>
            <p:cNvCxnSpPr/>
            <p:nvPr/>
          </p:nvCxnSpPr>
          <p:spPr>
            <a:xfrm>
              <a:off x="9885096" y="14666863"/>
              <a:ext cx="0" cy="10058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01EC9730-C460-AA3B-2528-EFDE7215D8B7}"/>
                </a:ext>
              </a:extLst>
            </p:cNvPr>
            <p:cNvCxnSpPr>
              <a:cxnSpLocks/>
            </p:cNvCxnSpPr>
            <p:nvPr/>
          </p:nvCxnSpPr>
          <p:spPr>
            <a:xfrm>
              <a:off x="9342803" y="14677464"/>
              <a:ext cx="1028701" cy="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FC81FD6-5275-A3BD-C937-F827AE03B6ED}"/>
                </a:ext>
              </a:extLst>
            </p:cNvPr>
            <p:cNvSpPr txBox="1"/>
            <p:nvPr/>
          </p:nvSpPr>
          <p:spPr>
            <a:xfrm>
              <a:off x="2203199" y="12776887"/>
              <a:ext cx="1802897" cy="13234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0" b="1" dirty="0"/>
                <a:t>MG</a:t>
              </a:r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01E8B87A-747C-D261-F536-6FA353B54CE3}"/>
                </a:ext>
              </a:extLst>
            </p:cNvPr>
            <p:cNvSpPr/>
            <p:nvPr/>
          </p:nvSpPr>
          <p:spPr>
            <a:xfrm>
              <a:off x="3965742" y="13157719"/>
              <a:ext cx="548640" cy="548640"/>
            </a:xfrm>
            <a:prstGeom prst="ellipse">
              <a:avLst/>
            </a:prstGeom>
            <a:solidFill>
              <a:schemeClr val="accent2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Arc 87">
            <a:extLst>
              <a:ext uri="{FF2B5EF4-FFF2-40B4-BE49-F238E27FC236}">
                <a16:creationId xmlns:a16="http://schemas.microsoft.com/office/drawing/2014/main" id="{2466C30F-D8B2-E928-568F-C179E3444FB2}"/>
              </a:ext>
            </a:extLst>
          </p:cNvPr>
          <p:cNvSpPr/>
          <p:nvPr/>
        </p:nvSpPr>
        <p:spPr>
          <a:xfrm>
            <a:off x="18466007" y="4423353"/>
            <a:ext cx="5355276" cy="5624289"/>
          </a:xfrm>
          <a:prstGeom prst="arc">
            <a:avLst>
              <a:gd name="adj1" fmla="val 16200000"/>
              <a:gd name="adj2" fmla="val 2074057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Arc 88">
            <a:extLst>
              <a:ext uri="{FF2B5EF4-FFF2-40B4-BE49-F238E27FC236}">
                <a16:creationId xmlns:a16="http://schemas.microsoft.com/office/drawing/2014/main" id="{E49CE1BA-3947-4E1B-0A9C-38E0A344304B}"/>
              </a:ext>
            </a:extLst>
          </p:cNvPr>
          <p:cNvSpPr/>
          <p:nvPr/>
        </p:nvSpPr>
        <p:spPr>
          <a:xfrm flipV="1">
            <a:off x="18459520" y="13556840"/>
            <a:ext cx="5355276" cy="5624289"/>
          </a:xfrm>
          <a:prstGeom prst="arc">
            <a:avLst>
              <a:gd name="adj1" fmla="val 16200000"/>
              <a:gd name="adj2" fmla="val 2055868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F4F5B0C5-B65A-F24C-4586-038D9B63654E}"/>
              </a:ext>
            </a:extLst>
          </p:cNvPr>
          <p:cNvCxnSpPr>
            <a:cxnSpLocks/>
          </p:cNvCxnSpPr>
          <p:nvPr/>
        </p:nvCxnSpPr>
        <p:spPr>
          <a:xfrm>
            <a:off x="30695010" y="11022466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4C6A373A-94AC-15E6-7D4B-1A355E9926A2}"/>
              </a:ext>
            </a:extLst>
          </p:cNvPr>
          <p:cNvCxnSpPr>
            <a:cxnSpLocks/>
          </p:cNvCxnSpPr>
          <p:nvPr/>
        </p:nvCxnSpPr>
        <p:spPr>
          <a:xfrm>
            <a:off x="44973438" y="11044237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43279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ED9D7A-DD2D-20FA-1BF7-4848FCB891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>
            <a:extLst>
              <a:ext uri="{FF2B5EF4-FFF2-40B4-BE49-F238E27FC236}">
                <a16:creationId xmlns:a16="http://schemas.microsoft.com/office/drawing/2014/main" id="{BD3F94F5-5859-4271-FEB0-733B59CE13C7}"/>
              </a:ext>
            </a:extLst>
          </p:cNvPr>
          <p:cNvSpPr txBox="1"/>
          <p:nvPr/>
        </p:nvSpPr>
        <p:spPr>
          <a:xfrm>
            <a:off x="1975449" y="7361879"/>
            <a:ext cx="3145536" cy="3145536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87E5C3D-1F27-EC93-F4E3-8BD830EFA463}"/>
              </a:ext>
            </a:extLst>
          </p:cNvPr>
          <p:cNvSpPr txBox="1"/>
          <p:nvPr/>
        </p:nvSpPr>
        <p:spPr>
          <a:xfrm>
            <a:off x="1918999" y="8003623"/>
            <a:ext cx="3390167" cy="1862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500" dirty="0">
                <a:solidFill>
                  <a:schemeClr val="bg1"/>
                </a:solidFill>
              </a:rPr>
              <a:t>Mg</a:t>
            </a:r>
            <a:r>
              <a:rPr lang="en-US" sz="11500" baseline="30000" dirty="0">
                <a:solidFill>
                  <a:schemeClr val="bg1"/>
                </a:solidFill>
              </a:rPr>
              <a:t>2+</a:t>
            </a:r>
            <a:endParaRPr lang="en-US" sz="8800" dirty="0">
              <a:solidFill>
                <a:schemeClr val="bg1"/>
              </a:solidFill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BE285CC-CE02-FF94-2501-424C23D3C66B}"/>
              </a:ext>
            </a:extLst>
          </p:cNvPr>
          <p:cNvGrpSpPr/>
          <p:nvPr/>
        </p:nvGrpSpPr>
        <p:grpSpPr>
          <a:xfrm>
            <a:off x="13464471" y="13125445"/>
            <a:ext cx="7599228" cy="9034412"/>
            <a:chOff x="-1120990" y="8729375"/>
            <a:chExt cx="9217654" cy="11113463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2844F66-D313-18E1-4B7D-CADCC5D83707}"/>
                </a:ext>
              </a:extLst>
            </p:cNvPr>
            <p:cNvGrpSpPr/>
            <p:nvPr/>
          </p:nvGrpSpPr>
          <p:grpSpPr>
            <a:xfrm>
              <a:off x="1757272" y="8729375"/>
              <a:ext cx="3036903" cy="7634415"/>
              <a:chOff x="9341364" y="2891367"/>
              <a:chExt cx="3036903" cy="7634415"/>
            </a:xfrm>
          </p:grpSpPr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AF8FDBA1-3BD1-43A3-E98A-F7AB537BDD96}"/>
                  </a:ext>
                </a:extLst>
              </p:cNvPr>
              <p:cNvSpPr/>
              <p:nvPr/>
            </p:nvSpPr>
            <p:spPr>
              <a:xfrm>
                <a:off x="10876112" y="9655176"/>
                <a:ext cx="373655" cy="764859"/>
              </a:xfrm>
              <a:prstGeom prst="ellipse">
                <a:avLst/>
              </a:prstGeom>
              <a:solidFill>
                <a:srgbClr val="F9EFD0"/>
              </a:solidFill>
              <a:ln w="57150">
                <a:solidFill>
                  <a:srgbClr val="F9EFD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1D288E5-09F3-26BD-36A6-2210902535DB}"/>
                  </a:ext>
                </a:extLst>
              </p:cNvPr>
              <p:cNvGrpSpPr/>
              <p:nvPr/>
            </p:nvGrpSpPr>
            <p:grpSpPr>
              <a:xfrm>
                <a:off x="9341364" y="2891367"/>
                <a:ext cx="3036903" cy="7634415"/>
                <a:chOff x="10204964" y="2637367"/>
                <a:chExt cx="3036903" cy="7634415"/>
              </a:xfrm>
            </p:grpSpPr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63AE1F7D-53E2-A934-1B83-487A9CA2C0BE}"/>
                    </a:ext>
                  </a:extLst>
                </p:cNvPr>
                <p:cNvSpPr/>
                <p:nvPr/>
              </p:nvSpPr>
              <p:spPr>
                <a:xfrm>
                  <a:off x="11612886" y="9401176"/>
                  <a:ext cx="634677" cy="870606"/>
                </a:xfrm>
                <a:prstGeom prst="ellipse">
                  <a:avLst/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26A7B278-0233-0AAF-DBF3-C8B9D4037018}"/>
                    </a:ext>
                  </a:extLst>
                </p:cNvPr>
                <p:cNvSpPr/>
                <p:nvPr/>
              </p:nvSpPr>
              <p:spPr>
                <a:xfrm>
                  <a:off x="10898271" y="4668519"/>
                  <a:ext cx="2050649" cy="235163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7" name="Block Arc 36">
                  <a:extLst>
                    <a:ext uri="{FF2B5EF4-FFF2-40B4-BE49-F238E27FC236}">
                      <a16:creationId xmlns:a16="http://schemas.microsoft.com/office/drawing/2014/main" id="{C8C60393-082F-1E59-C137-F5820F8BA823}"/>
                    </a:ext>
                  </a:extLst>
                </p:cNvPr>
                <p:cNvSpPr/>
                <p:nvPr/>
              </p:nvSpPr>
              <p:spPr>
                <a:xfrm rot="14698403">
                  <a:off x="10270097" y="2676360"/>
                  <a:ext cx="427356" cy="514795"/>
                </a:xfrm>
                <a:prstGeom prst="blockArc">
                  <a:avLst>
                    <a:gd name="adj1" fmla="val 13560443"/>
                    <a:gd name="adj2" fmla="val 2935971"/>
                    <a:gd name="adj3" fmla="val 24413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7BEE5F32-A63B-51BB-FCB5-387034AB8875}"/>
                    </a:ext>
                  </a:extLst>
                </p:cNvPr>
                <p:cNvSpPr/>
                <p:nvPr/>
              </p:nvSpPr>
              <p:spPr>
                <a:xfrm>
                  <a:off x="10445751" y="3054350"/>
                  <a:ext cx="464594" cy="10027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" name="Block Arc 38">
                  <a:extLst>
                    <a:ext uri="{FF2B5EF4-FFF2-40B4-BE49-F238E27FC236}">
                      <a16:creationId xmlns:a16="http://schemas.microsoft.com/office/drawing/2014/main" id="{24D8F084-0E01-7C1E-3DC7-570D1861E27B}"/>
                    </a:ext>
                  </a:extLst>
                </p:cNvPr>
                <p:cNvSpPr/>
                <p:nvPr/>
              </p:nvSpPr>
              <p:spPr>
                <a:xfrm rot="11312380">
                  <a:off x="10247864" y="2641239"/>
                  <a:ext cx="427356" cy="514795"/>
                </a:xfrm>
                <a:prstGeom prst="blockArc">
                  <a:avLst>
                    <a:gd name="adj1" fmla="val 15619198"/>
                    <a:gd name="adj2" fmla="val 16406583"/>
                    <a:gd name="adj3" fmla="val 22545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0" name="Block Arc 39">
                  <a:extLst>
                    <a:ext uri="{FF2B5EF4-FFF2-40B4-BE49-F238E27FC236}">
                      <a16:creationId xmlns:a16="http://schemas.microsoft.com/office/drawing/2014/main" id="{85ED6C6B-7AF0-5121-497B-0DFBAD7DA86F}"/>
                    </a:ext>
                  </a:extLst>
                </p:cNvPr>
                <p:cNvSpPr/>
                <p:nvPr/>
              </p:nvSpPr>
              <p:spPr>
                <a:xfrm rot="11312380">
                  <a:off x="10204964" y="2933117"/>
                  <a:ext cx="427356" cy="192024"/>
                </a:xfrm>
                <a:prstGeom prst="blockArc">
                  <a:avLst>
                    <a:gd name="adj1" fmla="val 15879138"/>
                    <a:gd name="adj2" fmla="val 17412361"/>
                    <a:gd name="adj3" fmla="val 26734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Block Arc 40">
                  <a:extLst>
                    <a:ext uri="{FF2B5EF4-FFF2-40B4-BE49-F238E27FC236}">
                      <a16:creationId xmlns:a16="http://schemas.microsoft.com/office/drawing/2014/main" id="{F2D33CF2-527F-0ACC-1798-1B95925415E1}"/>
                    </a:ext>
                  </a:extLst>
                </p:cNvPr>
                <p:cNvSpPr/>
                <p:nvPr/>
              </p:nvSpPr>
              <p:spPr>
                <a:xfrm rot="11312380">
                  <a:off x="10214444" y="2933116"/>
                  <a:ext cx="427356" cy="192024"/>
                </a:xfrm>
                <a:prstGeom prst="blockArc">
                  <a:avLst>
                    <a:gd name="adj1" fmla="val 13519529"/>
                    <a:gd name="adj2" fmla="val 16615939"/>
                    <a:gd name="adj3" fmla="val 25588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Block Arc 41">
                  <a:extLst>
                    <a:ext uri="{FF2B5EF4-FFF2-40B4-BE49-F238E27FC236}">
                      <a16:creationId xmlns:a16="http://schemas.microsoft.com/office/drawing/2014/main" id="{ED167386-25F3-BAD5-EB91-16553110729D}"/>
                    </a:ext>
                  </a:extLst>
                </p:cNvPr>
                <p:cNvSpPr/>
                <p:nvPr/>
              </p:nvSpPr>
              <p:spPr>
                <a:xfrm rot="11032256">
                  <a:off x="10238792" y="2931528"/>
                  <a:ext cx="427356" cy="192024"/>
                </a:xfrm>
                <a:prstGeom prst="blockArc">
                  <a:avLst>
                    <a:gd name="adj1" fmla="val 13519529"/>
                    <a:gd name="adj2" fmla="val 15470025"/>
                    <a:gd name="adj3" fmla="val 23131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" name="Rectangle: Rounded Corners 42">
                  <a:extLst>
                    <a:ext uri="{FF2B5EF4-FFF2-40B4-BE49-F238E27FC236}">
                      <a16:creationId xmlns:a16="http://schemas.microsoft.com/office/drawing/2014/main" id="{AEF1B87C-61D5-DFA7-F7E9-FE3B85E57CFF}"/>
                    </a:ext>
                  </a:extLst>
                </p:cNvPr>
                <p:cNvSpPr/>
                <p:nvPr/>
              </p:nvSpPr>
              <p:spPr>
                <a:xfrm>
                  <a:off x="10795109" y="2870200"/>
                  <a:ext cx="2235084" cy="358703"/>
                </a:xfrm>
                <a:prstGeom prst="roundRect">
                  <a:avLst>
                    <a:gd name="adj" fmla="val 30607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Rectangle: Rounded Corners 43">
                  <a:extLst>
                    <a:ext uri="{FF2B5EF4-FFF2-40B4-BE49-F238E27FC236}">
                      <a16:creationId xmlns:a16="http://schemas.microsoft.com/office/drawing/2014/main" id="{30710238-A871-4C93-EF70-A43D68EB1D6A}"/>
                    </a:ext>
                  </a:extLst>
                </p:cNvPr>
                <p:cNvSpPr/>
                <p:nvPr/>
              </p:nvSpPr>
              <p:spPr>
                <a:xfrm>
                  <a:off x="10565822" y="2637367"/>
                  <a:ext cx="2676045" cy="326453"/>
                </a:xfrm>
                <a:prstGeom prst="roundRect">
                  <a:avLst>
                    <a:gd name="adj" fmla="val 41305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rapezoid 44">
                  <a:extLst>
                    <a:ext uri="{FF2B5EF4-FFF2-40B4-BE49-F238E27FC236}">
                      <a16:creationId xmlns:a16="http://schemas.microsoft.com/office/drawing/2014/main" id="{8AF4A04C-323D-95A2-BE0A-B81E298237A7}"/>
                    </a:ext>
                  </a:extLst>
                </p:cNvPr>
                <p:cNvSpPr/>
                <p:nvPr/>
              </p:nvSpPr>
              <p:spPr>
                <a:xfrm rot="10800000">
                  <a:off x="10894226" y="7020147"/>
                  <a:ext cx="2071313" cy="2957101"/>
                </a:xfrm>
                <a:prstGeom prst="trapezoid">
                  <a:avLst>
                    <a:gd name="adj" fmla="val 36875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D16153B9-ACBB-1732-6136-58BAF69AA0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20487" y="7029540"/>
                  <a:ext cx="728432" cy="298318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85BBF9D1-3327-D7DB-6DA1-6D20318371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7020153"/>
                  <a:ext cx="744971" cy="2996972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46022B2E-2F0E-86E6-F001-BC67CBFF63B5}"/>
                    </a:ext>
                  </a:extLst>
                </p:cNvPr>
                <p:cNvSpPr/>
                <p:nvPr/>
              </p:nvSpPr>
              <p:spPr>
                <a:xfrm>
                  <a:off x="10898271" y="3262086"/>
                  <a:ext cx="2050649" cy="1538229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E001463E-606B-9567-3D18-97B30E1E4F47}"/>
                    </a:ext>
                  </a:extLst>
                </p:cNvPr>
                <p:cNvSpPr/>
                <p:nvPr/>
              </p:nvSpPr>
              <p:spPr>
                <a:xfrm>
                  <a:off x="11012077" y="4677907"/>
                  <a:ext cx="1827973" cy="2351633"/>
                </a:xfrm>
                <a:prstGeom prst="rect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AEB7CA1A-0A36-DD0C-1CE4-C211E1823C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530352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F28DA8B5-3B91-315B-4BFF-BAC5A28A79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75046" y="685800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2" name="Oval 51">
                  <a:extLst>
                    <a:ext uri="{FF2B5EF4-FFF2-40B4-BE49-F238E27FC236}">
                      <a16:creationId xmlns:a16="http://schemas.microsoft.com/office/drawing/2014/main" id="{77668779-8C5B-BBFE-3C39-BABAB49410D4}"/>
                    </a:ext>
                  </a:extLst>
                </p:cNvPr>
                <p:cNvSpPr/>
                <p:nvPr/>
              </p:nvSpPr>
              <p:spPr>
                <a:xfrm>
                  <a:off x="11739712" y="9419272"/>
                  <a:ext cx="373655" cy="764859"/>
                </a:xfrm>
                <a:prstGeom prst="ellipse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9AB2DA49-9AF6-2E45-4FA3-7A6FBA43E7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374396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8B2D432C-DFB8-4629-093A-265998929F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48920" y="3236263"/>
                  <a:ext cx="0" cy="3808748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F2755E92-EAB4-B6AF-BA57-23A4A99728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3236263"/>
                  <a:ext cx="0" cy="3801125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6" name="Trapezoid 55">
                  <a:extLst>
                    <a:ext uri="{FF2B5EF4-FFF2-40B4-BE49-F238E27FC236}">
                      <a16:creationId xmlns:a16="http://schemas.microsoft.com/office/drawing/2014/main" id="{AB9155AD-F588-8E42-FC9D-D92AC662BA87}"/>
                    </a:ext>
                  </a:extLst>
                </p:cNvPr>
                <p:cNvSpPr/>
                <p:nvPr/>
              </p:nvSpPr>
              <p:spPr>
                <a:xfrm rot="10800000">
                  <a:off x="11020539" y="7078403"/>
                  <a:ext cx="1810512" cy="2957103"/>
                </a:xfrm>
                <a:prstGeom prst="trapezoid">
                  <a:avLst>
                    <a:gd name="adj" fmla="val 41887"/>
                  </a:avLst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Trapezoid 56">
                  <a:extLst>
                    <a:ext uri="{FF2B5EF4-FFF2-40B4-BE49-F238E27FC236}">
                      <a16:creationId xmlns:a16="http://schemas.microsoft.com/office/drawing/2014/main" id="{5F623A1A-B6DF-D77A-913F-22143E32DDFF}"/>
                    </a:ext>
                  </a:extLst>
                </p:cNvPr>
                <p:cNvSpPr/>
                <p:nvPr/>
              </p:nvSpPr>
              <p:spPr>
                <a:xfrm rot="10800000">
                  <a:off x="11923760" y="9993713"/>
                  <a:ext cx="123106" cy="85889"/>
                </a:xfrm>
                <a:prstGeom prst="trapezoid">
                  <a:avLst>
                    <a:gd name="adj" fmla="val 3698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8" name="Rectangle: Rounded Corners 57">
                  <a:extLst>
                    <a:ext uri="{FF2B5EF4-FFF2-40B4-BE49-F238E27FC236}">
                      <a16:creationId xmlns:a16="http://schemas.microsoft.com/office/drawing/2014/main" id="{9655F4CC-44D5-60C2-E7A7-929EA81B2A97}"/>
                    </a:ext>
                  </a:extLst>
                </p:cNvPr>
                <p:cNvSpPr/>
                <p:nvPr/>
              </p:nvSpPr>
              <p:spPr>
                <a:xfrm>
                  <a:off x="11042409" y="6947349"/>
                  <a:ext cx="1765478" cy="195322"/>
                </a:xfrm>
                <a:prstGeom prst="roundRect">
                  <a:avLst>
                    <a:gd name="adj" fmla="val 1961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B05111FA-74C1-6F6C-9299-D18BD62395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12077" y="7050469"/>
                  <a:ext cx="49623" cy="182344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9316CC74-E5FB-1385-0044-8B870DAA53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786299" y="7042931"/>
                  <a:ext cx="46451" cy="186953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rapezoid 32">
                <a:extLst>
                  <a:ext uri="{FF2B5EF4-FFF2-40B4-BE49-F238E27FC236}">
                    <a16:creationId xmlns:a16="http://schemas.microsoft.com/office/drawing/2014/main" id="{10E7B228-40CC-4F6B-51B6-646EBC8BC799}"/>
                  </a:ext>
                </a:extLst>
              </p:cNvPr>
              <p:cNvSpPr/>
              <p:nvPr/>
            </p:nvSpPr>
            <p:spPr>
              <a:xfrm rot="10800000">
                <a:off x="10939945" y="10247711"/>
                <a:ext cx="131984" cy="98613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4" name="Trapezoid 33">
                <a:extLst>
                  <a:ext uri="{FF2B5EF4-FFF2-40B4-BE49-F238E27FC236}">
                    <a16:creationId xmlns:a16="http://schemas.microsoft.com/office/drawing/2014/main" id="{E7382145-1CDD-BB2B-215E-254AA3AC6DDD}"/>
                  </a:ext>
                </a:extLst>
              </p:cNvPr>
              <p:cNvSpPr/>
              <p:nvPr/>
            </p:nvSpPr>
            <p:spPr>
              <a:xfrm rot="10800000">
                <a:off x="10996688" y="10255028"/>
                <a:ext cx="126948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C2727C-3D6C-80DA-4D4D-D78DA4D5036E}"/>
                </a:ext>
              </a:extLst>
            </p:cNvPr>
            <p:cNvSpPr txBox="1"/>
            <p:nvPr/>
          </p:nvSpPr>
          <p:spPr>
            <a:xfrm>
              <a:off x="-1120990" y="16094659"/>
              <a:ext cx="9217654" cy="3748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600" dirty="0"/>
                <a:t>TX-TL reaction mixture</a:t>
              </a:r>
            </a:p>
          </p:txBody>
        </p:sp>
        <p:sp>
          <p:nvSpPr>
            <p:cNvPr id="19" name="Hexagon 18">
              <a:extLst>
                <a:ext uri="{FF2B5EF4-FFF2-40B4-BE49-F238E27FC236}">
                  <a16:creationId xmlns:a16="http://schemas.microsoft.com/office/drawing/2014/main" id="{ABE479DC-BEC7-B1A7-2679-31D9FFF2100F}"/>
                </a:ext>
              </a:extLst>
            </p:cNvPr>
            <p:cNvSpPr/>
            <p:nvPr/>
          </p:nvSpPr>
          <p:spPr>
            <a:xfrm>
              <a:off x="2646064" y="11393153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Hexagon 19">
              <a:extLst>
                <a:ext uri="{FF2B5EF4-FFF2-40B4-BE49-F238E27FC236}">
                  <a16:creationId xmlns:a16="http://schemas.microsoft.com/office/drawing/2014/main" id="{9A6BC27E-F9A6-B7A6-73DE-26970D149EA2}"/>
                </a:ext>
              </a:extLst>
            </p:cNvPr>
            <p:cNvSpPr/>
            <p:nvPr/>
          </p:nvSpPr>
          <p:spPr>
            <a:xfrm>
              <a:off x="3726148" y="1178582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Hexagon 20">
              <a:extLst>
                <a:ext uri="{FF2B5EF4-FFF2-40B4-BE49-F238E27FC236}">
                  <a16:creationId xmlns:a16="http://schemas.microsoft.com/office/drawing/2014/main" id="{67234DC2-879C-6662-C209-22CA602FBA90}"/>
                </a:ext>
              </a:extLst>
            </p:cNvPr>
            <p:cNvSpPr/>
            <p:nvPr/>
          </p:nvSpPr>
          <p:spPr>
            <a:xfrm>
              <a:off x="2965781" y="12688178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Hexagon 21">
              <a:extLst>
                <a:ext uri="{FF2B5EF4-FFF2-40B4-BE49-F238E27FC236}">
                  <a16:creationId xmlns:a16="http://schemas.microsoft.com/office/drawing/2014/main" id="{EEEF71C3-6BC4-45C8-C6BE-F22C3145F25C}"/>
                </a:ext>
              </a:extLst>
            </p:cNvPr>
            <p:cNvSpPr/>
            <p:nvPr/>
          </p:nvSpPr>
          <p:spPr>
            <a:xfrm>
              <a:off x="3586448" y="10994577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Hexagon 22">
              <a:extLst>
                <a:ext uri="{FF2B5EF4-FFF2-40B4-BE49-F238E27FC236}">
                  <a16:creationId xmlns:a16="http://schemas.microsoft.com/office/drawing/2014/main" id="{3A39DB67-ECBD-EBAD-0469-A5C20FDF5ADC}"/>
                </a:ext>
              </a:extLst>
            </p:cNvPr>
            <p:cNvSpPr/>
            <p:nvPr/>
          </p:nvSpPr>
          <p:spPr>
            <a:xfrm>
              <a:off x="3654145" y="1385148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E9C1DFBD-E95F-CC31-8273-D38CC91F03AD}"/>
                </a:ext>
              </a:extLst>
            </p:cNvPr>
            <p:cNvSpPr/>
            <p:nvPr/>
          </p:nvSpPr>
          <p:spPr>
            <a:xfrm>
              <a:off x="3081655" y="1195580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AB4AB4EC-BB63-CFDB-2A46-61374B69A351}"/>
                </a:ext>
              </a:extLst>
            </p:cNvPr>
            <p:cNvSpPr/>
            <p:nvPr/>
          </p:nvSpPr>
          <p:spPr>
            <a:xfrm>
              <a:off x="3364944" y="1235695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39C0E9B6-2468-2EC3-E4C1-00E3B3CDFC40}"/>
                </a:ext>
              </a:extLst>
            </p:cNvPr>
            <p:cNvSpPr/>
            <p:nvPr/>
          </p:nvSpPr>
          <p:spPr>
            <a:xfrm>
              <a:off x="3010530" y="14107849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" name="Connector: Curved 26">
              <a:extLst>
                <a:ext uri="{FF2B5EF4-FFF2-40B4-BE49-F238E27FC236}">
                  <a16:creationId xmlns:a16="http://schemas.microsoft.com/office/drawing/2014/main" id="{69DDB432-D338-9664-AEB8-03CC4A395E7F}"/>
                </a:ext>
              </a:extLst>
            </p:cNvPr>
            <p:cNvCxnSpPr/>
            <p:nvPr/>
          </p:nvCxnSpPr>
          <p:spPr>
            <a:xfrm rot="10800000" flipV="1">
              <a:off x="3207177" y="13301673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or: Curved 27">
              <a:extLst>
                <a:ext uri="{FF2B5EF4-FFF2-40B4-BE49-F238E27FC236}">
                  <a16:creationId xmlns:a16="http://schemas.microsoft.com/office/drawing/2014/main" id="{57D9F8F6-3820-1850-26E0-96FD45996E0A}"/>
                </a:ext>
              </a:extLst>
            </p:cNvPr>
            <p:cNvCxnSpPr/>
            <p:nvPr/>
          </p:nvCxnSpPr>
          <p:spPr>
            <a:xfrm rot="10800000" flipV="1">
              <a:off x="2882340" y="116039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or: Curved 28">
              <a:extLst>
                <a:ext uri="{FF2B5EF4-FFF2-40B4-BE49-F238E27FC236}">
                  <a16:creationId xmlns:a16="http://schemas.microsoft.com/office/drawing/2014/main" id="{73B3297E-836B-B0A6-3508-B6D86BA58C0F}"/>
                </a:ext>
              </a:extLst>
            </p:cNvPr>
            <p:cNvCxnSpPr/>
            <p:nvPr/>
          </p:nvCxnSpPr>
          <p:spPr>
            <a:xfrm rot="10800000" flipV="1">
              <a:off x="3263340" y="128866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or: Curved 29">
              <a:extLst>
                <a:ext uri="{FF2B5EF4-FFF2-40B4-BE49-F238E27FC236}">
                  <a16:creationId xmlns:a16="http://schemas.microsoft.com/office/drawing/2014/main" id="{9FCA8996-97C2-064B-8844-C0648AEBA977}"/>
                </a:ext>
              </a:extLst>
            </p:cNvPr>
            <p:cNvCxnSpPr/>
            <p:nvPr/>
          </p:nvCxnSpPr>
          <p:spPr>
            <a:xfrm rot="10800000" flipV="1">
              <a:off x="3359577" y="145032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1" name="Picture 60">
            <a:extLst>
              <a:ext uri="{FF2B5EF4-FFF2-40B4-BE49-F238E27FC236}">
                <a16:creationId xmlns:a16="http://schemas.microsoft.com/office/drawing/2014/main" id="{A17F252A-2338-4A7A-CACE-7AC0F31F7B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82746" y="150445"/>
            <a:ext cx="5057081" cy="8591688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B6232D01-E972-F884-8A05-0A5C1D164CF2}"/>
              </a:ext>
            </a:extLst>
          </p:cNvPr>
          <p:cNvSpPr txBox="1"/>
          <p:nvPr/>
        </p:nvSpPr>
        <p:spPr>
          <a:xfrm>
            <a:off x="13497635" y="8832270"/>
            <a:ext cx="7599229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dirty="0"/>
              <a:t>Echo 525 Liquid Handler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64797A8F-6E79-7778-1FBA-21A6E04955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84733" y="7834089"/>
            <a:ext cx="7599230" cy="5624289"/>
          </a:xfrm>
          <a:prstGeom prst="rect">
            <a:avLst/>
          </a:prstGeom>
        </p:spPr>
      </p:pic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EE1A5A69-DDEB-30DC-3ABD-43FD14DBD20C}"/>
              </a:ext>
            </a:extLst>
          </p:cNvPr>
          <p:cNvCxnSpPr>
            <a:cxnSpLocks/>
          </p:cNvCxnSpPr>
          <p:nvPr/>
        </p:nvCxnSpPr>
        <p:spPr>
          <a:xfrm>
            <a:off x="12214108" y="6547420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54C61565-9D69-2189-291F-3BFA30A064A2}"/>
              </a:ext>
            </a:extLst>
          </p:cNvPr>
          <p:cNvSpPr txBox="1"/>
          <p:nvPr/>
        </p:nvSpPr>
        <p:spPr>
          <a:xfrm>
            <a:off x="21957899" y="13532392"/>
            <a:ext cx="885289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dirty="0"/>
              <a:t>10µL reactions in 384-well plate</a:t>
            </a:r>
          </a:p>
        </p:txBody>
      </p:sp>
      <p:sp>
        <p:nvSpPr>
          <p:cNvPr id="73" name="Hexagon 72">
            <a:extLst>
              <a:ext uri="{FF2B5EF4-FFF2-40B4-BE49-F238E27FC236}">
                <a16:creationId xmlns:a16="http://schemas.microsoft.com/office/drawing/2014/main" id="{E2F7BD3A-E116-C9CB-60F4-251B081AE92D}"/>
              </a:ext>
            </a:extLst>
          </p:cNvPr>
          <p:cNvSpPr/>
          <p:nvPr/>
        </p:nvSpPr>
        <p:spPr>
          <a:xfrm rot="1800000">
            <a:off x="5859497" y="6004487"/>
            <a:ext cx="3429000" cy="2971800"/>
          </a:xfrm>
          <a:prstGeom prst="hexagon">
            <a:avLst>
              <a:gd name="adj" fmla="val 28695"/>
              <a:gd name="vf" fmla="val 115470"/>
            </a:avLst>
          </a:prstGeom>
          <a:solidFill>
            <a:srgbClr val="E5EBFB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18F06F5-50CD-D9E9-BA32-71CC4879B9E4}"/>
              </a:ext>
            </a:extLst>
          </p:cNvPr>
          <p:cNvSpPr txBox="1"/>
          <p:nvPr/>
        </p:nvSpPr>
        <p:spPr>
          <a:xfrm>
            <a:off x="6106415" y="6528788"/>
            <a:ext cx="2883447" cy="1862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500" dirty="0"/>
              <a:t>Fuel</a:t>
            </a:r>
            <a:endParaRPr lang="en-US" sz="8800" dirty="0"/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A30D0689-8002-476D-465D-60642A7BCEE4}"/>
              </a:ext>
            </a:extLst>
          </p:cNvPr>
          <p:cNvGrpSpPr/>
          <p:nvPr/>
        </p:nvGrpSpPr>
        <p:grpSpPr>
          <a:xfrm>
            <a:off x="621113" y="277458"/>
            <a:ext cx="11482214" cy="5005791"/>
            <a:chOff x="489316" y="12620280"/>
            <a:chExt cx="11386480" cy="463106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3534AE9-BABE-5AD1-EEA1-599AA8D94B3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96454" y="14034316"/>
              <a:ext cx="1640904" cy="1647403"/>
            </a:xfrm>
            <a:prstGeom prst="rect">
              <a:avLst/>
            </a:prstGeom>
          </p:spPr>
        </p:pic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782BEEF1-C311-BB2E-1F8F-7FCA6BD1F835}"/>
                </a:ext>
              </a:extLst>
            </p:cNvPr>
            <p:cNvSpPr/>
            <p:nvPr/>
          </p:nvSpPr>
          <p:spPr>
            <a:xfrm>
              <a:off x="489316" y="15707157"/>
              <a:ext cx="11386480" cy="1544190"/>
            </a:xfrm>
            <a:prstGeom prst="roundRect">
              <a:avLst/>
            </a:prstGeom>
            <a:noFill/>
            <a:ln w="139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C38AC8C-3922-5212-DB25-1670B8BE56BD}"/>
                </a:ext>
              </a:extLst>
            </p:cNvPr>
            <p:cNvCxnSpPr/>
            <p:nvPr/>
          </p:nvCxnSpPr>
          <p:spPr>
            <a:xfrm>
              <a:off x="1154301" y="14294282"/>
              <a:ext cx="0" cy="14630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E3B0425C-65A4-1D6D-7909-DBA40E082C44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15" y="14347622"/>
              <a:ext cx="1043360" cy="0"/>
            </a:xfrm>
            <a:prstGeom prst="line">
              <a:avLst/>
            </a:prstGeom>
            <a:ln w="139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Partial Circle 14">
              <a:extLst>
                <a:ext uri="{FF2B5EF4-FFF2-40B4-BE49-F238E27FC236}">
                  <a16:creationId xmlns:a16="http://schemas.microsoft.com/office/drawing/2014/main" id="{3CC7893C-0DEA-EC9C-9948-CE30C408A3A3}"/>
                </a:ext>
              </a:extLst>
            </p:cNvPr>
            <p:cNvSpPr/>
            <p:nvPr/>
          </p:nvSpPr>
          <p:spPr>
            <a:xfrm rot="5400000">
              <a:off x="3991321" y="15265521"/>
              <a:ext cx="1035047" cy="883279"/>
            </a:xfrm>
            <a:prstGeom prst="pie">
              <a:avLst>
                <a:gd name="adj1" fmla="val 5418294"/>
                <a:gd name="adj2" fmla="val 16200000"/>
              </a:avLst>
            </a:prstGeom>
            <a:noFill/>
            <a:ln w="139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A80067D-9407-733B-2B6A-6734258DBCD8}"/>
                </a:ext>
              </a:extLst>
            </p:cNvPr>
            <p:cNvSpPr txBox="1"/>
            <p:nvPr/>
          </p:nvSpPr>
          <p:spPr>
            <a:xfrm>
              <a:off x="5487587" y="14991235"/>
              <a:ext cx="4727576" cy="1452158"/>
            </a:xfrm>
            <a:prstGeom prst="homePlate">
              <a:avLst/>
            </a:prstGeom>
            <a:solidFill>
              <a:srgbClr val="70AD47"/>
            </a:solidFill>
            <a:ln w="1270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600" b="1" i="1" dirty="0"/>
                <a:t>deGFP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71BC54A1-EE54-A5B0-67E2-670CA8EFB5AC}"/>
                </a:ext>
              </a:extLst>
            </p:cNvPr>
            <p:cNvCxnSpPr/>
            <p:nvPr/>
          </p:nvCxnSpPr>
          <p:spPr>
            <a:xfrm>
              <a:off x="10951593" y="14572992"/>
              <a:ext cx="0" cy="1184330"/>
            </a:xfrm>
            <a:prstGeom prst="line">
              <a:avLst/>
            </a:prstGeom>
            <a:ln w="139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01EC9730-C460-AA3B-2528-EFDE7215D8B7}"/>
                </a:ext>
              </a:extLst>
            </p:cNvPr>
            <p:cNvCxnSpPr>
              <a:cxnSpLocks/>
            </p:cNvCxnSpPr>
            <p:nvPr/>
          </p:nvCxnSpPr>
          <p:spPr>
            <a:xfrm>
              <a:off x="10277700" y="14559171"/>
              <a:ext cx="1269487" cy="0"/>
            </a:xfrm>
            <a:prstGeom prst="line">
              <a:avLst/>
            </a:prstGeom>
            <a:ln w="139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FC81FD6-5275-A3BD-C937-F827AE03B6ED}"/>
                </a:ext>
              </a:extLst>
            </p:cNvPr>
            <p:cNvSpPr txBox="1"/>
            <p:nvPr/>
          </p:nvSpPr>
          <p:spPr>
            <a:xfrm>
              <a:off x="1955201" y="12620280"/>
              <a:ext cx="2186809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600" b="1" dirty="0"/>
                <a:t>MG</a:t>
              </a:r>
              <a:endParaRPr lang="en-US" sz="8000" b="1" dirty="0"/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01E8B87A-747C-D261-F536-6FA353B54CE3}"/>
                </a:ext>
              </a:extLst>
            </p:cNvPr>
            <p:cNvSpPr/>
            <p:nvPr/>
          </p:nvSpPr>
          <p:spPr>
            <a:xfrm>
              <a:off x="4044593" y="13120938"/>
              <a:ext cx="548640" cy="548640"/>
            </a:xfrm>
            <a:prstGeom prst="ellipse">
              <a:avLst/>
            </a:prstGeom>
            <a:solidFill>
              <a:schemeClr val="accent2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Arc 87">
            <a:extLst>
              <a:ext uri="{FF2B5EF4-FFF2-40B4-BE49-F238E27FC236}">
                <a16:creationId xmlns:a16="http://schemas.microsoft.com/office/drawing/2014/main" id="{2466C30F-D8B2-E928-568F-C179E3444FB2}"/>
              </a:ext>
            </a:extLst>
          </p:cNvPr>
          <p:cNvSpPr/>
          <p:nvPr/>
        </p:nvSpPr>
        <p:spPr>
          <a:xfrm>
            <a:off x="18466007" y="4423353"/>
            <a:ext cx="5355276" cy="5624289"/>
          </a:xfrm>
          <a:prstGeom prst="arc">
            <a:avLst>
              <a:gd name="adj1" fmla="val 16200000"/>
              <a:gd name="adj2" fmla="val 2074057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Arc 88">
            <a:extLst>
              <a:ext uri="{FF2B5EF4-FFF2-40B4-BE49-F238E27FC236}">
                <a16:creationId xmlns:a16="http://schemas.microsoft.com/office/drawing/2014/main" id="{E49CE1BA-3947-4E1B-0A9C-38E0A344304B}"/>
              </a:ext>
            </a:extLst>
          </p:cNvPr>
          <p:cNvSpPr/>
          <p:nvPr/>
        </p:nvSpPr>
        <p:spPr>
          <a:xfrm flipV="1">
            <a:off x="18459520" y="13556840"/>
            <a:ext cx="5355276" cy="5624289"/>
          </a:xfrm>
          <a:prstGeom prst="arc">
            <a:avLst>
              <a:gd name="adj1" fmla="val 16200000"/>
              <a:gd name="adj2" fmla="val 2055868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F4F5B0C5-B65A-F24C-4586-038D9B63654E}"/>
              </a:ext>
            </a:extLst>
          </p:cNvPr>
          <p:cNvCxnSpPr>
            <a:cxnSpLocks/>
          </p:cNvCxnSpPr>
          <p:nvPr/>
        </p:nvCxnSpPr>
        <p:spPr>
          <a:xfrm>
            <a:off x="30695010" y="11022466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4C6A373A-94AC-15E6-7D4B-1A355E9926A2}"/>
              </a:ext>
            </a:extLst>
          </p:cNvPr>
          <p:cNvCxnSpPr>
            <a:cxnSpLocks/>
          </p:cNvCxnSpPr>
          <p:nvPr/>
        </p:nvCxnSpPr>
        <p:spPr>
          <a:xfrm>
            <a:off x="44973438" y="11044237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66C7309-1A05-F4AF-0C5E-B6065ACF974E}"/>
              </a:ext>
            </a:extLst>
          </p:cNvPr>
          <p:cNvCxnSpPr>
            <a:cxnSpLocks/>
          </p:cNvCxnSpPr>
          <p:nvPr/>
        </p:nvCxnSpPr>
        <p:spPr>
          <a:xfrm>
            <a:off x="40676223" y="9369731"/>
            <a:ext cx="523420" cy="420623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7BAF282-A461-CBCB-2EBC-8C782E10A809}"/>
              </a:ext>
            </a:extLst>
          </p:cNvPr>
          <p:cNvCxnSpPr>
            <a:cxnSpLocks/>
          </p:cNvCxnSpPr>
          <p:nvPr/>
        </p:nvCxnSpPr>
        <p:spPr>
          <a:xfrm>
            <a:off x="41497561" y="9454528"/>
            <a:ext cx="415748" cy="359537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D9F452E-6D3F-4484-FF44-EDAE82A1B0BA}"/>
              </a:ext>
            </a:extLst>
          </p:cNvPr>
          <p:cNvCxnSpPr>
            <a:cxnSpLocks/>
          </p:cNvCxnSpPr>
          <p:nvPr/>
        </p:nvCxnSpPr>
        <p:spPr>
          <a:xfrm>
            <a:off x="42313020" y="9533226"/>
            <a:ext cx="224934" cy="268066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36511BB-49D9-58D6-3781-4BAD8BEB8264}"/>
              </a:ext>
            </a:extLst>
          </p:cNvPr>
          <p:cNvCxnSpPr>
            <a:cxnSpLocks/>
            <a:endCxn id="92" idx="8"/>
          </p:cNvCxnSpPr>
          <p:nvPr/>
        </p:nvCxnSpPr>
        <p:spPr>
          <a:xfrm>
            <a:off x="37601272" y="5743108"/>
            <a:ext cx="878163" cy="700483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5C766EE-0D7C-488D-F466-B771ADEA333C}"/>
              </a:ext>
            </a:extLst>
          </p:cNvPr>
          <p:cNvCxnSpPr>
            <a:cxnSpLocks/>
          </p:cNvCxnSpPr>
          <p:nvPr/>
        </p:nvCxnSpPr>
        <p:spPr>
          <a:xfrm>
            <a:off x="37635529" y="5117187"/>
            <a:ext cx="798869" cy="68463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196927F-815B-7C04-6987-F5E1273A3CC7}"/>
              </a:ext>
            </a:extLst>
          </p:cNvPr>
          <p:cNvCxnSpPr>
            <a:cxnSpLocks/>
          </p:cNvCxnSpPr>
          <p:nvPr/>
        </p:nvCxnSpPr>
        <p:spPr>
          <a:xfrm>
            <a:off x="37720207" y="4488836"/>
            <a:ext cx="622766" cy="527664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264C376-64C0-125B-FD96-72E970F7100D}"/>
              </a:ext>
            </a:extLst>
          </p:cNvPr>
          <p:cNvCxnSpPr>
            <a:cxnSpLocks/>
          </p:cNvCxnSpPr>
          <p:nvPr/>
        </p:nvCxnSpPr>
        <p:spPr>
          <a:xfrm>
            <a:off x="37494644" y="6293446"/>
            <a:ext cx="1220611" cy="1131342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41A32AC-AD38-AD59-9D18-43410286CF2A}"/>
              </a:ext>
            </a:extLst>
          </p:cNvPr>
          <p:cNvCxnSpPr>
            <a:cxnSpLocks/>
          </p:cNvCxnSpPr>
          <p:nvPr/>
        </p:nvCxnSpPr>
        <p:spPr>
          <a:xfrm>
            <a:off x="37411213" y="6912376"/>
            <a:ext cx="3127187" cy="2892562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735B382-70E0-67E3-57CD-0F241F0E37BF}"/>
              </a:ext>
            </a:extLst>
          </p:cNvPr>
          <p:cNvCxnSpPr>
            <a:cxnSpLocks/>
          </p:cNvCxnSpPr>
          <p:nvPr/>
        </p:nvCxnSpPr>
        <p:spPr>
          <a:xfrm>
            <a:off x="37169774" y="9355511"/>
            <a:ext cx="596637" cy="46466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0E40E78-8507-F622-27D9-A05B4CDD4730}"/>
              </a:ext>
            </a:extLst>
          </p:cNvPr>
          <p:cNvCxnSpPr>
            <a:cxnSpLocks/>
          </p:cNvCxnSpPr>
          <p:nvPr/>
        </p:nvCxnSpPr>
        <p:spPr>
          <a:xfrm>
            <a:off x="37252351" y="8836134"/>
            <a:ext cx="1090622" cy="908449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F37529F2-D9D7-ACB6-0B76-48A3143011F6}"/>
              </a:ext>
            </a:extLst>
          </p:cNvPr>
          <p:cNvCxnSpPr>
            <a:cxnSpLocks/>
          </p:cNvCxnSpPr>
          <p:nvPr/>
        </p:nvCxnSpPr>
        <p:spPr>
          <a:xfrm>
            <a:off x="37335014" y="7552715"/>
            <a:ext cx="2415986" cy="2191868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8F6C9B2C-BE5F-E93B-3232-A1E75EF5CA8D}"/>
              </a:ext>
            </a:extLst>
          </p:cNvPr>
          <p:cNvCxnSpPr>
            <a:cxnSpLocks/>
          </p:cNvCxnSpPr>
          <p:nvPr/>
        </p:nvCxnSpPr>
        <p:spPr>
          <a:xfrm>
            <a:off x="37276756" y="8153578"/>
            <a:ext cx="1810848" cy="165136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72" name="Ink 71">
                <a:extLst>
                  <a:ext uri="{FF2B5EF4-FFF2-40B4-BE49-F238E27FC236}">
                    <a16:creationId xmlns:a16="http://schemas.microsoft.com/office/drawing/2014/main" id="{DE0A121B-009F-558F-F3D3-BF8ACA4ACA9E}"/>
                  </a:ext>
                </a:extLst>
              </p14:cNvPr>
              <p14:cNvContentPartPr/>
              <p14:nvPr/>
            </p14:nvContentPartPr>
            <p14:xfrm>
              <a:off x="37111101" y="12439895"/>
              <a:ext cx="6386417" cy="7163087"/>
            </p14:xfrm>
          </p:contentPart>
        </mc:Choice>
        <mc:Fallback xmlns="">
          <p:pic>
            <p:nvPicPr>
              <p:cNvPr id="72" name="Ink 71">
                <a:extLst>
                  <a:ext uri="{FF2B5EF4-FFF2-40B4-BE49-F238E27FC236}">
                    <a16:creationId xmlns:a16="http://schemas.microsoft.com/office/drawing/2014/main" id="{DE0A121B-009F-558F-F3D3-BF8ACA4ACA9E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7053864" y="12382651"/>
                <a:ext cx="6500171" cy="7277215"/>
              </a:xfrm>
              <a:prstGeom prst="rect">
                <a:avLst/>
              </a:prstGeom>
            </p:spPr>
          </p:pic>
        </mc:Fallback>
      </mc:AlternateContent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A96393CA-A906-2171-776C-26795584ABD9}"/>
              </a:ext>
            </a:extLst>
          </p:cNvPr>
          <p:cNvCxnSpPr/>
          <p:nvPr/>
        </p:nvCxnSpPr>
        <p:spPr>
          <a:xfrm flipV="1">
            <a:off x="37053085" y="12051125"/>
            <a:ext cx="0" cy="7545124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D49A5E61-E9AF-23CC-AEBF-05F4393065FE}"/>
              </a:ext>
            </a:extLst>
          </p:cNvPr>
          <p:cNvCxnSpPr>
            <a:cxnSpLocks/>
          </p:cNvCxnSpPr>
          <p:nvPr/>
        </p:nvCxnSpPr>
        <p:spPr>
          <a:xfrm>
            <a:off x="37001339" y="19602981"/>
            <a:ext cx="6648093" cy="0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16786028-0FA8-F7DA-FC89-EE3F9D625608}"/>
              </a:ext>
            </a:extLst>
          </p:cNvPr>
          <p:cNvSpPr txBox="1"/>
          <p:nvPr/>
        </p:nvSpPr>
        <p:spPr>
          <a:xfrm>
            <a:off x="40325490" y="19610275"/>
            <a:ext cx="46479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1AD1B8E-B247-C8C2-B81F-1B45020F1B5A}"/>
              </a:ext>
            </a:extLst>
          </p:cNvPr>
          <p:cNvSpPr txBox="1"/>
          <p:nvPr/>
        </p:nvSpPr>
        <p:spPr>
          <a:xfrm>
            <a:off x="32652777" y="11751257"/>
            <a:ext cx="46479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b="1" dirty="0"/>
              <a:t>deGFP</a:t>
            </a:r>
            <a:endParaRPr lang="en-US" sz="7200" b="1" dirty="0"/>
          </a:p>
        </p:txBody>
      </p: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858BF522-76B7-75FF-B6EE-B0F3213A548B}"/>
              </a:ext>
            </a:extLst>
          </p:cNvPr>
          <p:cNvCxnSpPr/>
          <p:nvPr/>
        </p:nvCxnSpPr>
        <p:spPr>
          <a:xfrm flipV="1">
            <a:off x="37053727" y="2252520"/>
            <a:ext cx="0" cy="7545124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6F932525-CB59-95C5-DAC9-4F5F7A4323E7}"/>
              </a:ext>
            </a:extLst>
          </p:cNvPr>
          <p:cNvCxnSpPr>
            <a:cxnSpLocks/>
          </p:cNvCxnSpPr>
          <p:nvPr/>
        </p:nvCxnSpPr>
        <p:spPr>
          <a:xfrm>
            <a:off x="37015627" y="9797644"/>
            <a:ext cx="6647688" cy="0"/>
          </a:xfrm>
          <a:prstGeom prst="straightConnector1">
            <a:avLst/>
          </a:prstGeom>
          <a:ln w="1143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83ECD1D5-C3DA-84A0-DF92-4A230F130F5E}"/>
              </a:ext>
            </a:extLst>
          </p:cNvPr>
          <p:cNvSpPr txBox="1"/>
          <p:nvPr/>
        </p:nvSpPr>
        <p:spPr>
          <a:xfrm>
            <a:off x="40325490" y="9804938"/>
            <a:ext cx="46479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b="1" dirty="0"/>
              <a:t>Time</a:t>
            </a:r>
            <a:r>
              <a:rPr lang="en-US" b="1" dirty="0"/>
              <a:t>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8D86435-62A4-EEF2-EBB2-A9D48140364E}"/>
              </a:ext>
            </a:extLst>
          </p:cNvPr>
          <p:cNvSpPr txBox="1"/>
          <p:nvPr/>
        </p:nvSpPr>
        <p:spPr>
          <a:xfrm>
            <a:off x="32738081" y="1945920"/>
            <a:ext cx="46479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b="1" dirty="0"/>
              <a:t>MGapt</a:t>
            </a:r>
            <a:endParaRPr lang="en-US" sz="7200" b="1" dirty="0"/>
          </a:p>
        </p:txBody>
      </p:sp>
      <p:sp>
        <p:nvSpPr>
          <p:cNvPr id="90" name="Rectangle: Rounded Corners 89">
            <a:extLst>
              <a:ext uri="{FF2B5EF4-FFF2-40B4-BE49-F238E27FC236}">
                <a16:creationId xmlns:a16="http://schemas.microsoft.com/office/drawing/2014/main" id="{E788A335-C815-2161-9CD4-5B0DB5E57108}"/>
              </a:ext>
            </a:extLst>
          </p:cNvPr>
          <p:cNvSpPr/>
          <p:nvPr/>
        </p:nvSpPr>
        <p:spPr>
          <a:xfrm>
            <a:off x="32923367" y="1025242"/>
            <a:ext cx="11631723" cy="20312045"/>
          </a:xfrm>
          <a:prstGeom prst="roundRect">
            <a:avLst>
              <a:gd name="adj" fmla="val 11426"/>
            </a:avLst>
          </a:prstGeom>
          <a:noFill/>
          <a:ln w="1143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Freeform: Shape 91">
            <a:extLst>
              <a:ext uri="{FF2B5EF4-FFF2-40B4-BE49-F238E27FC236}">
                <a16:creationId xmlns:a16="http://schemas.microsoft.com/office/drawing/2014/main" id="{0B1DCE4D-B2EF-4C21-51ED-B070C72243A2}"/>
              </a:ext>
            </a:extLst>
          </p:cNvPr>
          <p:cNvSpPr/>
          <p:nvPr/>
        </p:nvSpPr>
        <p:spPr>
          <a:xfrm>
            <a:off x="37129927" y="3461652"/>
            <a:ext cx="6465551" cy="6282931"/>
          </a:xfrm>
          <a:custGeom>
            <a:avLst/>
            <a:gdLst>
              <a:gd name="connsiteX0" fmla="*/ 0 w 3057525"/>
              <a:gd name="connsiteY0" fmla="*/ 2665018 h 2665018"/>
              <a:gd name="connsiteX1" fmla="*/ 85725 w 3057525"/>
              <a:gd name="connsiteY1" fmla="*/ 1931593 h 2665018"/>
              <a:gd name="connsiteX2" fmla="*/ 209550 w 3057525"/>
              <a:gd name="connsiteY2" fmla="*/ 883843 h 2665018"/>
              <a:gd name="connsiteX3" fmla="*/ 304800 w 3057525"/>
              <a:gd name="connsiteY3" fmla="*/ 159943 h 2665018"/>
              <a:gd name="connsiteX4" fmla="*/ 352425 w 3057525"/>
              <a:gd name="connsiteY4" fmla="*/ 36118 h 2665018"/>
              <a:gd name="connsiteX5" fmla="*/ 428625 w 3057525"/>
              <a:gd name="connsiteY5" fmla="*/ 26593 h 2665018"/>
              <a:gd name="connsiteX6" fmla="*/ 495300 w 3057525"/>
              <a:gd name="connsiteY6" fmla="*/ 359968 h 2665018"/>
              <a:gd name="connsiteX7" fmla="*/ 561975 w 3057525"/>
              <a:gd name="connsiteY7" fmla="*/ 750493 h 2665018"/>
              <a:gd name="connsiteX8" fmla="*/ 638175 w 3057525"/>
              <a:gd name="connsiteY8" fmla="*/ 1264843 h 2665018"/>
              <a:gd name="connsiteX9" fmla="*/ 771525 w 3057525"/>
              <a:gd name="connsiteY9" fmla="*/ 1769668 h 2665018"/>
              <a:gd name="connsiteX10" fmla="*/ 923925 w 3057525"/>
              <a:gd name="connsiteY10" fmla="*/ 2064943 h 2665018"/>
              <a:gd name="connsiteX11" fmla="*/ 1162050 w 3057525"/>
              <a:gd name="connsiteY11" fmla="*/ 2303068 h 2665018"/>
              <a:gd name="connsiteX12" fmla="*/ 1352550 w 3057525"/>
              <a:gd name="connsiteY12" fmla="*/ 2398318 h 2665018"/>
              <a:gd name="connsiteX13" fmla="*/ 1609725 w 3057525"/>
              <a:gd name="connsiteY13" fmla="*/ 2484043 h 2665018"/>
              <a:gd name="connsiteX14" fmla="*/ 1924050 w 3057525"/>
              <a:gd name="connsiteY14" fmla="*/ 2531668 h 2665018"/>
              <a:gd name="connsiteX15" fmla="*/ 2305050 w 3057525"/>
              <a:gd name="connsiteY15" fmla="*/ 2560243 h 2665018"/>
              <a:gd name="connsiteX16" fmla="*/ 2771775 w 3057525"/>
              <a:gd name="connsiteY16" fmla="*/ 2588818 h 2665018"/>
              <a:gd name="connsiteX17" fmla="*/ 3057525 w 3057525"/>
              <a:gd name="connsiteY17" fmla="*/ 2607868 h 2665018"/>
              <a:gd name="connsiteX18" fmla="*/ 3057525 w 3057525"/>
              <a:gd name="connsiteY18" fmla="*/ 2607868 h 26650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3057525" h="2665018">
                <a:moveTo>
                  <a:pt x="0" y="2665018"/>
                </a:moveTo>
                <a:cubicBezTo>
                  <a:pt x="25400" y="2446737"/>
                  <a:pt x="50800" y="2228456"/>
                  <a:pt x="85725" y="1931593"/>
                </a:cubicBezTo>
                <a:cubicBezTo>
                  <a:pt x="120650" y="1634730"/>
                  <a:pt x="173038" y="1179118"/>
                  <a:pt x="209550" y="883843"/>
                </a:cubicBezTo>
                <a:cubicBezTo>
                  <a:pt x="246062" y="588568"/>
                  <a:pt x="280988" y="301230"/>
                  <a:pt x="304800" y="159943"/>
                </a:cubicBezTo>
                <a:cubicBezTo>
                  <a:pt x="328612" y="18656"/>
                  <a:pt x="331788" y="58343"/>
                  <a:pt x="352425" y="36118"/>
                </a:cubicBezTo>
                <a:cubicBezTo>
                  <a:pt x="373062" y="13893"/>
                  <a:pt x="404813" y="-27382"/>
                  <a:pt x="428625" y="26593"/>
                </a:cubicBezTo>
                <a:cubicBezTo>
                  <a:pt x="452437" y="80568"/>
                  <a:pt x="473075" y="239318"/>
                  <a:pt x="495300" y="359968"/>
                </a:cubicBezTo>
                <a:cubicBezTo>
                  <a:pt x="517525" y="480618"/>
                  <a:pt x="538162" y="599680"/>
                  <a:pt x="561975" y="750493"/>
                </a:cubicBezTo>
                <a:cubicBezTo>
                  <a:pt x="585788" y="901306"/>
                  <a:pt x="603250" y="1094980"/>
                  <a:pt x="638175" y="1264843"/>
                </a:cubicBezTo>
                <a:cubicBezTo>
                  <a:pt x="673100" y="1434705"/>
                  <a:pt x="723900" y="1636318"/>
                  <a:pt x="771525" y="1769668"/>
                </a:cubicBezTo>
                <a:cubicBezTo>
                  <a:pt x="819150" y="1903018"/>
                  <a:pt x="858838" y="1976043"/>
                  <a:pt x="923925" y="2064943"/>
                </a:cubicBezTo>
                <a:cubicBezTo>
                  <a:pt x="989012" y="2153843"/>
                  <a:pt x="1090613" y="2247506"/>
                  <a:pt x="1162050" y="2303068"/>
                </a:cubicBezTo>
                <a:cubicBezTo>
                  <a:pt x="1233487" y="2358630"/>
                  <a:pt x="1277938" y="2368155"/>
                  <a:pt x="1352550" y="2398318"/>
                </a:cubicBezTo>
                <a:cubicBezTo>
                  <a:pt x="1427163" y="2428480"/>
                  <a:pt x="1514475" y="2461818"/>
                  <a:pt x="1609725" y="2484043"/>
                </a:cubicBezTo>
                <a:cubicBezTo>
                  <a:pt x="1704975" y="2506268"/>
                  <a:pt x="1808163" y="2518968"/>
                  <a:pt x="1924050" y="2531668"/>
                </a:cubicBezTo>
                <a:cubicBezTo>
                  <a:pt x="2039937" y="2544368"/>
                  <a:pt x="2305050" y="2560243"/>
                  <a:pt x="2305050" y="2560243"/>
                </a:cubicBezTo>
                <a:lnTo>
                  <a:pt x="2771775" y="2588818"/>
                </a:lnTo>
                <a:lnTo>
                  <a:pt x="3057525" y="2607868"/>
                </a:lnTo>
                <a:lnTo>
                  <a:pt x="3057525" y="2607868"/>
                </a:lnTo>
              </a:path>
            </a:pathLst>
          </a:custGeom>
          <a:noFill/>
          <a:ln w="114300">
            <a:solidFill>
              <a:srgbClr val="ED7D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7DDC9CDD-6D9F-50B9-AF04-33D69131948B}"/>
              </a:ext>
            </a:extLst>
          </p:cNvPr>
          <p:cNvCxnSpPr>
            <a:cxnSpLocks/>
          </p:cNvCxnSpPr>
          <p:nvPr/>
        </p:nvCxnSpPr>
        <p:spPr>
          <a:xfrm flipH="1">
            <a:off x="39087604" y="6495969"/>
            <a:ext cx="857987" cy="1338120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4DCCE028-6F2F-B003-9AF8-452D7080E6C3}"/>
              </a:ext>
            </a:extLst>
          </p:cNvPr>
          <p:cNvSpPr txBox="1"/>
          <p:nvPr/>
        </p:nvSpPr>
        <p:spPr>
          <a:xfrm>
            <a:off x="39251332" y="2761768"/>
            <a:ext cx="5231844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b="1" dirty="0"/>
              <a:t>Integrated MG aptamer</a:t>
            </a:r>
            <a:endParaRPr lang="en-US" sz="6000" b="1" dirty="0"/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A0E3E269-D2C0-B62F-64A2-A014E2BAB1A5}"/>
              </a:ext>
            </a:extLst>
          </p:cNvPr>
          <p:cNvCxnSpPr>
            <a:cxnSpLocks/>
          </p:cNvCxnSpPr>
          <p:nvPr/>
        </p:nvCxnSpPr>
        <p:spPr>
          <a:xfrm flipV="1">
            <a:off x="42483774" y="13206604"/>
            <a:ext cx="637255" cy="1653677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068A08AD-7636-C678-1E43-CC16867EC44A}"/>
              </a:ext>
            </a:extLst>
          </p:cNvPr>
          <p:cNvSpPr txBox="1"/>
          <p:nvPr/>
        </p:nvSpPr>
        <p:spPr>
          <a:xfrm>
            <a:off x="39835227" y="14860281"/>
            <a:ext cx="4647949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b="1" dirty="0"/>
              <a:t>Maximum deGFP</a:t>
            </a:r>
            <a:endParaRPr lang="en-US" sz="6000" b="1" dirty="0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A9E1194B-964B-F0FC-BB58-26E71824CBAA}"/>
              </a:ext>
            </a:extLst>
          </p:cNvPr>
          <p:cNvSpPr/>
          <p:nvPr/>
        </p:nvSpPr>
        <p:spPr>
          <a:xfrm>
            <a:off x="43040309" y="11998741"/>
            <a:ext cx="836708" cy="862300"/>
          </a:xfrm>
          <a:prstGeom prst="ellipse">
            <a:avLst/>
          </a:prstGeom>
          <a:noFill/>
          <a:ln w="139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64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ED9D7A-DD2D-20FA-1BF7-4848FCB891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>
            <a:extLst>
              <a:ext uri="{FF2B5EF4-FFF2-40B4-BE49-F238E27FC236}">
                <a16:creationId xmlns:a16="http://schemas.microsoft.com/office/drawing/2014/main" id="{BD3F94F5-5859-4271-FEB0-733B59CE13C7}"/>
              </a:ext>
            </a:extLst>
          </p:cNvPr>
          <p:cNvSpPr txBox="1"/>
          <p:nvPr/>
        </p:nvSpPr>
        <p:spPr>
          <a:xfrm>
            <a:off x="1975449" y="7361879"/>
            <a:ext cx="3145536" cy="3145536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952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endParaRPr lang="en-US" sz="5400" dirty="0">
              <a:solidFill>
                <a:schemeClr val="bg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87E5C3D-1F27-EC93-F4E3-8BD830EFA463}"/>
              </a:ext>
            </a:extLst>
          </p:cNvPr>
          <p:cNvSpPr txBox="1"/>
          <p:nvPr/>
        </p:nvSpPr>
        <p:spPr>
          <a:xfrm>
            <a:off x="1891258" y="8160891"/>
            <a:ext cx="344278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g</a:t>
            </a:r>
            <a:r>
              <a:rPr lang="en-US" sz="96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US" sz="9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BE285CC-CE02-FF94-2501-424C23D3C66B}"/>
              </a:ext>
            </a:extLst>
          </p:cNvPr>
          <p:cNvGrpSpPr/>
          <p:nvPr/>
        </p:nvGrpSpPr>
        <p:grpSpPr>
          <a:xfrm>
            <a:off x="13464471" y="13125445"/>
            <a:ext cx="7599228" cy="8788192"/>
            <a:chOff x="-1120990" y="8729375"/>
            <a:chExt cx="9217654" cy="1081058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2844F66-D313-18E1-4B7D-CADCC5D83707}"/>
                </a:ext>
              </a:extLst>
            </p:cNvPr>
            <p:cNvGrpSpPr/>
            <p:nvPr/>
          </p:nvGrpSpPr>
          <p:grpSpPr>
            <a:xfrm>
              <a:off x="1757272" y="8729375"/>
              <a:ext cx="3036903" cy="7634415"/>
              <a:chOff x="9341364" y="2891367"/>
              <a:chExt cx="3036903" cy="7634415"/>
            </a:xfrm>
          </p:grpSpPr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AF8FDBA1-3BD1-43A3-E98A-F7AB537BDD96}"/>
                  </a:ext>
                </a:extLst>
              </p:cNvPr>
              <p:cNvSpPr/>
              <p:nvPr/>
            </p:nvSpPr>
            <p:spPr>
              <a:xfrm>
                <a:off x="10876112" y="9655176"/>
                <a:ext cx="373655" cy="764859"/>
              </a:xfrm>
              <a:prstGeom prst="ellipse">
                <a:avLst/>
              </a:prstGeom>
              <a:solidFill>
                <a:srgbClr val="F9EFD0"/>
              </a:solidFill>
              <a:ln w="57150">
                <a:solidFill>
                  <a:srgbClr val="F9EFD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1D288E5-09F3-26BD-36A6-2210902535DB}"/>
                  </a:ext>
                </a:extLst>
              </p:cNvPr>
              <p:cNvGrpSpPr/>
              <p:nvPr/>
            </p:nvGrpSpPr>
            <p:grpSpPr>
              <a:xfrm>
                <a:off x="9341364" y="2891367"/>
                <a:ext cx="3036903" cy="7634415"/>
                <a:chOff x="10204964" y="2637367"/>
                <a:chExt cx="3036903" cy="7634415"/>
              </a:xfrm>
            </p:grpSpPr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63AE1F7D-53E2-A934-1B83-487A9CA2C0BE}"/>
                    </a:ext>
                  </a:extLst>
                </p:cNvPr>
                <p:cNvSpPr/>
                <p:nvPr/>
              </p:nvSpPr>
              <p:spPr>
                <a:xfrm>
                  <a:off x="11612886" y="9401176"/>
                  <a:ext cx="634677" cy="870606"/>
                </a:xfrm>
                <a:prstGeom prst="ellipse">
                  <a:avLst/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26A7B278-0233-0AAF-DBF3-C8B9D4037018}"/>
                    </a:ext>
                  </a:extLst>
                </p:cNvPr>
                <p:cNvSpPr/>
                <p:nvPr/>
              </p:nvSpPr>
              <p:spPr>
                <a:xfrm>
                  <a:off x="10898271" y="4668519"/>
                  <a:ext cx="2050649" cy="235163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7" name="Block Arc 36">
                  <a:extLst>
                    <a:ext uri="{FF2B5EF4-FFF2-40B4-BE49-F238E27FC236}">
                      <a16:creationId xmlns:a16="http://schemas.microsoft.com/office/drawing/2014/main" id="{C8C60393-082F-1E59-C137-F5820F8BA823}"/>
                    </a:ext>
                  </a:extLst>
                </p:cNvPr>
                <p:cNvSpPr/>
                <p:nvPr/>
              </p:nvSpPr>
              <p:spPr>
                <a:xfrm rot="14698403">
                  <a:off x="10270097" y="2676360"/>
                  <a:ext cx="427356" cy="514795"/>
                </a:xfrm>
                <a:prstGeom prst="blockArc">
                  <a:avLst>
                    <a:gd name="adj1" fmla="val 13560443"/>
                    <a:gd name="adj2" fmla="val 2935971"/>
                    <a:gd name="adj3" fmla="val 24413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7BEE5F32-A63B-51BB-FCB5-387034AB8875}"/>
                    </a:ext>
                  </a:extLst>
                </p:cNvPr>
                <p:cNvSpPr/>
                <p:nvPr/>
              </p:nvSpPr>
              <p:spPr>
                <a:xfrm>
                  <a:off x="10445751" y="3054350"/>
                  <a:ext cx="464594" cy="100273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" name="Block Arc 38">
                  <a:extLst>
                    <a:ext uri="{FF2B5EF4-FFF2-40B4-BE49-F238E27FC236}">
                      <a16:creationId xmlns:a16="http://schemas.microsoft.com/office/drawing/2014/main" id="{24D8F084-0E01-7C1E-3DC7-570D1861E27B}"/>
                    </a:ext>
                  </a:extLst>
                </p:cNvPr>
                <p:cNvSpPr/>
                <p:nvPr/>
              </p:nvSpPr>
              <p:spPr>
                <a:xfrm rot="11312380">
                  <a:off x="10247864" y="2641239"/>
                  <a:ext cx="427356" cy="514795"/>
                </a:xfrm>
                <a:prstGeom prst="blockArc">
                  <a:avLst>
                    <a:gd name="adj1" fmla="val 15619198"/>
                    <a:gd name="adj2" fmla="val 16406583"/>
                    <a:gd name="adj3" fmla="val 22545"/>
                  </a:avLst>
                </a:prstGeom>
                <a:solidFill>
                  <a:srgbClr val="EBF2F2"/>
                </a:solidFill>
                <a:ln w="5080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0" name="Block Arc 39">
                  <a:extLst>
                    <a:ext uri="{FF2B5EF4-FFF2-40B4-BE49-F238E27FC236}">
                      <a16:creationId xmlns:a16="http://schemas.microsoft.com/office/drawing/2014/main" id="{85ED6C6B-7AF0-5121-497B-0DFBAD7DA86F}"/>
                    </a:ext>
                  </a:extLst>
                </p:cNvPr>
                <p:cNvSpPr/>
                <p:nvPr/>
              </p:nvSpPr>
              <p:spPr>
                <a:xfrm rot="11312380">
                  <a:off x="10204964" y="2933117"/>
                  <a:ext cx="427356" cy="192024"/>
                </a:xfrm>
                <a:prstGeom prst="blockArc">
                  <a:avLst>
                    <a:gd name="adj1" fmla="val 15879138"/>
                    <a:gd name="adj2" fmla="val 17412361"/>
                    <a:gd name="adj3" fmla="val 26734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Block Arc 40">
                  <a:extLst>
                    <a:ext uri="{FF2B5EF4-FFF2-40B4-BE49-F238E27FC236}">
                      <a16:creationId xmlns:a16="http://schemas.microsoft.com/office/drawing/2014/main" id="{F2D33CF2-527F-0ACC-1798-1B95925415E1}"/>
                    </a:ext>
                  </a:extLst>
                </p:cNvPr>
                <p:cNvSpPr/>
                <p:nvPr/>
              </p:nvSpPr>
              <p:spPr>
                <a:xfrm rot="11312380">
                  <a:off x="10214444" y="2933116"/>
                  <a:ext cx="427356" cy="192024"/>
                </a:xfrm>
                <a:prstGeom prst="blockArc">
                  <a:avLst>
                    <a:gd name="adj1" fmla="val 13519529"/>
                    <a:gd name="adj2" fmla="val 16615939"/>
                    <a:gd name="adj3" fmla="val 25588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Block Arc 41">
                  <a:extLst>
                    <a:ext uri="{FF2B5EF4-FFF2-40B4-BE49-F238E27FC236}">
                      <a16:creationId xmlns:a16="http://schemas.microsoft.com/office/drawing/2014/main" id="{ED167386-25F3-BAD5-EB91-16553110729D}"/>
                    </a:ext>
                  </a:extLst>
                </p:cNvPr>
                <p:cNvSpPr/>
                <p:nvPr/>
              </p:nvSpPr>
              <p:spPr>
                <a:xfrm rot="11032256">
                  <a:off x="10238792" y="2931528"/>
                  <a:ext cx="427356" cy="192024"/>
                </a:xfrm>
                <a:prstGeom prst="blockArc">
                  <a:avLst>
                    <a:gd name="adj1" fmla="val 13519529"/>
                    <a:gd name="adj2" fmla="val 15470025"/>
                    <a:gd name="adj3" fmla="val 23131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" name="Rectangle: Rounded Corners 42">
                  <a:extLst>
                    <a:ext uri="{FF2B5EF4-FFF2-40B4-BE49-F238E27FC236}">
                      <a16:creationId xmlns:a16="http://schemas.microsoft.com/office/drawing/2014/main" id="{AEF1B87C-61D5-DFA7-F7E9-FE3B85E57CFF}"/>
                    </a:ext>
                  </a:extLst>
                </p:cNvPr>
                <p:cNvSpPr/>
                <p:nvPr/>
              </p:nvSpPr>
              <p:spPr>
                <a:xfrm>
                  <a:off x="10795109" y="2870200"/>
                  <a:ext cx="2235084" cy="358703"/>
                </a:xfrm>
                <a:prstGeom prst="roundRect">
                  <a:avLst>
                    <a:gd name="adj" fmla="val 30607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Rectangle: Rounded Corners 43">
                  <a:extLst>
                    <a:ext uri="{FF2B5EF4-FFF2-40B4-BE49-F238E27FC236}">
                      <a16:creationId xmlns:a16="http://schemas.microsoft.com/office/drawing/2014/main" id="{30710238-A871-4C93-EF70-A43D68EB1D6A}"/>
                    </a:ext>
                  </a:extLst>
                </p:cNvPr>
                <p:cNvSpPr/>
                <p:nvPr/>
              </p:nvSpPr>
              <p:spPr>
                <a:xfrm>
                  <a:off x="10565822" y="2637367"/>
                  <a:ext cx="2676045" cy="326453"/>
                </a:xfrm>
                <a:prstGeom prst="roundRect">
                  <a:avLst>
                    <a:gd name="adj" fmla="val 41305"/>
                  </a:avLst>
                </a:prstGeom>
                <a:solidFill>
                  <a:srgbClr val="EBF2F2"/>
                </a:solidFill>
                <a:ln w="57150">
                  <a:solidFill>
                    <a:srgbClr val="5D666E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rapezoid 44">
                  <a:extLst>
                    <a:ext uri="{FF2B5EF4-FFF2-40B4-BE49-F238E27FC236}">
                      <a16:creationId xmlns:a16="http://schemas.microsoft.com/office/drawing/2014/main" id="{8AF4A04C-323D-95A2-BE0A-B81E298237A7}"/>
                    </a:ext>
                  </a:extLst>
                </p:cNvPr>
                <p:cNvSpPr/>
                <p:nvPr/>
              </p:nvSpPr>
              <p:spPr>
                <a:xfrm rot="10800000">
                  <a:off x="10894226" y="7020147"/>
                  <a:ext cx="2071313" cy="2957101"/>
                </a:xfrm>
                <a:prstGeom prst="trapezoid">
                  <a:avLst>
                    <a:gd name="adj" fmla="val 36875"/>
                  </a:avLst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D16153B9-ACBB-1732-6136-58BAF69AA0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20487" y="7029540"/>
                  <a:ext cx="728432" cy="298318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85BBF9D1-3327-D7DB-6DA1-6D20318371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7020153"/>
                  <a:ext cx="744971" cy="2996972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46022B2E-2F0E-86E6-F001-BC67CBFF63B5}"/>
                    </a:ext>
                  </a:extLst>
                </p:cNvPr>
                <p:cNvSpPr/>
                <p:nvPr/>
              </p:nvSpPr>
              <p:spPr>
                <a:xfrm>
                  <a:off x="10898271" y="3262086"/>
                  <a:ext cx="2050649" cy="1538229"/>
                </a:xfrm>
                <a:prstGeom prst="rect">
                  <a:avLst/>
                </a:prstGeom>
                <a:solidFill>
                  <a:srgbClr val="EBF2F2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E001463E-606B-9567-3D18-97B30E1E4F47}"/>
                    </a:ext>
                  </a:extLst>
                </p:cNvPr>
                <p:cNvSpPr/>
                <p:nvPr/>
              </p:nvSpPr>
              <p:spPr>
                <a:xfrm>
                  <a:off x="11012077" y="4677907"/>
                  <a:ext cx="1827973" cy="2351633"/>
                </a:xfrm>
                <a:prstGeom prst="rect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AEB7CA1A-0A36-DD0C-1CE4-C211E1823C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530352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F28DA8B5-3B91-315B-4BFF-BAC5A28A79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75046" y="685800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2" name="Oval 51">
                  <a:extLst>
                    <a:ext uri="{FF2B5EF4-FFF2-40B4-BE49-F238E27FC236}">
                      <a16:creationId xmlns:a16="http://schemas.microsoft.com/office/drawing/2014/main" id="{77668779-8C5B-BBFE-3C39-BABAB49410D4}"/>
                    </a:ext>
                  </a:extLst>
                </p:cNvPr>
                <p:cNvSpPr/>
                <p:nvPr/>
              </p:nvSpPr>
              <p:spPr>
                <a:xfrm>
                  <a:off x="11739712" y="9419272"/>
                  <a:ext cx="373655" cy="764859"/>
                </a:xfrm>
                <a:prstGeom prst="ellipse">
                  <a:avLst/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9AB2DA49-9AF6-2E45-4FA3-7A6FBA43E7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091670" y="3743960"/>
                  <a:ext cx="685800" cy="0"/>
                </a:xfrm>
                <a:prstGeom prst="line">
                  <a:avLst/>
                </a:prstGeom>
                <a:ln w="5080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8B2D432C-DFB8-4629-093A-265998929F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948920" y="3236263"/>
                  <a:ext cx="0" cy="3808748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F2755E92-EAB4-B6AF-BA57-23A4A99728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96247" y="3236263"/>
                  <a:ext cx="0" cy="3801125"/>
                </a:xfrm>
                <a:prstGeom prst="line">
                  <a:avLst/>
                </a:prstGeom>
                <a:ln w="57150">
                  <a:solidFill>
                    <a:srgbClr val="5D666E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6" name="Trapezoid 55">
                  <a:extLst>
                    <a:ext uri="{FF2B5EF4-FFF2-40B4-BE49-F238E27FC236}">
                      <a16:creationId xmlns:a16="http://schemas.microsoft.com/office/drawing/2014/main" id="{AB9155AD-F588-8E42-FC9D-D92AC662BA87}"/>
                    </a:ext>
                  </a:extLst>
                </p:cNvPr>
                <p:cNvSpPr/>
                <p:nvPr/>
              </p:nvSpPr>
              <p:spPr>
                <a:xfrm rot="10800000">
                  <a:off x="11020539" y="7078403"/>
                  <a:ext cx="1810512" cy="2957103"/>
                </a:xfrm>
                <a:prstGeom prst="trapezoid">
                  <a:avLst>
                    <a:gd name="adj" fmla="val 41887"/>
                  </a:avLst>
                </a:prstGeom>
                <a:solidFill>
                  <a:srgbClr val="F9EFD0"/>
                </a:solidFill>
                <a:ln w="57150">
                  <a:solidFill>
                    <a:srgbClr val="AF802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Trapezoid 56">
                  <a:extLst>
                    <a:ext uri="{FF2B5EF4-FFF2-40B4-BE49-F238E27FC236}">
                      <a16:creationId xmlns:a16="http://schemas.microsoft.com/office/drawing/2014/main" id="{5F623A1A-B6DF-D77A-913F-22143E32DDFF}"/>
                    </a:ext>
                  </a:extLst>
                </p:cNvPr>
                <p:cNvSpPr/>
                <p:nvPr/>
              </p:nvSpPr>
              <p:spPr>
                <a:xfrm rot="10800000">
                  <a:off x="11923760" y="9993713"/>
                  <a:ext cx="123106" cy="85889"/>
                </a:xfrm>
                <a:prstGeom prst="trapezoid">
                  <a:avLst>
                    <a:gd name="adj" fmla="val 3698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8" name="Rectangle: Rounded Corners 57">
                  <a:extLst>
                    <a:ext uri="{FF2B5EF4-FFF2-40B4-BE49-F238E27FC236}">
                      <a16:creationId xmlns:a16="http://schemas.microsoft.com/office/drawing/2014/main" id="{9655F4CC-44D5-60C2-E7A7-929EA81B2A97}"/>
                    </a:ext>
                  </a:extLst>
                </p:cNvPr>
                <p:cNvSpPr/>
                <p:nvPr/>
              </p:nvSpPr>
              <p:spPr>
                <a:xfrm>
                  <a:off x="11042409" y="6947349"/>
                  <a:ext cx="1765478" cy="195322"/>
                </a:xfrm>
                <a:prstGeom prst="roundRect">
                  <a:avLst>
                    <a:gd name="adj" fmla="val 19611"/>
                  </a:avLst>
                </a:prstGeom>
                <a:solidFill>
                  <a:srgbClr val="F9EFD0"/>
                </a:solidFill>
                <a:ln w="508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B05111FA-74C1-6F6C-9299-D18BD62395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12077" y="7050469"/>
                  <a:ext cx="49623" cy="182344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9316CC74-E5FB-1385-0044-8B870DAA53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786299" y="7042931"/>
                  <a:ext cx="46451" cy="186953"/>
                </a:xfrm>
                <a:prstGeom prst="line">
                  <a:avLst/>
                </a:prstGeom>
                <a:ln w="50800">
                  <a:solidFill>
                    <a:srgbClr val="AF802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rapezoid 32">
                <a:extLst>
                  <a:ext uri="{FF2B5EF4-FFF2-40B4-BE49-F238E27FC236}">
                    <a16:creationId xmlns:a16="http://schemas.microsoft.com/office/drawing/2014/main" id="{10E7B228-40CC-4F6B-51B6-646EBC8BC799}"/>
                  </a:ext>
                </a:extLst>
              </p:cNvPr>
              <p:cNvSpPr/>
              <p:nvPr/>
            </p:nvSpPr>
            <p:spPr>
              <a:xfrm rot="10800000">
                <a:off x="10939945" y="10247711"/>
                <a:ext cx="131984" cy="98613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4" name="Trapezoid 33">
                <a:extLst>
                  <a:ext uri="{FF2B5EF4-FFF2-40B4-BE49-F238E27FC236}">
                    <a16:creationId xmlns:a16="http://schemas.microsoft.com/office/drawing/2014/main" id="{E7382145-1CDD-BB2B-215E-254AA3AC6DDD}"/>
                  </a:ext>
                </a:extLst>
              </p:cNvPr>
              <p:cNvSpPr/>
              <p:nvPr/>
            </p:nvSpPr>
            <p:spPr>
              <a:xfrm rot="10800000">
                <a:off x="10996688" y="10255028"/>
                <a:ext cx="126948" cy="73152"/>
              </a:xfrm>
              <a:prstGeom prst="trapezoid">
                <a:avLst>
                  <a:gd name="adj" fmla="val 39150"/>
                </a:avLst>
              </a:prstGeom>
              <a:solidFill>
                <a:srgbClr val="F9EFD0"/>
              </a:solidFill>
              <a:ln w="508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C2727C-3D6C-80DA-4D4D-D78DA4D5036E}"/>
                </a:ext>
              </a:extLst>
            </p:cNvPr>
            <p:cNvSpPr txBox="1"/>
            <p:nvPr/>
          </p:nvSpPr>
          <p:spPr>
            <a:xfrm>
              <a:off x="-1120990" y="16094660"/>
              <a:ext cx="9217654" cy="34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dirty="0">
                  <a:latin typeface="Arial" panose="020B0604020202020204" pitchFamily="34" charset="0"/>
                  <a:cs typeface="Arial" panose="020B0604020202020204" pitchFamily="34" charset="0"/>
                </a:rPr>
                <a:t>TX-TL reaction mixture</a:t>
              </a:r>
            </a:p>
          </p:txBody>
        </p:sp>
        <p:sp>
          <p:nvSpPr>
            <p:cNvPr id="19" name="Hexagon 18">
              <a:extLst>
                <a:ext uri="{FF2B5EF4-FFF2-40B4-BE49-F238E27FC236}">
                  <a16:creationId xmlns:a16="http://schemas.microsoft.com/office/drawing/2014/main" id="{ABE479DC-BEC7-B1A7-2679-31D9FFF2100F}"/>
                </a:ext>
              </a:extLst>
            </p:cNvPr>
            <p:cNvSpPr/>
            <p:nvPr/>
          </p:nvSpPr>
          <p:spPr>
            <a:xfrm>
              <a:off x="2646064" y="11393153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Hexagon 19">
              <a:extLst>
                <a:ext uri="{FF2B5EF4-FFF2-40B4-BE49-F238E27FC236}">
                  <a16:creationId xmlns:a16="http://schemas.microsoft.com/office/drawing/2014/main" id="{9A6BC27E-F9A6-B7A6-73DE-26970D149EA2}"/>
                </a:ext>
              </a:extLst>
            </p:cNvPr>
            <p:cNvSpPr/>
            <p:nvPr/>
          </p:nvSpPr>
          <p:spPr>
            <a:xfrm>
              <a:off x="3726148" y="1178582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Hexagon 20">
              <a:extLst>
                <a:ext uri="{FF2B5EF4-FFF2-40B4-BE49-F238E27FC236}">
                  <a16:creationId xmlns:a16="http://schemas.microsoft.com/office/drawing/2014/main" id="{67234DC2-879C-6662-C209-22CA602FBA90}"/>
                </a:ext>
              </a:extLst>
            </p:cNvPr>
            <p:cNvSpPr/>
            <p:nvPr/>
          </p:nvSpPr>
          <p:spPr>
            <a:xfrm>
              <a:off x="2965781" y="12688178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Hexagon 21">
              <a:extLst>
                <a:ext uri="{FF2B5EF4-FFF2-40B4-BE49-F238E27FC236}">
                  <a16:creationId xmlns:a16="http://schemas.microsoft.com/office/drawing/2014/main" id="{EEEF71C3-6BC4-45C8-C6BE-F22C3145F25C}"/>
                </a:ext>
              </a:extLst>
            </p:cNvPr>
            <p:cNvSpPr/>
            <p:nvPr/>
          </p:nvSpPr>
          <p:spPr>
            <a:xfrm>
              <a:off x="3586448" y="10994577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Hexagon 22">
              <a:extLst>
                <a:ext uri="{FF2B5EF4-FFF2-40B4-BE49-F238E27FC236}">
                  <a16:creationId xmlns:a16="http://schemas.microsoft.com/office/drawing/2014/main" id="{3A39DB67-ECBD-EBAD-0469-A5C20FDF5ADC}"/>
                </a:ext>
              </a:extLst>
            </p:cNvPr>
            <p:cNvSpPr/>
            <p:nvPr/>
          </p:nvSpPr>
          <p:spPr>
            <a:xfrm>
              <a:off x="3654145" y="13851489"/>
              <a:ext cx="457200" cy="398576"/>
            </a:xfrm>
            <a:prstGeom prst="hexagon">
              <a:avLst>
                <a:gd name="adj" fmla="val 28186"/>
                <a:gd name="vf" fmla="val 115470"/>
              </a:avLst>
            </a:prstGeom>
            <a:solidFill>
              <a:srgbClr val="A671D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E9C1DFBD-E95F-CC31-8273-D38CC91F03AD}"/>
                </a:ext>
              </a:extLst>
            </p:cNvPr>
            <p:cNvSpPr/>
            <p:nvPr/>
          </p:nvSpPr>
          <p:spPr>
            <a:xfrm>
              <a:off x="3081655" y="1195580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AB4AB4EC-BB63-CFDB-2A46-61374B69A351}"/>
                </a:ext>
              </a:extLst>
            </p:cNvPr>
            <p:cNvSpPr/>
            <p:nvPr/>
          </p:nvSpPr>
          <p:spPr>
            <a:xfrm>
              <a:off x="3364944" y="12356955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39C0E9B6-2468-2EC3-E4C1-00E3B3CDFC40}"/>
                </a:ext>
              </a:extLst>
            </p:cNvPr>
            <p:cNvSpPr/>
            <p:nvPr/>
          </p:nvSpPr>
          <p:spPr>
            <a:xfrm>
              <a:off x="3010530" y="14107849"/>
              <a:ext cx="457200" cy="457200"/>
            </a:xfrm>
            <a:prstGeom prst="ellipse">
              <a:avLst/>
            </a:prstGeom>
            <a:solidFill>
              <a:srgbClr val="1D64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" name="Connector: Curved 26">
              <a:extLst>
                <a:ext uri="{FF2B5EF4-FFF2-40B4-BE49-F238E27FC236}">
                  <a16:creationId xmlns:a16="http://schemas.microsoft.com/office/drawing/2014/main" id="{69DDB432-D338-9664-AEB8-03CC4A395E7F}"/>
                </a:ext>
              </a:extLst>
            </p:cNvPr>
            <p:cNvCxnSpPr/>
            <p:nvPr/>
          </p:nvCxnSpPr>
          <p:spPr>
            <a:xfrm rot="10800000" flipV="1">
              <a:off x="3207177" y="13301673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or: Curved 27">
              <a:extLst>
                <a:ext uri="{FF2B5EF4-FFF2-40B4-BE49-F238E27FC236}">
                  <a16:creationId xmlns:a16="http://schemas.microsoft.com/office/drawing/2014/main" id="{57D9F8F6-3820-1850-26E0-96FD45996E0A}"/>
                </a:ext>
              </a:extLst>
            </p:cNvPr>
            <p:cNvCxnSpPr/>
            <p:nvPr/>
          </p:nvCxnSpPr>
          <p:spPr>
            <a:xfrm rot="10800000" flipV="1">
              <a:off x="2882340" y="11603929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or: Curved 28">
              <a:extLst>
                <a:ext uri="{FF2B5EF4-FFF2-40B4-BE49-F238E27FC236}">
                  <a16:creationId xmlns:a16="http://schemas.microsoft.com/office/drawing/2014/main" id="{73B3297E-836B-B0A6-3508-B6D86BA58C0F}"/>
                </a:ext>
              </a:extLst>
            </p:cNvPr>
            <p:cNvCxnSpPr/>
            <p:nvPr/>
          </p:nvCxnSpPr>
          <p:spPr>
            <a:xfrm rot="10800000" flipV="1">
              <a:off x="3263340" y="128866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or: Curved 29">
              <a:extLst>
                <a:ext uri="{FF2B5EF4-FFF2-40B4-BE49-F238E27FC236}">
                  <a16:creationId xmlns:a16="http://schemas.microsoft.com/office/drawing/2014/main" id="{9FCA8996-97C2-064B-8844-C0648AEBA977}"/>
                </a:ext>
              </a:extLst>
            </p:cNvPr>
            <p:cNvCxnSpPr/>
            <p:nvPr/>
          </p:nvCxnSpPr>
          <p:spPr>
            <a:xfrm rot="10800000" flipV="1">
              <a:off x="3359577" y="14503228"/>
              <a:ext cx="521108" cy="398576"/>
            </a:xfrm>
            <a:prstGeom prst="curvedConnector3">
              <a:avLst>
                <a:gd name="adj1" fmla="val 45126"/>
              </a:avLst>
            </a:prstGeom>
            <a:ln w="5715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1" name="Picture 60">
            <a:extLst>
              <a:ext uri="{FF2B5EF4-FFF2-40B4-BE49-F238E27FC236}">
                <a16:creationId xmlns:a16="http://schemas.microsoft.com/office/drawing/2014/main" id="{A17F252A-2338-4A7A-CACE-7AC0F31F7B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82746" y="150445"/>
            <a:ext cx="5057081" cy="8591688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B6232D01-E972-F884-8A05-0A5C1D164CF2}"/>
              </a:ext>
            </a:extLst>
          </p:cNvPr>
          <p:cNvSpPr txBox="1"/>
          <p:nvPr/>
        </p:nvSpPr>
        <p:spPr>
          <a:xfrm>
            <a:off x="13497635" y="8832270"/>
            <a:ext cx="7599229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latin typeface="Arial" panose="020B0604020202020204" pitchFamily="34" charset="0"/>
                <a:cs typeface="Arial" panose="020B0604020202020204" pitchFamily="34" charset="0"/>
              </a:rPr>
              <a:t>Echo 525 Liquid Handler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64797A8F-6E79-7778-1FBA-21A6E04955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84733" y="7834089"/>
            <a:ext cx="7599230" cy="5624289"/>
          </a:xfrm>
          <a:prstGeom prst="rect">
            <a:avLst/>
          </a:prstGeom>
        </p:spPr>
      </p:pic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EE1A5A69-DDEB-30DC-3ABD-43FD14DBD20C}"/>
              </a:ext>
            </a:extLst>
          </p:cNvPr>
          <p:cNvCxnSpPr>
            <a:cxnSpLocks/>
          </p:cNvCxnSpPr>
          <p:nvPr/>
        </p:nvCxnSpPr>
        <p:spPr>
          <a:xfrm>
            <a:off x="12214108" y="6547420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54C61565-9D69-2189-291F-3BFA30A064A2}"/>
              </a:ext>
            </a:extLst>
          </p:cNvPr>
          <p:cNvSpPr txBox="1"/>
          <p:nvPr/>
        </p:nvSpPr>
        <p:spPr>
          <a:xfrm>
            <a:off x="21957899" y="13532392"/>
            <a:ext cx="885289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dirty="0">
                <a:latin typeface="Arial" panose="020B0604020202020204" pitchFamily="34" charset="0"/>
                <a:cs typeface="Arial" panose="020B0604020202020204" pitchFamily="34" charset="0"/>
              </a:rPr>
              <a:t>10µL reactions in 384-well plate</a:t>
            </a:r>
          </a:p>
        </p:txBody>
      </p:sp>
      <p:sp>
        <p:nvSpPr>
          <p:cNvPr id="73" name="Hexagon 72">
            <a:extLst>
              <a:ext uri="{FF2B5EF4-FFF2-40B4-BE49-F238E27FC236}">
                <a16:creationId xmlns:a16="http://schemas.microsoft.com/office/drawing/2014/main" id="{E2F7BD3A-E116-C9CB-60F4-251B081AE92D}"/>
              </a:ext>
            </a:extLst>
          </p:cNvPr>
          <p:cNvSpPr/>
          <p:nvPr/>
        </p:nvSpPr>
        <p:spPr>
          <a:xfrm rot="1800000">
            <a:off x="5859497" y="6004487"/>
            <a:ext cx="3429000" cy="2971800"/>
          </a:xfrm>
          <a:prstGeom prst="hexagon">
            <a:avLst>
              <a:gd name="adj" fmla="val 28695"/>
              <a:gd name="vf" fmla="val 115470"/>
            </a:avLst>
          </a:prstGeom>
          <a:solidFill>
            <a:srgbClr val="E5EBFB"/>
          </a:solidFill>
          <a:ln w="762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18F06F5-50CD-D9E9-BA32-71CC4879B9E4}"/>
              </a:ext>
            </a:extLst>
          </p:cNvPr>
          <p:cNvSpPr txBox="1"/>
          <p:nvPr/>
        </p:nvSpPr>
        <p:spPr>
          <a:xfrm>
            <a:off x="6095521" y="6652550"/>
            <a:ext cx="2883447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0" dirty="0">
                <a:latin typeface="Arial" panose="020B0604020202020204" pitchFamily="34" charset="0"/>
                <a:cs typeface="Arial" panose="020B0604020202020204" pitchFamily="34" charset="0"/>
              </a:rPr>
              <a:t>Fuel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A30D0689-8002-476D-465D-60642A7BCEE4}"/>
              </a:ext>
            </a:extLst>
          </p:cNvPr>
          <p:cNvGrpSpPr/>
          <p:nvPr/>
        </p:nvGrpSpPr>
        <p:grpSpPr>
          <a:xfrm>
            <a:off x="621113" y="277458"/>
            <a:ext cx="11482214" cy="5005791"/>
            <a:chOff x="489316" y="12620280"/>
            <a:chExt cx="11386480" cy="463106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3534AE9-BABE-5AD1-EEA1-599AA8D94B3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96454" y="14034316"/>
              <a:ext cx="1640904" cy="1647403"/>
            </a:xfrm>
            <a:prstGeom prst="rect">
              <a:avLst/>
            </a:prstGeom>
          </p:spPr>
        </p:pic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782BEEF1-C311-BB2E-1F8F-7FCA6BD1F835}"/>
                </a:ext>
              </a:extLst>
            </p:cNvPr>
            <p:cNvSpPr/>
            <p:nvPr/>
          </p:nvSpPr>
          <p:spPr>
            <a:xfrm>
              <a:off x="489316" y="15707157"/>
              <a:ext cx="11386480" cy="1544190"/>
            </a:xfrm>
            <a:prstGeom prst="roundRect">
              <a:avLst/>
            </a:prstGeom>
            <a:noFill/>
            <a:ln w="139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C38AC8C-3922-5212-DB25-1670B8BE56BD}"/>
                </a:ext>
              </a:extLst>
            </p:cNvPr>
            <p:cNvCxnSpPr/>
            <p:nvPr/>
          </p:nvCxnSpPr>
          <p:spPr>
            <a:xfrm>
              <a:off x="1154301" y="14294282"/>
              <a:ext cx="0" cy="1463040"/>
            </a:xfrm>
            <a:prstGeom prst="line">
              <a:avLst/>
            </a:prstGeom>
            <a:ln w="1143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E3B0425C-65A4-1D6D-7909-DBA40E082C44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15" y="14347622"/>
              <a:ext cx="1043360" cy="0"/>
            </a:xfrm>
            <a:prstGeom prst="line">
              <a:avLst/>
            </a:prstGeom>
            <a:ln w="139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Partial Circle 14">
              <a:extLst>
                <a:ext uri="{FF2B5EF4-FFF2-40B4-BE49-F238E27FC236}">
                  <a16:creationId xmlns:a16="http://schemas.microsoft.com/office/drawing/2014/main" id="{3CC7893C-0DEA-EC9C-9948-CE30C408A3A3}"/>
                </a:ext>
              </a:extLst>
            </p:cNvPr>
            <p:cNvSpPr/>
            <p:nvPr/>
          </p:nvSpPr>
          <p:spPr>
            <a:xfrm rot="5400000">
              <a:off x="3991321" y="15265521"/>
              <a:ext cx="1035047" cy="883279"/>
            </a:xfrm>
            <a:prstGeom prst="pie">
              <a:avLst>
                <a:gd name="adj1" fmla="val 5418294"/>
                <a:gd name="adj2" fmla="val 16200000"/>
              </a:avLst>
            </a:prstGeom>
            <a:noFill/>
            <a:ln w="139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A80067D-9407-733B-2B6A-6734258DBCD8}"/>
                </a:ext>
              </a:extLst>
            </p:cNvPr>
            <p:cNvSpPr txBox="1"/>
            <p:nvPr/>
          </p:nvSpPr>
          <p:spPr>
            <a:xfrm>
              <a:off x="5487587" y="14991235"/>
              <a:ext cx="4727576" cy="1338264"/>
            </a:xfrm>
            <a:prstGeom prst="homePlate">
              <a:avLst/>
            </a:prstGeom>
            <a:solidFill>
              <a:srgbClr val="92D050"/>
            </a:solidFill>
            <a:ln w="1270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eGFP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71BC54A1-EE54-A5B0-67E2-670CA8EFB5AC}"/>
                </a:ext>
              </a:extLst>
            </p:cNvPr>
            <p:cNvCxnSpPr/>
            <p:nvPr/>
          </p:nvCxnSpPr>
          <p:spPr>
            <a:xfrm>
              <a:off x="10951593" y="14572992"/>
              <a:ext cx="0" cy="1184330"/>
            </a:xfrm>
            <a:prstGeom prst="line">
              <a:avLst/>
            </a:prstGeom>
            <a:ln w="139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01EC9730-C460-AA3B-2528-EFDE7215D8B7}"/>
                </a:ext>
              </a:extLst>
            </p:cNvPr>
            <p:cNvCxnSpPr>
              <a:cxnSpLocks/>
            </p:cNvCxnSpPr>
            <p:nvPr/>
          </p:nvCxnSpPr>
          <p:spPr>
            <a:xfrm>
              <a:off x="10277700" y="14559171"/>
              <a:ext cx="1269487" cy="0"/>
            </a:xfrm>
            <a:prstGeom prst="line">
              <a:avLst/>
            </a:prstGeom>
            <a:ln w="139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FC81FD6-5275-A3BD-C937-F827AE03B6ED}"/>
                </a:ext>
              </a:extLst>
            </p:cNvPr>
            <p:cNvSpPr txBox="1"/>
            <p:nvPr/>
          </p:nvSpPr>
          <p:spPr>
            <a:xfrm>
              <a:off x="1955201" y="12620280"/>
              <a:ext cx="2186809" cy="13382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00" b="1" dirty="0">
                  <a:latin typeface="Arial" panose="020B0604020202020204" pitchFamily="34" charset="0"/>
                  <a:cs typeface="Arial" panose="020B0604020202020204" pitchFamily="34" charset="0"/>
                </a:rPr>
                <a:t>MG</a:t>
              </a:r>
              <a:endParaRPr lang="en-US" sz="8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01E8B87A-747C-D261-F536-6FA353B54CE3}"/>
                </a:ext>
              </a:extLst>
            </p:cNvPr>
            <p:cNvSpPr/>
            <p:nvPr/>
          </p:nvSpPr>
          <p:spPr>
            <a:xfrm>
              <a:off x="4044593" y="13120938"/>
              <a:ext cx="548640" cy="548640"/>
            </a:xfrm>
            <a:prstGeom prst="ellipse">
              <a:avLst/>
            </a:prstGeom>
            <a:solidFill>
              <a:schemeClr val="accent2"/>
            </a:solidFill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Arc 87">
            <a:extLst>
              <a:ext uri="{FF2B5EF4-FFF2-40B4-BE49-F238E27FC236}">
                <a16:creationId xmlns:a16="http://schemas.microsoft.com/office/drawing/2014/main" id="{2466C30F-D8B2-E928-568F-C179E3444FB2}"/>
              </a:ext>
            </a:extLst>
          </p:cNvPr>
          <p:cNvSpPr/>
          <p:nvPr/>
        </p:nvSpPr>
        <p:spPr>
          <a:xfrm>
            <a:off x="18466007" y="4423353"/>
            <a:ext cx="5355276" cy="5624289"/>
          </a:xfrm>
          <a:prstGeom prst="arc">
            <a:avLst>
              <a:gd name="adj1" fmla="val 16200000"/>
              <a:gd name="adj2" fmla="val 2074057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Arc 88">
            <a:extLst>
              <a:ext uri="{FF2B5EF4-FFF2-40B4-BE49-F238E27FC236}">
                <a16:creationId xmlns:a16="http://schemas.microsoft.com/office/drawing/2014/main" id="{E49CE1BA-3947-4E1B-0A9C-38E0A344304B}"/>
              </a:ext>
            </a:extLst>
          </p:cNvPr>
          <p:cNvSpPr/>
          <p:nvPr/>
        </p:nvSpPr>
        <p:spPr>
          <a:xfrm flipV="1">
            <a:off x="18459520" y="13556840"/>
            <a:ext cx="5355276" cy="5624289"/>
          </a:xfrm>
          <a:prstGeom prst="arc">
            <a:avLst>
              <a:gd name="adj1" fmla="val 16200000"/>
              <a:gd name="adj2" fmla="val 20558681"/>
            </a:avLst>
          </a:prstGeom>
          <a:ln w="152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F4F5B0C5-B65A-F24C-4586-038D9B63654E}"/>
              </a:ext>
            </a:extLst>
          </p:cNvPr>
          <p:cNvCxnSpPr>
            <a:cxnSpLocks/>
          </p:cNvCxnSpPr>
          <p:nvPr/>
        </p:nvCxnSpPr>
        <p:spPr>
          <a:xfrm>
            <a:off x="30695010" y="11022466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4C6A373A-94AC-15E6-7D4B-1A355E9926A2}"/>
              </a:ext>
            </a:extLst>
          </p:cNvPr>
          <p:cNvCxnSpPr>
            <a:cxnSpLocks/>
          </p:cNvCxnSpPr>
          <p:nvPr/>
        </p:nvCxnSpPr>
        <p:spPr>
          <a:xfrm>
            <a:off x="44973438" y="11044237"/>
            <a:ext cx="2043071" cy="0"/>
          </a:xfrm>
          <a:prstGeom prst="straightConnector1">
            <a:avLst/>
          </a:prstGeom>
          <a:ln w="152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66C7309-1A05-F4AF-0C5E-B6065ACF974E}"/>
              </a:ext>
            </a:extLst>
          </p:cNvPr>
          <p:cNvCxnSpPr>
            <a:cxnSpLocks/>
          </p:cNvCxnSpPr>
          <p:nvPr/>
        </p:nvCxnSpPr>
        <p:spPr>
          <a:xfrm>
            <a:off x="40676223" y="9369731"/>
            <a:ext cx="523420" cy="420623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7BAF282-A461-CBCB-2EBC-8C782E10A809}"/>
              </a:ext>
            </a:extLst>
          </p:cNvPr>
          <p:cNvCxnSpPr>
            <a:cxnSpLocks/>
          </p:cNvCxnSpPr>
          <p:nvPr/>
        </p:nvCxnSpPr>
        <p:spPr>
          <a:xfrm>
            <a:off x="41497561" y="9454528"/>
            <a:ext cx="415748" cy="359537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D9F452E-6D3F-4484-FF44-EDAE82A1B0BA}"/>
              </a:ext>
            </a:extLst>
          </p:cNvPr>
          <p:cNvCxnSpPr>
            <a:cxnSpLocks/>
          </p:cNvCxnSpPr>
          <p:nvPr/>
        </p:nvCxnSpPr>
        <p:spPr>
          <a:xfrm>
            <a:off x="42313020" y="9533226"/>
            <a:ext cx="224934" cy="268066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36511BB-49D9-58D6-3781-4BAD8BEB8264}"/>
              </a:ext>
            </a:extLst>
          </p:cNvPr>
          <p:cNvCxnSpPr>
            <a:cxnSpLocks/>
            <a:endCxn id="92" idx="8"/>
          </p:cNvCxnSpPr>
          <p:nvPr/>
        </p:nvCxnSpPr>
        <p:spPr>
          <a:xfrm>
            <a:off x="37601272" y="5743108"/>
            <a:ext cx="878163" cy="700483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5C766EE-0D7C-488D-F466-B771ADEA333C}"/>
              </a:ext>
            </a:extLst>
          </p:cNvPr>
          <p:cNvCxnSpPr>
            <a:cxnSpLocks/>
          </p:cNvCxnSpPr>
          <p:nvPr/>
        </p:nvCxnSpPr>
        <p:spPr>
          <a:xfrm>
            <a:off x="37635529" y="5117187"/>
            <a:ext cx="798869" cy="68463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196927F-815B-7C04-6987-F5E1273A3CC7}"/>
              </a:ext>
            </a:extLst>
          </p:cNvPr>
          <p:cNvCxnSpPr>
            <a:cxnSpLocks/>
          </p:cNvCxnSpPr>
          <p:nvPr/>
        </p:nvCxnSpPr>
        <p:spPr>
          <a:xfrm>
            <a:off x="37720207" y="4488836"/>
            <a:ext cx="622766" cy="527664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264C376-64C0-125B-FD96-72E970F7100D}"/>
              </a:ext>
            </a:extLst>
          </p:cNvPr>
          <p:cNvCxnSpPr>
            <a:cxnSpLocks/>
          </p:cNvCxnSpPr>
          <p:nvPr/>
        </p:nvCxnSpPr>
        <p:spPr>
          <a:xfrm>
            <a:off x="37494644" y="6293446"/>
            <a:ext cx="1220611" cy="1131342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41A32AC-AD38-AD59-9D18-43410286CF2A}"/>
              </a:ext>
            </a:extLst>
          </p:cNvPr>
          <p:cNvCxnSpPr>
            <a:cxnSpLocks/>
          </p:cNvCxnSpPr>
          <p:nvPr/>
        </p:nvCxnSpPr>
        <p:spPr>
          <a:xfrm>
            <a:off x="37411213" y="6912376"/>
            <a:ext cx="3127187" cy="2892562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735B382-70E0-67E3-57CD-0F241F0E37BF}"/>
              </a:ext>
            </a:extLst>
          </p:cNvPr>
          <p:cNvCxnSpPr>
            <a:cxnSpLocks/>
          </p:cNvCxnSpPr>
          <p:nvPr/>
        </p:nvCxnSpPr>
        <p:spPr>
          <a:xfrm>
            <a:off x="37169774" y="9355511"/>
            <a:ext cx="596637" cy="46466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0E40E78-8507-F622-27D9-A05B4CDD4730}"/>
              </a:ext>
            </a:extLst>
          </p:cNvPr>
          <p:cNvCxnSpPr>
            <a:cxnSpLocks/>
          </p:cNvCxnSpPr>
          <p:nvPr/>
        </p:nvCxnSpPr>
        <p:spPr>
          <a:xfrm>
            <a:off x="37252351" y="8836134"/>
            <a:ext cx="1090622" cy="908449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F37529F2-D9D7-ACB6-0B76-48A3143011F6}"/>
              </a:ext>
            </a:extLst>
          </p:cNvPr>
          <p:cNvCxnSpPr>
            <a:cxnSpLocks/>
          </p:cNvCxnSpPr>
          <p:nvPr/>
        </p:nvCxnSpPr>
        <p:spPr>
          <a:xfrm>
            <a:off x="37335014" y="7552715"/>
            <a:ext cx="2415986" cy="2191868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8F6C9B2C-BE5F-E93B-3232-A1E75EF5CA8D}"/>
              </a:ext>
            </a:extLst>
          </p:cNvPr>
          <p:cNvCxnSpPr>
            <a:cxnSpLocks/>
          </p:cNvCxnSpPr>
          <p:nvPr/>
        </p:nvCxnSpPr>
        <p:spPr>
          <a:xfrm>
            <a:off x="37276756" y="8153578"/>
            <a:ext cx="1810848" cy="1651360"/>
          </a:xfrm>
          <a:prstGeom prst="line">
            <a:avLst/>
          </a:prstGeom>
          <a:ln w="139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>
        <mc:Choice xmlns:p14="http://schemas.microsoft.com/office/powerpoint/2010/main" Requires="p14">
          <p:contentPart p14:bwMode="auto" r:id="rId5">
            <p14:nvContentPartPr>
              <p14:cNvPr id="72" name="Ink 71">
                <a:extLst>
                  <a:ext uri="{FF2B5EF4-FFF2-40B4-BE49-F238E27FC236}">
                    <a16:creationId xmlns:a16="http://schemas.microsoft.com/office/drawing/2014/main" id="{DE0A121B-009F-558F-F3D3-BF8ACA4ACA9E}"/>
                  </a:ext>
                </a:extLst>
              </p14:cNvPr>
              <p14:cNvContentPartPr/>
              <p14:nvPr/>
            </p14:nvContentPartPr>
            <p14:xfrm>
              <a:off x="37111101" y="12439895"/>
              <a:ext cx="6386417" cy="7163087"/>
            </p14:xfrm>
          </p:contentPart>
        </mc:Choice>
        <mc:Fallback>
          <p:pic>
            <p:nvPicPr>
              <p:cNvPr id="72" name="Ink 71">
                <a:extLst>
                  <a:ext uri="{FF2B5EF4-FFF2-40B4-BE49-F238E27FC236}">
                    <a16:creationId xmlns:a16="http://schemas.microsoft.com/office/drawing/2014/main" id="{DE0A121B-009F-558F-F3D3-BF8ACA4ACA9E}"/>
                  </a:ext>
                </a:extLst>
              </p:cNvPr>
              <p:cNvPicPr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7053864" y="12382651"/>
                <a:ext cx="6500531" cy="7277215"/>
              </a:xfrm>
              <a:prstGeom prst="rect">
                <a:avLst/>
              </a:prstGeom>
            </p:spPr>
          </p:pic>
        </mc:Fallback>
      </mc:AlternateContent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A96393CA-A906-2171-776C-26795584ABD9}"/>
              </a:ext>
            </a:extLst>
          </p:cNvPr>
          <p:cNvCxnSpPr/>
          <p:nvPr/>
        </p:nvCxnSpPr>
        <p:spPr>
          <a:xfrm flipV="1">
            <a:off x="37053085" y="12051125"/>
            <a:ext cx="0" cy="7545124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D49A5E61-E9AF-23CC-AEBF-05F4393065FE}"/>
              </a:ext>
            </a:extLst>
          </p:cNvPr>
          <p:cNvCxnSpPr>
            <a:cxnSpLocks/>
          </p:cNvCxnSpPr>
          <p:nvPr/>
        </p:nvCxnSpPr>
        <p:spPr>
          <a:xfrm>
            <a:off x="37001339" y="19602981"/>
            <a:ext cx="6648093" cy="0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16786028-0FA8-F7DA-FC89-EE3F9D625608}"/>
              </a:ext>
            </a:extLst>
          </p:cNvPr>
          <p:cNvSpPr txBox="1"/>
          <p:nvPr/>
        </p:nvSpPr>
        <p:spPr>
          <a:xfrm>
            <a:off x="40325490" y="19610275"/>
            <a:ext cx="464794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1AD1B8E-B247-C8C2-B81F-1B45020F1B5A}"/>
              </a:ext>
            </a:extLst>
          </p:cNvPr>
          <p:cNvSpPr txBox="1"/>
          <p:nvPr/>
        </p:nvSpPr>
        <p:spPr>
          <a:xfrm>
            <a:off x="32652777" y="11751257"/>
            <a:ext cx="464794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b="1" dirty="0">
                <a:latin typeface="Arial" panose="020B0604020202020204" pitchFamily="34" charset="0"/>
                <a:cs typeface="Arial" panose="020B0604020202020204" pitchFamily="34" charset="0"/>
              </a:rPr>
              <a:t>deGFP</a:t>
            </a:r>
            <a:endParaRPr lang="en-US" sz="6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858BF522-76B7-75FF-B6EE-B0F3213A548B}"/>
              </a:ext>
            </a:extLst>
          </p:cNvPr>
          <p:cNvCxnSpPr/>
          <p:nvPr/>
        </p:nvCxnSpPr>
        <p:spPr>
          <a:xfrm flipV="1">
            <a:off x="37053727" y="2252520"/>
            <a:ext cx="0" cy="7545124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6F932525-CB59-95C5-DAC9-4F5F7A4323E7}"/>
              </a:ext>
            </a:extLst>
          </p:cNvPr>
          <p:cNvCxnSpPr>
            <a:cxnSpLocks/>
          </p:cNvCxnSpPr>
          <p:nvPr/>
        </p:nvCxnSpPr>
        <p:spPr>
          <a:xfrm>
            <a:off x="37015627" y="9797644"/>
            <a:ext cx="6647688" cy="0"/>
          </a:xfrm>
          <a:prstGeom prst="straightConnector1">
            <a:avLst/>
          </a:prstGeom>
          <a:ln w="1143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83ECD1D5-C3DA-84A0-DF92-4A230F130F5E}"/>
              </a:ext>
            </a:extLst>
          </p:cNvPr>
          <p:cNvSpPr txBox="1"/>
          <p:nvPr/>
        </p:nvSpPr>
        <p:spPr>
          <a:xfrm>
            <a:off x="40325490" y="9804938"/>
            <a:ext cx="464794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b="1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8D86435-62A4-EEF2-EBB2-A9D48140364E}"/>
              </a:ext>
            </a:extLst>
          </p:cNvPr>
          <p:cNvSpPr txBox="1"/>
          <p:nvPr/>
        </p:nvSpPr>
        <p:spPr>
          <a:xfrm>
            <a:off x="32738081" y="1945920"/>
            <a:ext cx="464794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800" b="1" dirty="0">
                <a:latin typeface="Arial" panose="020B0604020202020204" pitchFamily="34" charset="0"/>
                <a:cs typeface="Arial" panose="020B0604020202020204" pitchFamily="34" charset="0"/>
              </a:rPr>
              <a:t>MGapt</a:t>
            </a:r>
            <a:endParaRPr lang="en-US" sz="7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: Rounded Corners 89">
            <a:extLst>
              <a:ext uri="{FF2B5EF4-FFF2-40B4-BE49-F238E27FC236}">
                <a16:creationId xmlns:a16="http://schemas.microsoft.com/office/drawing/2014/main" id="{E788A335-C815-2161-9CD4-5B0DB5E57108}"/>
              </a:ext>
            </a:extLst>
          </p:cNvPr>
          <p:cNvSpPr/>
          <p:nvPr/>
        </p:nvSpPr>
        <p:spPr>
          <a:xfrm>
            <a:off x="32923367" y="1025242"/>
            <a:ext cx="11631723" cy="20312045"/>
          </a:xfrm>
          <a:prstGeom prst="roundRect">
            <a:avLst>
              <a:gd name="adj" fmla="val 11426"/>
            </a:avLst>
          </a:prstGeom>
          <a:noFill/>
          <a:ln w="1143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Freeform: Shape 91">
            <a:extLst>
              <a:ext uri="{FF2B5EF4-FFF2-40B4-BE49-F238E27FC236}">
                <a16:creationId xmlns:a16="http://schemas.microsoft.com/office/drawing/2014/main" id="{0B1DCE4D-B2EF-4C21-51ED-B070C72243A2}"/>
              </a:ext>
            </a:extLst>
          </p:cNvPr>
          <p:cNvSpPr/>
          <p:nvPr/>
        </p:nvSpPr>
        <p:spPr>
          <a:xfrm>
            <a:off x="37129927" y="3461652"/>
            <a:ext cx="6465551" cy="6282931"/>
          </a:xfrm>
          <a:custGeom>
            <a:avLst/>
            <a:gdLst>
              <a:gd name="connsiteX0" fmla="*/ 0 w 3057525"/>
              <a:gd name="connsiteY0" fmla="*/ 2665018 h 2665018"/>
              <a:gd name="connsiteX1" fmla="*/ 85725 w 3057525"/>
              <a:gd name="connsiteY1" fmla="*/ 1931593 h 2665018"/>
              <a:gd name="connsiteX2" fmla="*/ 209550 w 3057525"/>
              <a:gd name="connsiteY2" fmla="*/ 883843 h 2665018"/>
              <a:gd name="connsiteX3" fmla="*/ 304800 w 3057525"/>
              <a:gd name="connsiteY3" fmla="*/ 159943 h 2665018"/>
              <a:gd name="connsiteX4" fmla="*/ 352425 w 3057525"/>
              <a:gd name="connsiteY4" fmla="*/ 36118 h 2665018"/>
              <a:gd name="connsiteX5" fmla="*/ 428625 w 3057525"/>
              <a:gd name="connsiteY5" fmla="*/ 26593 h 2665018"/>
              <a:gd name="connsiteX6" fmla="*/ 495300 w 3057525"/>
              <a:gd name="connsiteY6" fmla="*/ 359968 h 2665018"/>
              <a:gd name="connsiteX7" fmla="*/ 561975 w 3057525"/>
              <a:gd name="connsiteY7" fmla="*/ 750493 h 2665018"/>
              <a:gd name="connsiteX8" fmla="*/ 638175 w 3057525"/>
              <a:gd name="connsiteY8" fmla="*/ 1264843 h 2665018"/>
              <a:gd name="connsiteX9" fmla="*/ 771525 w 3057525"/>
              <a:gd name="connsiteY9" fmla="*/ 1769668 h 2665018"/>
              <a:gd name="connsiteX10" fmla="*/ 923925 w 3057525"/>
              <a:gd name="connsiteY10" fmla="*/ 2064943 h 2665018"/>
              <a:gd name="connsiteX11" fmla="*/ 1162050 w 3057525"/>
              <a:gd name="connsiteY11" fmla="*/ 2303068 h 2665018"/>
              <a:gd name="connsiteX12" fmla="*/ 1352550 w 3057525"/>
              <a:gd name="connsiteY12" fmla="*/ 2398318 h 2665018"/>
              <a:gd name="connsiteX13" fmla="*/ 1609725 w 3057525"/>
              <a:gd name="connsiteY13" fmla="*/ 2484043 h 2665018"/>
              <a:gd name="connsiteX14" fmla="*/ 1924050 w 3057525"/>
              <a:gd name="connsiteY14" fmla="*/ 2531668 h 2665018"/>
              <a:gd name="connsiteX15" fmla="*/ 2305050 w 3057525"/>
              <a:gd name="connsiteY15" fmla="*/ 2560243 h 2665018"/>
              <a:gd name="connsiteX16" fmla="*/ 2771775 w 3057525"/>
              <a:gd name="connsiteY16" fmla="*/ 2588818 h 2665018"/>
              <a:gd name="connsiteX17" fmla="*/ 3057525 w 3057525"/>
              <a:gd name="connsiteY17" fmla="*/ 2607868 h 2665018"/>
              <a:gd name="connsiteX18" fmla="*/ 3057525 w 3057525"/>
              <a:gd name="connsiteY18" fmla="*/ 2607868 h 26650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3057525" h="2665018">
                <a:moveTo>
                  <a:pt x="0" y="2665018"/>
                </a:moveTo>
                <a:cubicBezTo>
                  <a:pt x="25400" y="2446737"/>
                  <a:pt x="50800" y="2228456"/>
                  <a:pt x="85725" y="1931593"/>
                </a:cubicBezTo>
                <a:cubicBezTo>
                  <a:pt x="120650" y="1634730"/>
                  <a:pt x="173038" y="1179118"/>
                  <a:pt x="209550" y="883843"/>
                </a:cubicBezTo>
                <a:cubicBezTo>
                  <a:pt x="246062" y="588568"/>
                  <a:pt x="280988" y="301230"/>
                  <a:pt x="304800" y="159943"/>
                </a:cubicBezTo>
                <a:cubicBezTo>
                  <a:pt x="328612" y="18656"/>
                  <a:pt x="331788" y="58343"/>
                  <a:pt x="352425" y="36118"/>
                </a:cubicBezTo>
                <a:cubicBezTo>
                  <a:pt x="373062" y="13893"/>
                  <a:pt x="404813" y="-27382"/>
                  <a:pt x="428625" y="26593"/>
                </a:cubicBezTo>
                <a:cubicBezTo>
                  <a:pt x="452437" y="80568"/>
                  <a:pt x="473075" y="239318"/>
                  <a:pt x="495300" y="359968"/>
                </a:cubicBezTo>
                <a:cubicBezTo>
                  <a:pt x="517525" y="480618"/>
                  <a:pt x="538162" y="599680"/>
                  <a:pt x="561975" y="750493"/>
                </a:cubicBezTo>
                <a:cubicBezTo>
                  <a:pt x="585788" y="901306"/>
                  <a:pt x="603250" y="1094980"/>
                  <a:pt x="638175" y="1264843"/>
                </a:cubicBezTo>
                <a:cubicBezTo>
                  <a:pt x="673100" y="1434705"/>
                  <a:pt x="723900" y="1636318"/>
                  <a:pt x="771525" y="1769668"/>
                </a:cubicBezTo>
                <a:cubicBezTo>
                  <a:pt x="819150" y="1903018"/>
                  <a:pt x="858838" y="1976043"/>
                  <a:pt x="923925" y="2064943"/>
                </a:cubicBezTo>
                <a:cubicBezTo>
                  <a:pt x="989012" y="2153843"/>
                  <a:pt x="1090613" y="2247506"/>
                  <a:pt x="1162050" y="2303068"/>
                </a:cubicBezTo>
                <a:cubicBezTo>
                  <a:pt x="1233487" y="2358630"/>
                  <a:pt x="1277938" y="2368155"/>
                  <a:pt x="1352550" y="2398318"/>
                </a:cubicBezTo>
                <a:cubicBezTo>
                  <a:pt x="1427163" y="2428480"/>
                  <a:pt x="1514475" y="2461818"/>
                  <a:pt x="1609725" y="2484043"/>
                </a:cubicBezTo>
                <a:cubicBezTo>
                  <a:pt x="1704975" y="2506268"/>
                  <a:pt x="1808163" y="2518968"/>
                  <a:pt x="1924050" y="2531668"/>
                </a:cubicBezTo>
                <a:cubicBezTo>
                  <a:pt x="2039937" y="2544368"/>
                  <a:pt x="2305050" y="2560243"/>
                  <a:pt x="2305050" y="2560243"/>
                </a:cubicBezTo>
                <a:lnTo>
                  <a:pt x="2771775" y="2588818"/>
                </a:lnTo>
                <a:lnTo>
                  <a:pt x="3057525" y="2607868"/>
                </a:lnTo>
                <a:lnTo>
                  <a:pt x="3057525" y="2607868"/>
                </a:lnTo>
              </a:path>
            </a:pathLst>
          </a:custGeom>
          <a:noFill/>
          <a:ln w="114300">
            <a:solidFill>
              <a:srgbClr val="ED7D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7DDC9CDD-6D9F-50B9-AF04-33D69131948B}"/>
              </a:ext>
            </a:extLst>
          </p:cNvPr>
          <p:cNvCxnSpPr>
            <a:cxnSpLocks/>
          </p:cNvCxnSpPr>
          <p:nvPr/>
        </p:nvCxnSpPr>
        <p:spPr>
          <a:xfrm flipH="1">
            <a:off x="39087604" y="6495969"/>
            <a:ext cx="857987" cy="1338120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4DCCE028-6F2F-B003-9AF8-452D7080E6C3}"/>
              </a:ext>
            </a:extLst>
          </p:cNvPr>
          <p:cNvSpPr txBox="1"/>
          <p:nvPr/>
        </p:nvSpPr>
        <p:spPr>
          <a:xfrm>
            <a:off x="39095124" y="2148415"/>
            <a:ext cx="5231844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>
                <a:latin typeface="Arial" panose="020B0604020202020204" pitchFamily="34" charset="0"/>
                <a:cs typeface="Arial" panose="020B0604020202020204" pitchFamily="34" charset="0"/>
              </a:rPr>
              <a:t>Integrated MG aptamer</a:t>
            </a:r>
            <a:endParaRPr lang="en-US" sz="6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A0E3E269-D2C0-B62F-64A2-A014E2BAB1A5}"/>
              </a:ext>
            </a:extLst>
          </p:cNvPr>
          <p:cNvCxnSpPr>
            <a:cxnSpLocks/>
          </p:cNvCxnSpPr>
          <p:nvPr/>
        </p:nvCxnSpPr>
        <p:spPr>
          <a:xfrm flipV="1">
            <a:off x="42483774" y="13206604"/>
            <a:ext cx="637255" cy="1653677"/>
          </a:xfrm>
          <a:prstGeom prst="straightConnector1">
            <a:avLst/>
          </a:prstGeom>
          <a:ln w="1143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068A08AD-7636-C678-1E43-CC16867EC44A}"/>
              </a:ext>
            </a:extLst>
          </p:cNvPr>
          <p:cNvSpPr txBox="1"/>
          <p:nvPr/>
        </p:nvSpPr>
        <p:spPr>
          <a:xfrm>
            <a:off x="39476195" y="15052851"/>
            <a:ext cx="4990453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0" dirty="0">
                <a:latin typeface="Arial" panose="020B0604020202020204" pitchFamily="34" charset="0"/>
                <a:cs typeface="Arial" panose="020B0604020202020204" pitchFamily="34" charset="0"/>
              </a:rPr>
              <a:t>Maximum deGFP</a:t>
            </a:r>
            <a:endParaRPr lang="en-US" sz="6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A9E1194B-964B-F0FC-BB58-26E71824CBAA}"/>
              </a:ext>
            </a:extLst>
          </p:cNvPr>
          <p:cNvSpPr/>
          <p:nvPr/>
        </p:nvSpPr>
        <p:spPr>
          <a:xfrm>
            <a:off x="43040309" y="11998741"/>
            <a:ext cx="836708" cy="862300"/>
          </a:xfrm>
          <a:prstGeom prst="ellipse">
            <a:avLst/>
          </a:prstGeom>
          <a:noFill/>
          <a:ln w="139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1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7</TotalTime>
  <Words>108</Words>
  <Application>Microsoft Office PowerPoint</Application>
  <PresentationFormat>Custom</PresentationFormat>
  <Paragraphs>5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isha Kapasiawala</dc:creator>
  <cp:lastModifiedBy>Manisha Kapasiawala</cp:lastModifiedBy>
  <cp:revision>13</cp:revision>
  <dcterms:created xsi:type="dcterms:W3CDTF">2024-03-11T18:55:17Z</dcterms:created>
  <dcterms:modified xsi:type="dcterms:W3CDTF">2024-08-28T20:03:24Z</dcterms:modified>
</cp:coreProperties>
</file>